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  <p:sldId id="287" r:id="rId3"/>
    <p:sldId id="284" r:id="rId4"/>
    <p:sldId id="286" r:id="rId5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63" userDrawn="1">
          <p15:clr>
            <a:srgbClr val="A4A3A4"/>
          </p15:clr>
        </p15:guide>
        <p15:guide id="2" pos="5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32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67" y="134"/>
      </p:cViewPr>
      <p:guideLst>
        <p:guide orient="horz" pos="663"/>
        <p:guide pos="5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705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310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968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5081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303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931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7007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178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00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022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400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FF0A94-5C6C-47A8-B13D-D2AB7FA8515B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CF9E6C-F9D2-406B-ACBB-01D9B2B10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0171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046E07F-70C8-42FB-8119-5FDCBC752A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7268979"/>
              </p:ext>
            </p:extLst>
          </p:nvPr>
        </p:nvGraphicFramePr>
        <p:xfrm>
          <a:off x="808673" y="2526305"/>
          <a:ext cx="4140200" cy="2228850"/>
        </p:xfrm>
        <a:graphic>
          <a:graphicData uri="http://schemas.openxmlformats.org/drawingml/2006/table">
            <a:tbl>
              <a:tblPr/>
              <a:tblGrid>
                <a:gridCol w="431469">
                  <a:extLst>
                    <a:ext uri="{9D8B030D-6E8A-4147-A177-3AD203B41FA5}">
                      <a16:colId xmlns:a16="http://schemas.microsoft.com/office/drawing/2014/main" val="1279659694"/>
                    </a:ext>
                  </a:extLst>
                </a:gridCol>
                <a:gridCol w="1497452">
                  <a:extLst>
                    <a:ext uri="{9D8B030D-6E8A-4147-A177-3AD203B41FA5}">
                      <a16:colId xmlns:a16="http://schemas.microsoft.com/office/drawing/2014/main" val="170111553"/>
                    </a:ext>
                  </a:extLst>
                </a:gridCol>
                <a:gridCol w="1040602">
                  <a:extLst>
                    <a:ext uri="{9D8B030D-6E8A-4147-A177-3AD203B41FA5}">
                      <a16:colId xmlns:a16="http://schemas.microsoft.com/office/drawing/2014/main" val="491872456"/>
                    </a:ext>
                  </a:extLst>
                </a:gridCol>
                <a:gridCol w="1170677">
                  <a:extLst>
                    <a:ext uri="{9D8B030D-6E8A-4147-A177-3AD203B41FA5}">
                      <a16:colId xmlns:a16="http://schemas.microsoft.com/office/drawing/2014/main" val="2825230292"/>
                    </a:ext>
                  </a:extLst>
                </a:gridCol>
              </a:tblGrid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ea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ragm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heoretical M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xperimental M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0051870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S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9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9.00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826171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YGS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2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2.15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4210610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FAEDVG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70.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71.39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089036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FAEDVGSN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69.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69.57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257759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FFAEDVGSN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68.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68.62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5728432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FFAEDVGSN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81.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382.72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5237723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VGSN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8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8.35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112180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QK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4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4.31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6194358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7FEFF1-61E8-4490-C491-D7884CBD7A24}"/>
              </a:ext>
            </a:extLst>
          </p:cNvPr>
          <p:cNvSpPr txBox="1"/>
          <p:nvPr/>
        </p:nvSpPr>
        <p:spPr>
          <a:xfrm>
            <a:off x="371793" y="2274054"/>
            <a:ext cx="4800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cs typeface="Times New Roman" panose="02020603050405020304" pitchFamily="18" charset="0"/>
              </a:rPr>
              <a:t>(b) </a:t>
            </a:r>
            <a:endParaRPr lang="ja-JP" altLang="en-US" sz="1200" dirty="0"/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A6A616BA-15DC-4FDA-B9A4-357FE9BC0B6C}"/>
              </a:ext>
            </a:extLst>
          </p:cNvPr>
          <p:cNvGrpSpPr/>
          <p:nvPr/>
        </p:nvGrpSpPr>
        <p:grpSpPr>
          <a:xfrm>
            <a:off x="328204" y="787791"/>
            <a:ext cx="5132883" cy="1465302"/>
            <a:chOff x="286611" y="1915551"/>
            <a:chExt cx="5132883" cy="1465302"/>
          </a:xfrm>
        </p:grpSpPr>
        <p:sp>
          <p:nvSpPr>
            <p:cNvPr id="15" name="Line 181">
              <a:extLst>
                <a:ext uri="{FF2B5EF4-FFF2-40B4-BE49-F238E27FC236}">
                  <a16:creationId xmlns:a16="http://schemas.microsoft.com/office/drawing/2014/main" id="{BBBFAC7B-21B1-9552-0F1D-0273F55506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0058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" name="Line 186">
              <a:extLst>
                <a:ext uri="{FF2B5EF4-FFF2-40B4-BE49-F238E27FC236}">
                  <a16:creationId xmlns:a16="http://schemas.microsoft.com/office/drawing/2014/main" id="{1885F4A2-1894-5083-6ECD-5F7E938200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192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7" name="Line 191">
              <a:extLst>
                <a:ext uri="{FF2B5EF4-FFF2-40B4-BE49-F238E27FC236}">
                  <a16:creationId xmlns:a16="http://schemas.microsoft.com/office/drawing/2014/main" id="{2A7A1D60-3FF0-4FC9-5D55-A6927A9AF1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7968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8" name="Line 196">
              <a:extLst>
                <a:ext uri="{FF2B5EF4-FFF2-40B4-BE49-F238E27FC236}">
                  <a16:creationId xmlns:a16="http://schemas.microsoft.com/office/drawing/2014/main" id="{9DB87E82-4D69-E1C1-5A2F-5B138297FB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5102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9" name="Line 201">
              <a:extLst>
                <a:ext uri="{FF2B5EF4-FFF2-40B4-BE49-F238E27FC236}">
                  <a16:creationId xmlns:a16="http://schemas.microsoft.com/office/drawing/2014/main" id="{DC9CE558-4379-AE63-AF04-67A8701A14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5877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0" name="Line 206">
              <a:extLst>
                <a:ext uri="{FF2B5EF4-FFF2-40B4-BE49-F238E27FC236}">
                  <a16:creationId xmlns:a16="http://schemas.microsoft.com/office/drawing/2014/main" id="{720CBE59-1AD2-73E2-FC50-429B3B6911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3012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1" name="Line 211">
              <a:extLst>
                <a:ext uri="{FF2B5EF4-FFF2-40B4-BE49-F238E27FC236}">
                  <a16:creationId xmlns:a16="http://schemas.microsoft.com/office/drawing/2014/main" id="{9E37BCB6-A531-9992-01EE-EB4C7C1620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43787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2" name="Line 216">
              <a:extLst>
                <a:ext uri="{FF2B5EF4-FFF2-40B4-BE49-F238E27FC236}">
                  <a16:creationId xmlns:a16="http://schemas.microsoft.com/office/drawing/2014/main" id="{2979767F-223C-4499-6920-43201F8D5B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0921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3" name="Line 221">
              <a:extLst>
                <a:ext uri="{FF2B5EF4-FFF2-40B4-BE49-F238E27FC236}">
                  <a16:creationId xmlns:a16="http://schemas.microsoft.com/office/drawing/2014/main" id="{959C7461-2313-02B5-3E4B-EF09596138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1697" y="3076767"/>
              <a:ext cx="3641" cy="26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4" name="Line 222">
              <a:extLst>
                <a:ext uri="{FF2B5EF4-FFF2-40B4-BE49-F238E27FC236}">
                  <a16:creationId xmlns:a16="http://schemas.microsoft.com/office/drawing/2014/main" id="{26B32BE3-ABDE-E4CF-72D4-5FA60DA827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0058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5" name="Rectangle 223">
              <a:extLst>
                <a:ext uri="{FF2B5EF4-FFF2-40B4-BE49-F238E27FC236}">
                  <a16:creationId xmlns:a16="http://schemas.microsoft.com/office/drawing/2014/main" id="{F5AD812B-A972-2F48-66AA-58C1EA4A1E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2613" y="313391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6</a:t>
              </a:r>
              <a:endParaRPr lang="en-US" altLang="ja-JP" dirty="0"/>
            </a:p>
          </p:txBody>
        </p:sp>
        <p:sp>
          <p:nvSpPr>
            <p:cNvPr id="26" name="Line 224">
              <a:extLst>
                <a:ext uri="{FF2B5EF4-FFF2-40B4-BE49-F238E27FC236}">
                  <a16:creationId xmlns:a16="http://schemas.microsoft.com/office/drawing/2014/main" id="{2275F5CD-34B0-C9F2-AE98-FDDE377769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7192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7" name="Rectangle 225">
              <a:extLst>
                <a:ext uri="{FF2B5EF4-FFF2-40B4-BE49-F238E27FC236}">
                  <a16:creationId xmlns:a16="http://schemas.microsoft.com/office/drawing/2014/main" id="{3D2DD220-73B4-90B4-F972-173B976B0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9747" y="313391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7</a:t>
              </a:r>
              <a:endParaRPr lang="en-US" altLang="ja-JP" dirty="0"/>
            </a:p>
          </p:txBody>
        </p:sp>
        <p:sp>
          <p:nvSpPr>
            <p:cNvPr id="28" name="Line 226">
              <a:extLst>
                <a:ext uri="{FF2B5EF4-FFF2-40B4-BE49-F238E27FC236}">
                  <a16:creationId xmlns:a16="http://schemas.microsoft.com/office/drawing/2014/main" id="{125F7AA3-6ADD-06B4-9ACA-E6196D7B09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7968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D63DC2A8-FDFC-A1E8-555B-A82A3422B2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0048" y="313391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8</a:t>
              </a:r>
              <a:endParaRPr lang="en-US" altLang="ja-JP" dirty="0"/>
            </a:p>
          </p:txBody>
        </p:sp>
        <p:sp>
          <p:nvSpPr>
            <p:cNvPr id="30" name="Line 228">
              <a:extLst>
                <a:ext uri="{FF2B5EF4-FFF2-40B4-BE49-F238E27FC236}">
                  <a16:creationId xmlns:a16="http://schemas.microsoft.com/office/drawing/2014/main" id="{17CF5A9E-8F41-6592-5841-9BA32A1D4F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5102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7E2E013D-E6D7-41B7-3547-31383C29A3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7182" y="313391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9</a:t>
              </a:r>
              <a:endParaRPr lang="en-US" altLang="ja-JP" dirty="0"/>
            </a:p>
          </p:txBody>
        </p:sp>
        <p:sp>
          <p:nvSpPr>
            <p:cNvPr id="32" name="Line 230">
              <a:extLst>
                <a:ext uri="{FF2B5EF4-FFF2-40B4-BE49-F238E27FC236}">
                  <a16:creationId xmlns:a16="http://schemas.microsoft.com/office/drawing/2014/main" id="{EDC878A2-B1B2-2A49-6D2E-9B529DAFF0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5877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8F8DC54A-D482-9F92-64E8-296759B16A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1347" y="31339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10</a:t>
              </a:r>
              <a:endParaRPr lang="en-US" altLang="ja-JP" dirty="0"/>
            </a:p>
          </p:txBody>
        </p:sp>
        <p:sp>
          <p:nvSpPr>
            <p:cNvPr id="34" name="Line 232">
              <a:extLst>
                <a:ext uri="{FF2B5EF4-FFF2-40B4-BE49-F238E27FC236}">
                  <a16:creationId xmlns:a16="http://schemas.microsoft.com/office/drawing/2014/main" id="{10F09C1E-52C2-1E93-5D37-D20561EA49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3012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BB207B6D-0324-E05E-9F39-DD82B72D96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3718" y="31339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11</a:t>
              </a:r>
              <a:endParaRPr lang="en-US" altLang="ja-JP" dirty="0"/>
            </a:p>
          </p:txBody>
        </p:sp>
        <p:sp>
          <p:nvSpPr>
            <p:cNvPr id="36" name="Line 234">
              <a:extLst>
                <a:ext uri="{FF2B5EF4-FFF2-40B4-BE49-F238E27FC236}">
                  <a16:creationId xmlns:a16="http://schemas.microsoft.com/office/drawing/2014/main" id="{EA825AFC-74A3-B35C-23A1-5625BDEA88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43787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67C42841-710B-752E-CB96-DDA2B1A0ED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0377" y="31339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12</a:t>
              </a:r>
              <a:endParaRPr lang="en-US" altLang="ja-JP" dirty="0"/>
            </a:p>
          </p:txBody>
        </p:sp>
        <p:sp>
          <p:nvSpPr>
            <p:cNvPr id="38" name="Line 236">
              <a:extLst>
                <a:ext uri="{FF2B5EF4-FFF2-40B4-BE49-F238E27FC236}">
                  <a16:creationId xmlns:a16="http://schemas.microsoft.com/office/drawing/2014/main" id="{58C2C499-6879-1914-ECBA-4B131929AA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0921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212BF9BF-761A-54CA-217D-88F767B3C8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1153" y="31339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13</a:t>
              </a:r>
              <a:endParaRPr lang="en-US" altLang="ja-JP" dirty="0"/>
            </a:p>
          </p:txBody>
        </p:sp>
        <p:sp>
          <p:nvSpPr>
            <p:cNvPr id="40" name="Line 238">
              <a:extLst>
                <a:ext uri="{FF2B5EF4-FFF2-40B4-BE49-F238E27FC236}">
                  <a16:creationId xmlns:a16="http://schemas.microsoft.com/office/drawing/2014/main" id="{AD32F04B-1624-13A9-6E26-248C3BDE5B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1697" y="3076767"/>
              <a:ext cx="3641" cy="555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6815A515-30E9-1BAA-CD1C-EC6025DD8D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5094" y="3257742"/>
              <a:ext cx="26129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(min.)</a:t>
              </a:r>
              <a:endParaRPr lang="en-US" altLang="ja-JP" dirty="0"/>
            </a:p>
          </p:txBody>
        </p:sp>
        <p:sp>
          <p:nvSpPr>
            <p:cNvPr id="42" name="Line 244">
              <a:extLst>
                <a:ext uri="{FF2B5EF4-FFF2-40B4-BE49-F238E27FC236}">
                  <a16:creationId xmlns:a16="http://schemas.microsoft.com/office/drawing/2014/main" id="{BD5BBF6C-42CC-D7A7-8CE5-DA7D066E90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4568" y="2875155"/>
              <a:ext cx="21848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3" name="Line 249">
              <a:extLst>
                <a:ext uri="{FF2B5EF4-FFF2-40B4-BE49-F238E27FC236}">
                  <a16:creationId xmlns:a16="http://schemas.microsoft.com/office/drawing/2014/main" id="{AF12E85E-7A91-91A9-B5FC-8FD8F203C8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4568" y="2660842"/>
              <a:ext cx="21848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4" name="Line 254">
              <a:extLst>
                <a:ext uri="{FF2B5EF4-FFF2-40B4-BE49-F238E27FC236}">
                  <a16:creationId xmlns:a16="http://schemas.microsoft.com/office/drawing/2014/main" id="{8D467E2A-DB7B-4BF8-749B-316154BB35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4568" y="2449705"/>
              <a:ext cx="21848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5" name="Line 259">
              <a:extLst>
                <a:ext uri="{FF2B5EF4-FFF2-40B4-BE49-F238E27FC236}">
                  <a16:creationId xmlns:a16="http://schemas.microsoft.com/office/drawing/2014/main" id="{1FACFC40-C98E-C5E5-E8FD-D44BD09C1D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4568" y="2235392"/>
              <a:ext cx="21848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6" name="Line 260">
              <a:extLst>
                <a:ext uri="{FF2B5EF4-FFF2-40B4-BE49-F238E27FC236}">
                  <a16:creationId xmlns:a16="http://schemas.microsoft.com/office/drawing/2014/main" id="{1C4DF8D6-9A05-3CAA-B126-61F0FCF63C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720" y="2875155"/>
              <a:ext cx="43697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7" name="Rectangle 261">
              <a:extLst>
                <a:ext uri="{FF2B5EF4-FFF2-40B4-BE49-F238E27FC236}">
                  <a16:creationId xmlns:a16="http://schemas.microsoft.com/office/drawing/2014/main" id="{0FAEFFA3-3B2C-33DB-D836-0370B5FD76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060" y="282276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ea typeface="ＭＳ ゴシック" charset="-128"/>
                </a:rPr>
                <a:t>25</a:t>
              </a:r>
              <a:endParaRPr lang="en-US" altLang="ja-JP"/>
            </a:p>
          </p:txBody>
        </p:sp>
        <p:sp>
          <p:nvSpPr>
            <p:cNvPr id="48" name="Line 262">
              <a:extLst>
                <a:ext uri="{FF2B5EF4-FFF2-40B4-BE49-F238E27FC236}">
                  <a16:creationId xmlns:a16="http://schemas.microsoft.com/office/drawing/2014/main" id="{FF203E56-38E1-E863-6DD0-1BA805BC8C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720" y="2660842"/>
              <a:ext cx="43697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9" name="Rectangle 263">
              <a:extLst>
                <a:ext uri="{FF2B5EF4-FFF2-40B4-BE49-F238E27FC236}">
                  <a16:creationId xmlns:a16="http://schemas.microsoft.com/office/drawing/2014/main" id="{00C0E925-8F44-E00B-223A-4A74F09C0C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060" y="2610042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ea typeface="ＭＳ ゴシック" charset="-128"/>
                </a:rPr>
                <a:t>50</a:t>
              </a:r>
              <a:endParaRPr lang="en-US" altLang="ja-JP"/>
            </a:p>
          </p:txBody>
        </p:sp>
        <p:sp>
          <p:nvSpPr>
            <p:cNvPr id="50" name="Line 264">
              <a:extLst>
                <a:ext uri="{FF2B5EF4-FFF2-40B4-BE49-F238E27FC236}">
                  <a16:creationId xmlns:a16="http://schemas.microsoft.com/office/drawing/2014/main" id="{692EE636-A74C-5996-E076-7B5BAEFFF9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720" y="2449705"/>
              <a:ext cx="43697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1" name="Rectangle 265">
              <a:extLst>
                <a:ext uri="{FF2B5EF4-FFF2-40B4-BE49-F238E27FC236}">
                  <a16:creationId xmlns:a16="http://schemas.microsoft.com/office/drawing/2014/main" id="{472F73C5-5162-4882-2E78-2BF6792A37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060" y="23973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>
                  <a:solidFill>
                    <a:srgbClr val="000000"/>
                  </a:solidFill>
                  <a:ea typeface="ＭＳ ゴシック" charset="-128"/>
                </a:rPr>
                <a:t>75</a:t>
              </a:r>
              <a:endParaRPr lang="en-US" altLang="ja-JP"/>
            </a:p>
          </p:txBody>
        </p:sp>
        <p:sp>
          <p:nvSpPr>
            <p:cNvPr id="52" name="Line 266">
              <a:extLst>
                <a:ext uri="{FF2B5EF4-FFF2-40B4-BE49-F238E27FC236}">
                  <a16:creationId xmlns:a16="http://schemas.microsoft.com/office/drawing/2014/main" id="{B87801A9-FAD3-B063-90FC-6F208AC226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720" y="2235392"/>
              <a:ext cx="43697" cy="15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3" name="Rectangle 267">
              <a:extLst>
                <a:ext uri="{FF2B5EF4-FFF2-40B4-BE49-F238E27FC236}">
                  <a16:creationId xmlns:a16="http://schemas.microsoft.com/office/drawing/2014/main" id="{B65056C9-E165-20B6-F424-776F73E9ED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363" y="2184592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100</a:t>
              </a:r>
              <a:endParaRPr lang="en-US" altLang="ja-JP" dirty="0"/>
            </a:p>
          </p:txBody>
        </p:sp>
        <p:sp>
          <p:nvSpPr>
            <p:cNvPr id="54" name="Freeform 269">
              <a:extLst>
                <a:ext uri="{FF2B5EF4-FFF2-40B4-BE49-F238E27FC236}">
                  <a16:creationId xmlns:a16="http://schemas.microsoft.com/office/drawing/2014/main" id="{B4F912AB-B003-8824-B1AF-0867D97468A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058" y="2241742"/>
              <a:ext cx="4471639" cy="755650"/>
            </a:xfrm>
            <a:custGeom>
              <a:avLst/>
              <a:gdLst>
                <a:gd name="T0" fmla="*/ 52 w 3685"/>
                <a:gd name="T1" fmla="*/ 793 h 953"/>
                <a:gd name="T2" fmla="*/ 111 w 3685"/>
                <a:gd name="T3" fmla="*/ 941 h 953"/>
                <a:gd name="T4" fmla="*/ 170 w 3685"/>
                <a:gd name="T5" fmla="*/ 824 h 953"/>
                <a:gd name="T6" fmla="*/ 229 w 3685"/>
                <a:gd name="T7" fmla="*/ 943 h 953"/>
                <a:gd name="T8" fmla="*/ 287 w 3685"/>
                <a:gd name="T9" fmla="*/ 928 h 953"/>
                <a:gd name="T10" fmla="*/ 346 w 3685"/>
                <a:gd name="T11" fmla="*/ 739 h 953"/>
                <a:gd name="T12" fmla="*/ 405 w 3685"/>
                <a:gd name="T13" fmla="*/ 494 h 953"/>
                <a:gd name="T14" fmla="*/ 464 w 3685"/>
                <a:gd name="T15" fmla="*/ 891 h 953"/>
                <a:gd name="T16" fmla="*/ 524 w 3685"/>
                <a:gd name="T17" fmla="*/ 937 h 953"/>
                <a:gd name="T18" fmla="*/ 583 w 3685"/>
                <a:gd name="T19" fmla="*/ 945 h 953"/>
                <a:gd name="T20" fmla="*/ 642 w 3685"/>
                <a:gd name="T21" fmla="*/ 951 h 953"/>
                <a:gd name="T22" fmla="*/ 700 w 3685"/>
                <a:gd name="T23" fmla="*/ 951 h 953"/>
                <a:gd name="T24" fmla="*/ 759 w 3685"/>
                <a:gd name="T25" fmla="*/ 951 h 953"/>
                <a:gd name="T26" fmla="*/ 818 w 3685"/>
                <a:gd name="T27" fmla="*/ 947 h 953"/>
                <a:gd name="T28" fmla="*/ 877 w 3685"/>
                <a:gd name="T29" fmla="*/ 951 h 953"/>
                <a:gd name="T30" fmla="*/ 936 w 3685"/>
                <a:gd name="T31" fmla="*/ 929 h 953"/>
                <a:gd name="T32" fmla="*/ 995 w 3685"/>
                <a:gd name="T33" fmla="*/ 941 h 953"/>
                <a:gd name="T34" fmla="*/ 1054 w 3685"/>
                <a:gd name="T35" fmla="*/ 945 h 953"/>
                <a:gd name="T36" fmla="*/ 1113 w 3685"/>
                <a:gd name="T37" fmla="*/ 947 h 953"/>
                <a:gd name="T38" fmla="*/ 1171 w 3685"/>
                <a:gd name="T39" fmla="*/ 949 h 953"/>
                <a:gd name="T40" fmla="*/ 1230 w 3685"/>
                <a:gd name="T41" fmla="*/ 943 h 953"/>
                <a:gd name="T42" fmla="*/ 1289 w 3685"/>
                <a:gd name="T43" fmla="*/ 947 h 953"/>
                <a:gd name="T44" fmla="*/ 1349 w 3685"/>
                <a:gd name="T45" fmla="*/ 947 h 953"/>
                <a:gd name="T46" fmla="*/ 1408 w 3685"/>
                <a:gd name="T47" fmla="*/ 945 h 953"/>
                <a:gd name="T48" fmla="*/ 1467 w 3685"/>
                <a:gd name="T49" fmla="*/ 945 h 953"/>
                <a:gd name="T50" fmla="*/ 1526 w 3685"/>
                <a:gd name="T51" fmla="*/ 945 h 953"/>
                <a:gd name="T52" fmla="*/ 1584 w 3685"/>
                <a:gd name="T53" fmla="*/ 945 h 953"/>
                <a:gd name="T54" fmla="*/ 1643 w 3685"/>
                <a:gd name="T55" fmla="*/ 945 h 953"/>
                <a:gd name="T56" fmla="*/ 1702 w 3685"/>
                <a:gd name="T57" fmla="*/ 937 h 953"/>
                <a:gd name="T58" fmla="*/ 1761 w 3685"/>
                <a:gd name="T59" fmla="*/ 935 h 953"/>
                <a:gd name="T60" fmla="*/ 1820 w 3685"/>
                <a:gd name="T61" fmla="*/ 939 h 953"/>
                <a:gd name="T62" fmla="*/ 1879 w 3685"/>
                <a:gd name="T63" fmla="*/ 939 h 953"/>
                <a:gd name="T64" fmla="*/ 1938 w 3685"/>
                <a:gd name="T65" fmla="*/ 939 h 953"/>
                <a:gd name="T66" fmla="*/ 1996 w 3685"/>
                <a:gd name="T67" fmla="*/ 935 h 953"/>
                <a:gd name="T68" fmla="*/ 2055 w 3685"/>
                <a:gd name="T69" fmla="*/ 929 h 953"/>
                <a:gd name="T70" fmla="*/ 2114 w 3685"/>
                <a:gd name="T71" fmla="*/ 931 h 953"/>
                <a:gd name="T72" fmla="*/ 2174 w 3685"/>
                <a:gd name="T73" fmla="*/ 929 h 953"/>
                <a:gd name="T74" fmla="*/ 2233 w 3685"/>
                <a:gd name="T75" fmla="*/ 931 h 953"/>
                <a:gd name="T76" fmla="*/ 2292 w 3685"/>
                <a:gd name="T77" fmla="*/ 926 h 953"/>
                <a:gd name="T78" fmla="*/ 2351 w 3685"/>
                <a:gd name="T79" fmla="*/ 928 h 953"/>
                <a:gd name="T80" fmla="*/ 2410 w 3685"/>
                <a:gd name="T81" fmla="*/ 926 h 953"/>
                <a:gd name="T82" fmla="*/ 2468 w 3685"/>
                <a:gd name="T83" fmla="*/ 893 h 953"/>
                <a:gd name="T84" fmla="*/ 2527 w 3685"/>
                <a:gd name="T85" fmla="*/ 872 h 953"/>
                <a:gd name="T86" fmla="*/ 2586 w 3685"/>
                <a:gd name="T87" fmla="*/ 916 h 953"/>
                <a:gd name="T88" fmla="*/ 2645 w 3685"/>
                <a:gd name="T89" fmla="*/ 918 h 953"/>
                <a:gd name="T90" fmla="*/ 2704 w 3685"/>
                <a:gd name="T91" fmla="*/ 918 h 953"/>
                <a:gd name="T92" fmla="*/ 2763 w 3685"/>
                <a:gd name="T93" fmla="*/ 918 h 953"/>
                <a:gd name="T94" fmla="*/ 2822 w 3685"/>
                <a:gd name="T95" fmla="*/ 914 h 953"/>
                <a:gd name="T96" fmla="*/ 2880 w 3685"/>
                <a:gd name="T97" fmla="*/ 906 h 953"/>
                <a:gd name="T98" fmla="*/ 2939 w 3685"/>
                <a:gd name="T99" fmla="*/ 908 h 953"/>
                <a:gd name="T100" fmla="*/ 2999 w 3685"/>
                <a:gd name="T101" fmla="*/ 908 h 953"/>
                <a:gd name="T102" fmla="*/ 3058 w 3685"/>
                <a:gd name="T103" fmla="*/ 889 h 953"/>
                <a:gd name="T104" fmla="*/ 3117 w 3685"/>
                <a:gd name="T105" fmla="*/ 880 h 953"/>
                <a:gd name="T106" fmla="*/ 3176 w 3685"/>
                <a:gd name="T107" fmla="*/ 901 h 953"/>
                <a:gd name="T108" fmla="*/ 3235 w 3685"/>
                <a:gd name="T109" fmla="*/ 864 h 953"/>
                <a:gd name="T110" fmla="*/ 3294 w 3685"/>
                <a:gd name="T111" fmla="*/ 889 h 953"/>
                <a:gd name="T112" fmla="*/ 3352 w 3685"/>
                <a:gd name="T113" fmla="*/ 799 h 953"/>
                <a:gd name="T114" fmla="*/ 3411 w 3685"/>
                <a:gd name="T115" fmla="*/ 620 h 953"/>
                <a:gd name="T116" fmla="*/ 3470 w 3685"/>
                <a:gd name="T117" fmla="*/ 705 h 953"/>
                <a:gd name="T118" fmla="*/ 3529 w 3685"/>
                <a:gd name="T119" fmla="*/ 764 h 953"/>
                <a:gd name="T120" fmla="*/ 3588 w 3685"/>
                <a:gd name="T121" fmla="*/ 797 h 953"/>
                <a:gd name="T122" fmla="*/ 3647 w 3685"/>
                <a:gd name="T123" fmla="*/ 818 h 9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685" h="953">
                  <a:moveTo>
                    <a:pt x="0" y="949"/>
                  </a:moveTo>
                  <a:lnTo>
                    <a:pt x="2" y="941"/>
                  </a:lnTo>
                  <a:lnTo>
                    <a:pt x="8" y="924"/>
                  </a:lnTo>
                  <a:lnTo>
                    <a:pt x="13" y="901"/>
                  </a:lnTo>
                  <a:lnTo>
                    <a:pt x="18" y="874"/>
                  </a:lnTo>
                  <a:lnTo>
                    <a:pt x="22" y="843"/>
                  </a:lnTo>
                  <a:lnTo>
                    <a:pt x="27" y="812"/>
                  </a:lnTo>
                  <a:lnTo>
                    <a:pt x="32" y="787"/>
                  </a:lnTo>
                  <a:lnTo>
                    <a:pt x="37" y="772"/>
                  </a:lnTo>
                  <a:lnTo>
                    <a:pt x="42" y="768"/>
                  </a:lnTo>
                  <a:lnTo>
                    <a:pt x="47" y="776"/>
                  </a:lnTo>
                  <a:lnTo>
                    <a:pt x="52" y="793"/>
                  </a:lnTo>
                  <a:lnTo>
                    <a:pt x="57" y="816"/>
                  </a:lnTo>
                  <a:lnTo>
                    <a:pt x="61" y="837"/>
                  </a:lnTo>
                  <a:lnTo>
                    <a:pt x="66" y="858"/>
                  </a:lnTo>
                  <a:lnTo>
                    <a:pt x="72" y="876"/>
                  </a:lnTo>
                  <a:lnTo>
                    <a:pt x="77" y="891"/>
                  </a:lnTo>
                  <a:lnTo>
                    <a:pt x="81" y="903"/>
                  </a:lnTo>
                  <a:lnTo>
                    <a:pt x="86" y="914"/>
                  </a:lnTo>
                  <a:lnTo>
                    <a:pt x="91" y="922"/>
                  </a:lnTo>
                  <a:lnTo>
                    <a:pt x="96" y="929"/>
                  </a:lnTo>
                  <a:lnTo>
                    <a:pt x="100" y="935"/>
                  </a:lnTo>
                  <a:lnTo>
                    <a:pt x="106" y="939"/>
                  </a:lnTo>
                  <a:lnTo>
                    <a:pt x="111" y="941"/>
                  </a:lnTo>
                  <a:lnTo>
                    <a:pt x="116" y="943"/>
                  </a:lnTo>
                  <a:lnTo>
                    <a:pt x="121" y="941"/>
                  </a:lnTo>
                  <a:lnTo>
                    <a:pt x="125" y="937"/>
                  </a:lnTo>
                  <a:lnTo>
                    <a:pt x="130" y="929"/>
                  </a:lnTo>
                  <a:lnTo>
                    <a:pt x="136" y="918"/>
                  </a:lnTo>
                  <a:lnTo>
                    <a:pt x="141" y="901"/>
                  </a:lnTo>
                  <a:lnTo>
                    <a:pt x="145" y="882"/>
                  </a:lnTo>
                  <a:lnTo>
                    <a:pt x="150" y="860"/>
                  </a:lnTo>
                  <a:lnTo>
                    <a:pt x="155" y="841"/>
                  </a:lnTo>
                  <a:lnTo>
                    <a:pt x="160" y="828"/>
                  </a:lnTo>
                  <a:lnTo>
                    <a:pt x="164" y="822"/>
                  </a:lnTo>
                  <a:lnTo>
                    <a:pt x="170" y="824"/>
                  </a:lnTo>
                  <a:lnTo>
                    <a:pt x="175" y="834"/>
                  </a:lnTo>
                  <a:lnTo>
                    <a:pt x="180" y="847"/>
                  </a:lnTo>
                  <a:lnTo>
                    <a:pt x="184" y="862"/>
                  </a:lnTo>
                  <a:lnTo>
                    <a:pt x="189" y="876"/>
                  </a:lnTo>
                  <a:lnTo>
                    <a:pt x="194" y="889"/>
                  </a:lnTo>
                  <a:lnTo>
                    <a:pt x="200" y="901"/>
                  </a:lnTo>
                  <a:lnTo>
                    <a:pt x="204" y="912"/>
                  </a:lnTo>
                  <a:lnTo>
                    <a:pt x="209" y="920"/>
                  </a:lnTo>
                  <a:lnTo>
                    <a:pt x="214" y="928"/>
                  </a:lnTo>
                  <a:lnTo>
                    <a:pt x="219" y="933"/>
                  </a:lnTo>
                  <a:lnTo>
                    <a:pt x="223" y="939"/>
                  </a:lnTo>
                  <a:lnTo>
                    <a:pt x="229" y="943"/>
                  </a:lnTo>
                  <a:lnTo>
                    <a:pt x="234" y="945"/>
                  </a:lnTo>
                  <a:lnTo>
                    <a:pt x="239" y="949"/>
                  </a:lnTo>
                  <a:lnTo>
                    <a:pt x="243" y="951"/>
                  </a:lnTo>
                  <a:lnTo>
                    <a:pt x="248" y="951"/>
                  </a:lnTo>
                  <a:lnTo>
                    <a:pt x="253" y="953"/>
                  </a:lnTo>
                  <a:lnTo>
                    <a:pt x="258" y="953"/>
                  </a:lnTo>
                  <a:lnTo>
                    <a:pt x="263" y="951"/>
                  </a:lnTo>
                  <a:lnTo>
                    <a:pt x="268" y="949"/>
                  </a:lnTo>
                  <a:lnTo>
                    <a:pt x="273" y="947"/>
                  </a:lnTo>
                  <a:lnTo>
                    <a:pt x="278" y="941"/>
                  </a:lnTo>
                  <a:lnTo>
                    <a:pt x="282" y="935"/>
                  </a:lnTo>
                  <a:lnTo>
                    <a:pt x="287" y="928"/>
                  </a:lnTo>
                  <a:lnTo>
                    <a:pt x="293" y="918"/>
                  </a:lnTo>
                  <a:lnTo>
                    <a:pt x="298" y="910"/>
                  </a:lnTo>
                  <a:lnTo>
                    <a:pt x="302" y="905"/>
                  </a:lnTo>
                  <a:lnTo>
                    <a:pt x="307" y="903"/>
                  </a:lnTo>
                  <a:lnTo>
                    <a:pt x="312" y="905"/>
                  </a:lnTo>
                  <a:lnTo>
                    <a:pt x="317" y="906"/>
                  </a:lnTo>
                  <a:lnTo>
                    <a:pt x="322" y="906"/>
                  </a:lnTo>
                  <a:lnTo>
                    <a:pt x="327" y="903"/>
                  </a:lnTo>
                  <a:lnTo>
                    <a:pt x="332" y="889"/>
                  </a:lnTo>
                  <a:lnTo>
                    <a:pt x="337" y="864"/>
                  </a:lnTo>
                  <a:lnTo>
                    <a:pt x="342" y="816"/>
                  </a:lnTo>
                  <a:lnTo>
                    <a:pt x="346" y="739"/>
                  </a:lnTo>
                  <a:lnTo>
                    <a:pt x="351" y="626"/>
                  </a:lnTo>
                  <a:lnTo>
                    <a:pt x="357" y="480"/>
                  </a:lnTo>
                  <a:lnTo>
                    <a:pt x="362" y="315"/>
                  </a:lnTo>
                  <a:lnTo>
                    <a:pt x="366" y="160"/>
                  </a:lnTo>
                  <a:lnTo>
                    <a:pt x="371" y="45"/>
                  </a:lnTo>
                  <a:lnTo>
                    <a:pt x="376" y="0"/>
                  </a:lnTo>
                  <a:lnTo>
                    <a:pt x="381" y="25"/>
                  </a:lnTo>
                  <a:lnTo>
                    <a:pt x="385" y="102"/>
                  </a:lnTo>
                  <a:lnTo>
                    <a:pt x="391" y="206"/>
                  </a:lnTo>
                  <a:lnTo>
                    <a:pt x="396" y="310"/>
                  </a:lnTo>
                  <a:lnTo>
                    <a:pt x="401" y="407"/>
                  </a:lnTo>
                  <a:lnTo>
                    <a:pt x="405" y="494"/>
                  </a:lnTo>
                  <a:lnTo>
                    <a:pt x="410" y="571"/>
                  </a:lnTo>
                  <a:lnTo>
                    <a:pt x="415" y="638"/>
                  </a:lnTo>
                  <a:lnTo>
                    <a:pt x="421" y="697"/>
                  </a:lnTo>
                  <a:lnTo>
                    <a:pt x="425" y="745"/>
                  </a:lnTo>
                  <a:lnTo>
                    <a:pt x="430" y="787"/>
                  </a:lnTo>
                  <a:lnTo>
                    <a:pt x="435" y="820"/>
                  </a:lnTo>
                  <a:lnTo>
                    <a:pt x="440" y="847"/>
                  </a:lnTo>
                  <a:lnTo>
                    <a:pt x="444" y="866"/>
                  </a:lnTo>
                  <a:lnTo>
                    <a:pt x="450" y="880"/>
                  </a:lnTo>
                  <a:lnTo>
                    <a:pt x="455" y="887"/>
                  </a:lnTo>
                  <a:lnTo>
                    <a:pt x="460" y="891"/>
                  </a:lnTo>
                  <a:lnTo>
                    <a:pt x="464" y="891"/>
                  </a:lnTo>
                  <a:lnTo>
                    <a:pt x="469" y="891"/>
                  </a:lnTo>
                  <a:lnTo>
                    <a:pt x="474" y="891"/>
                  </a:lnTo>
                  <a:lnTo>
                    <a:pt x="479" y="893"/>
                  </a:lnTo>
                  <a:lnTo>
                    <a:pt x="484" y="897"/>
                  </a:lnTo>
                  <a:lnTo>
                    <a:pt x="489" y="905"/>
                  </a:lnTo>
                  <a:lnTo>
                    <a:pt x="494" y="910"/>
                  </a:lnTo>
                  <a:lnTo>
                    <a:pt x="499" y="916"/>
                  </a:lnTo>
                  <a:lnTo>
                    <a:pt x="503" y="924"/>
                  </a:lnTo>
                  <a:lnTo>
                    <a:pt x="508" y="928"/>
                  </a:lnTo>
                  <a:lnTo>
                    <a:pt x="514" y="931"/>
                  </a:lnTo>
                  <a:lnTo>
                    <a:pt x="519" y="935"/>
                  </a:lnTo>
                  <a:lnTo>
                    <a:pt x="524" y="937"/>
                  </a:lnTo>
                  <a:lnTo>
                    <a:pt x="528" y="939"/>
                  </a:lnTo>
                  <a:lnTo>
                    <a:pt x="533" y="941"/>
                  </a:lnTo>
                  <a:lnTo>
                    <a:pt x="538" y="943"/>
                  </a:lnTo>
                  <a:lnTo>
                    <a:pt x="543" y="943"/>
                  </a:lnTo>
                  <a:lnTo>
                    <a:pt x="548" y="943"/>
                  </a:lnTo>
                  <a:lnTo>
                    <a:pt x="553" y="941"/>
                  </a:lnTo>
                  <a:lnTo>
                    <a:pt x="558" y="941"/>
                  </a:lnTo>
                  <a:lnTo>
                    <a:pt x="563" y="941"/>
                  </a:lnTo>
                  <a:lnTo>
                    <a:pt x="567" y="943"/>
                  </a:lnTo>
                  <a:lnTo>
                    <a:pt x="572" y="943"/>
                  </a:lnTo>
                  <a:lnTo>
                    <a:pt x="578" y="945"/>
                  </a:lnTo>
                  <a:lnTo>
                    <a:pt x="583" y="945"/>
                  </a:lnTo>
                  <a:lnTo>
                    <a:pt x="587" y="947"/>
                  </a:lnTo>
                  <a:lnTo>
                    <a:pt x="592" y="947"/>
                  </a:lnTo>
                  <a:lnTo>
                    <a:pt x="597" y="949"/>
                  </a:lnTo>
                  <a:lnTo>
                    <a:pt x="602" y="949"/>
                  </a:lnTo>
                  <a:lnTo>
                    <a:pt x="606" y="949"/>
                  </a:lnTo>
                  <a:lnTo>
                    <a:pt x="612" y="951"/>
                  </a:lnTo>
                  <a:lnTo>
                    <a:pt x="617" y="951"/>
                  </a:lnTo>
                  <a:lnTo>
                    <a:pt x="622" y="951"/>
                  </a:lnTo>
                  <a:lnTo>
                    <a:pt x="626" y="951"/>
                  </a:lnTo>
                  <a:lnTo>
                    <a:pt x="631" y="951"/>
                  </a:lnTo>
                  <a:lnTo>
                    <a:pt x="636" y="951"/>
                  </a:lnTo>
                  <a:lnTo>
                    <a:pt x="642" y="951"/>
                  </a:lnTo>
                  <a:lnTo>
                    <a:pt x="646" y="951"/>
                  </a:lnTo>
                  <a:lnTo>
                    <a:pt x="651" y="951"/>
                  </a:lnTo>
                  <a:lnTo>
                    <a:pt x="656" y="949"/>
                  </a:lnTo>
                  <a:lnTo>
                    <a:pt x="661" y="949"/>
                  </a:lnTo>
                  <a:lnTo>
                    <a:pt x="665" y="949"/>
                  </a:lnTo>
                  <a:lnTo>
                    <a:pt x="671" y="949"/>
                  </a:lnTo>
                  <a:lnTo>
                    <a:pt x="676" y="949"/>
                  </a:lnTo>
                  <a:lnTo>
                    <a:pt x="681" y="951"/>
                  </a:lnTo>
                  <a:lnTo>
                    <a:pt x="685" y="951"/>
                  </a:lnTo>
                  <a:lnTo>
                    <a:pt x="690" y="951"/>
                  </a:lnTo>
                  <a:lnTo>
                    <a:pt x="695" y="951"/>
                  </a:lnTo>
                  <a:lnTo>
                    <a:pt x="700" y="951"/>
                  </a:lnTo>
                  <a:lnTo>
                    <a:pt x="705" y="951"/>
                  </a:lnTo>
                  <a:lnTo>
                    <a:pt x="710" y="951"/>
                  </a:lnTo>
                  <a:lnTo>
                    <a:pt x="715" y="951"/>
                  </a:lnTo>
                  <a:lnTo>
                    <a:pt x="720" y="951"/>
                  </a:lnTo>
                  <a:lnTo>
                    <a:pt x="725" y="951"/>
                  </a:lnTo>
                  <a:lnTo>
                    <a:pt x="729" y="951"/>
                  </a:lnTo>
                  <a:lnTo>
                    <a:pt x="735" y="951"/>
                  </a:lnTo>
                  <a:lnTo>
                    <a:pt x="740" y="951"/>
                  </a:lnTo>
                  <a:lnTo>
                    <a:pt x="745" y="951"/>
                  </a:lnTo>
                  <a:lnTo>
                    <a:pt x="749" y="951"/>
                  </a:lnTo>
                  <a:lnTo>
                    <a:pt x="754" y="951"/>
                  </a:lnTo>
                  <a:lnTo>
                    <a:pt x="759" y="951"/>
                  </a:lnTo>
                  <a:lnTo>
                    <a:pt x="764" y="951"/>
                  </a:lnTo>
                  <a:lnTo>
                    <a:pt x="769" y="951"/>
                  </a:lnTo>
                  <a:lnTo>
                    <a:pt x="774" y="951"/>
                  </a:lnTo>
                  <a:lnTo>
                    <a:pt x="779" y="951"/>
                  </a:lnTo>
                  <a:lnTo>
                    <a:pt x="784" y="951"/>
                  </a:lnTo>
                  <a:lnTo>
                    <a:pt x="788" y="949"/>
                  </a:lnTo>
                  <a:lnTo>
                    <a:pt x="793" y="949"/>
                  </a:lnTo>
                  <a:lnTo>
                    <a:pt x="799" y="949"/>
                  </a:lnTo>
                  <a:lnTo>
                    <a:pt x="804" y="949"/>
                  </a:lnTo>
                  <a:lnTo>
                    <a:pt x="808" y="949"/>
                  </a:lnTo>
                  <a:lnTo>
                    <a:pt x="813" y="949"/>
                  </a:lnTo>
                  <a:lnTo>
                    <a:pt x="818" y="947"/>
                  </a:lnTo>
                  <a:lnTo>
                    <a:pt x="823" y="947"/>
                  </a:lnTo>
                  <a:lnTo>
                    <a:pt x="827" y="947"/>
                  </a:lnTo>
                  <a:lnTo>
                    <a:pt x="833" y="947"/>
                  </a:lnTo>
                  <a:lnTo>
                    <a:pt x="838" y="949"/>
                  </a:lnTo>
                  <a:lnTo>
                    <a:pt x="843" y="949"/>
                  </a:lnTo>
                  <a:lnTo>
                    <a:pt x="847" y="949"/>
                  </a:lnTo>
                  <a:lnTo>
                    <a:pt x="852" y="949"/>
                  </a:lnTo>
                  <a:lnTo>
                    <a:pt x="857" y="949"/>
                  </a:lnTo>
                  <a:lnTo>
                    <a:pt x="863" y="951"/>
                  </a:lnTo>
                  <a:lnTo>
                    <a:pt x="867" y="951"/>
                  </a:lnTo>
                  <a:lnTo>
                    <a:pt x="872" y="951"/>
                  </a:lnTo>
                  <a:lnTo>
                    <a:pt x="877" y="951"/>
                  </a:lnTo>
                  <a:lnTo>
                    <a:pt x="882" y="951"/>
                  </a:lnTo>
                  <a:lnTo>
                    <a:pt x="886" y="951"/>
                  </a:lnTo>
                  <a:lnTo>
                    <a:pt x="892" y="951"/>
                  </a:lnTo>
                  <a:lnTo>
                    <a:pt x="897" y="951"/>
                  </a:lnTo>
                  <a:lnTo>
                    <a:pt x="902" y="951"/>
                  </a:lnTo>
                  <a:lnTo>
                    <a:pt x="906" y="951"/>
                  </a:lnTo>
                  <a:lnTo>
                    <a:pt x="911" y="949"/>
                  </a:lnTo>
                  <a:lnTo>
                    <a:pt x="916" y="947"/>
                  </a:lnTo>
                  <a:lnTo>
                    <a:pt x="921" y="945"/>
                  </a:lnTo>
                  <a:lnTo>
                    <a:pt x="927" y="941"/>
                  </a:lnTo>
                  <a:lnTo>
                    <a:pt x="931" y="935"/>
                  </a:lnTo>
                  <a:lnTo>
                    <a:pt x="936" y="929"/>
                  </a:lnTo>
                  <a:lnTo>
                    <a:pt x="941" y="924"/>
                  </a:lnTo>
                  <a:lnTo>
                    <a:pt x="946" y="918"/>
                  </a:lnTo>
                  <a:lnTo>
                    <a:pt x="950" y="916"/>
                  </a:lnTo>
                  <a:lnTo>
                    <a:pt x="956" y="916"/>
                  </a:lnTo>
                  <a:lnTo>
                    <a:pt x="961" y="918"/>
                  </a:lnTo>
                  <a:lnTo>
                    <a:pt x="966" y="922"/>
                  </a:lnTo>
                  <a:lnTo>
                    <a:pt x="970" y="928"/>
                  </a:lnTo>
                  <a:lnTo>
                    <a:pt x="975" y="931"/>
                  </a:lnTo>
                  <a:lnTo>
                    <a:pt x="980" y="935"/>
                  </a:lnTo>
                  <a:lnTo>
                    <a:pt x="985" y="937"/>
                  </a:lnTo>
                  <a:lnTo>
                    <a:pt x="990" y="939"/>
                  </a:lnTo>
                  <a:lnTo>
                    <a:pt x="995" y="941"/>
                  </a:lnTo>
                  <a:lnTo>
                    <a:pt x="1000" y="943"/>
                  </a:lnTo>
                  <a:lnTo>
                    <a:pt x="1005" y="945"/>
                  </a:lnTo>
                  <a:lnTo>
                    <a:pt x="1009" y="945"/>
                  </a:lnTo>
                  <a:lnTo>
                    <a:pt x="1014" y="947"/>
                  </a:lnTo>
                  <a:lnTo>
                    <a:pt x="1020" y="947"/>
                  </a:lnTo>
                  <a:lnTo>
                    <a:pt x="1025" y="949"/>
                  </a:lnTo>
                  <a:lnTo>
                    <a:pt x="1029" y="949"/>
                  </a:lnTo>
                  <a:lnTo>
                    <a:pt x="1034" y="949"/>
                  </a:lnTo>
                  <a:lnTo>
                    <a:pt x="1039" y="949"/>
                  </a:lnTo>
                  <a:lnTo>
                    <a:pt x="1044" y="947"/>
                  </a:lnTo>
                  <a:lnTo>
                    <a:pt x="1048" y="947"/>
                  </a:lnTo>
                  <a:lnTo>
                    <a:pt x="1054" y="945"/>
                  </a:lnTo>
                  <a:lnTo>
                    <a:pt x="1059" y="943"/>
                  </a:lnTo>
                  <a:lnTo>
                    <a:pt x="1064" y="941"/>
                  </a:lnTo>
                  <a:lnTo>
                    <a:pt x="1068" y="939"/>
                  </a:lnTo>
                  <a:lnTo>
                    <a:pt x="1073" y="939"/>
                  </a:lnTo>
                  <a:lnTo>
                    <a:pt x="1078" y="939"/>
                  </a:lnTo>
                  <a:lnTo>
                    <a:pt x="1084" y="941"/>
                  </a:lnTo>
                  <a:lnTo>
                    <a:pt x="1088" y="943"/>
                  </a:lnTo>
                  <a:lnTo>
                    <a:pt x="1093" y="945"/>
                  </a:lnTo>
                  <a:lnTo>
                    <a:pt x="1098" y="945"/>
                  </a:lnTo>
                  <a:lnTo>
                    <a:pt x="1103" y="947"/>
                  </a:lnTo>
                  <a:lnTo>
                    <a:pt x="1107" y="947"/>
                  </a:lnTo>
                  <a:lnTo>
                    <a:pt x="1113" y="947"/>
                  </a:lnTo>
                  <a:lnTo>
                    <a:pt x="1118" y="947"/>
                  </a:lnTo>
                  <a:lnTo>
                    <a:pt x="1123" y="947"/>
                  </a:lnTo>
                  <a:lnTo>
                    <a:pt x="1128" y="947"/>
                  </a:lnTo>
                  <a:lnTo>
                    <a:pt x="1132" y="947"/>
                  </a:lnTo>
                  <a:lnTo>
                    <a:pt x="1137" y="947"/>
                  </a:lnTo>
                  <a:lnTo>
                    <a:pt x="1142" y="947"/>
                  </a:lnTo>
                  <a:lnTo>
                    <a:pt x="1148" y="947"/>
                  </a:lnTo>
                  <a:lnTo>
                    <a:pt x="1152" y="947"/>
                  </a:lnTo>
                  <a:lnTo>
                    <a:pt x="1157" y="947"/>
                  </a:lnTo>
                  <a:lnTo>
                    <a:pt x="1162" y="947"/>
                  </a:lnTo>
                  <a:lnTo>
                    <a:pt x="1167" y="949"/>
                  </a:lnTo>
                  <a:lnTo>
                    <a:pt x="1171" y="949"/>
                  </a:lnTo>
                  <a:lnTo>
                    <a:pt x="1177" y="949"/>
                  </a:lnTo>
                  <a:lnTo>
                    <a:pt x="1182" y="949"/>
                  </a:lnTo>
                  <a:lnTo>
                    <a:pt x="1187" y="949"/>
                  </a:lnTo>
                  <a:lnTo>
                    <a:pt x="1191" y="947"/>
                  </a:lnTo>
                  <a:lnTo>
                    <a:pt x="1196" y="947"/>
                  </a:lnTo>
                  <a:lnTo>
                    <a:pt x="1201" y="945"/>
                  </a:lnTo>
                  <a:lnTo>
                    <a:pt x="1206" y="945"/>
                  </a:lnTo>
                  <a:lnTo>
                    <a:pt x="1211" y="943"/>
                  </a:lnTo>
                  <a:lnTo>
                    <a:pt x="1216" y="943"/>
                  </a:lnTo>
                  <a:lnTo>
                    <a:pt x="1221" y="943"/>
                  </a:lnTo>
                  <a:lnTo>
                    <a:pt x="1226" y="943"/>
                  </a:lnTo>
                  <a:lnTo>
                    <a:pt x="1230" y="943"/>
                  </a:lnTo>
                  <a:lnTo>
                    <a:pt x="1235" y="943"/>
                  </a:lnTo>
                  <a:lnTo>
                    <a:pt x="1241" y="945"/>
                  </a:lnTo>
                  <a:lnTo>
                    <a:pt x="1246" y="945"/>
                  </a:lnTo>
                  <a:lnTo>
                    <a:pt x="1250" y="945"/>
                  </a:lnTo>
                  <a:lnTo>
                    <a:pt x="1255" y="947"/>
                  </a:lnTo>
                  <a:lnTo>
                    <a:pt x="1260" y="947"/>
                  </a:lnTo>
                  <a:lnTo>
                    <a:pt x="1265" y="947"/>
                  </a:lnTo>
                  <a:lnTo>
                    <a:pt x="1269" y="947"/>
                  </a:lnTo>
                  <a:lnTo>
                    <a:pt x="1275" y="947"/>
                  </a:lnTo>
                  <a:lnTo>
                    <a:pt x="1280" y="947"/>
                  </a:lnTo>
                  <a:lnTo>
                    <a:pt x="1285" y="947"/>
                  </a:lnTo>
                  <a:lnTo>
                    <a:pt x="1289" y="947"/>
                  </a:lnTo>
                  <a:lnTo>
                    <a:pt x="1294" y="947"/>
                  </a:lnTo>
                  <a:lnTo>
                    <a:pt x="1299" y="947"/>
                  </a:lnTo>
                  <a:lnTo>
                    <a:pt x="1305" y="947"/>
                  </a:lnTo>
                  <a:lnTo>
                    <a:pt x="1309" y="947"/>
                  </a:lnTo>
                  <a:lnTo>
                    <a:pt x="1314" y="947"/>
                  </a:lnTo>
                  <a:lnTo>
                    <a:pt x="1319" y="947"/>
                  </a:lnTo>
                  <a:lnTo>
                    <a:pt x="1324" y="947"/>
                  </a:lnTo>
                  <a:lnTo>
                    <a:pt x="1328" y="947"/>
                  </a:lnTo>
                  <a:lnTo>
                    <a:pt x="1334" y="947"/>
                  </a:lnTo>
                  <a:lnTo>
                    <a:pt x="1339" y="947"/>
                  </a:lnTo>
                  <a:lnTo>
                    <a:pt x="1344" y="947"/>
                  </a:lnTo>
                  <a:lnTo>
                    <a:pt x="1349" y="947"/>
                  </a:lnTo>
                  <a:lnTo>
                    <a:pt x="1353" y="947"/>
                  </a:lnTo>
                  <a:lnTo>
                    <a:pt x="1358" y="947"/>
                  </a:lnTo>
                  <a:lnTo>
                    <a:pt x="1363" y="947"/>
                  </a:lnTo>
                  <a:lnTo>
                    <a:pt x="1369" y="947"/>
                  </a:lnTo>
                  <a:lnTo>
                    <a:pt x="1373" y="947"/>
                  </a:lnTo>
                  <a:lnTo>
                    <a:pt x="1378" y="947"/>
                  </a:lnTo>
                  <a:lnTo>
                    <a:pt x="1383" y="947"/>
                  </a:lnTo>
                  <a:lnTo>
                    <a:pt x="1388" y="945"/>
                  </a:lnTo>
                  <a:lnTo>
                    <a:pt x="1392" y="945"/>
                  </a:lnTo>
                  <a:lnTo>
                    <a:pt x="1398" y="945"/>
                  </a:lnTo>
                  <a:lnTo>
                    <a:pt x="1403" y="945"/>
                  </a:lnTo>
                  <a:lnTo>
                    <a:pt x="1408" y="945"/>
                  </a:lnTo>
                  <a:lnTo>
                    <a:pt x="1412" y="945"/>
                  </a:lnTo>
                  <a:lnTo>
                    <a:pt x="1417" y="945"/>
                  </a:lnTo>
                  <a:lnTo>
                    <a:pt x="1422" y="945"/>
                  </a:lnTo>
                  <a:lnTo>
                    <a:pt x="1427" y="947"/>
                  </a:lnTo>
                  <a:lnTo>
                    <a:pt x="1432" y="945"/>
                  </a:lnTo>
                  <a:lnTo>
                    <a:pt x="1437" y="945"/>
                  </a:lnTo>
                  <a:lnTo>
                    <a:pt x="1442" y="945"/>
                  </a:lnTo>
                  <a:lnTo>
                    <a:pt x="1447" y="945"/>
                  </a:lnTo>
                  <a:lnTo>
                    <a:pt x="1451" y="947"/>
                  </a:lnTo>
                  <a:lnTo>
                    <a:pt x="1456" y="947"/>
                  </a:lnTo>
                  <a:lnTo>
                    <a:pt x="1462" y="947"/>
                  </a:lnTo>
                  <a:lnTo>
                    <a:pt x="1467" y="945"/>
                  </a:lnTo>
                  <a:lnTo>
                    <a:pt x="1471" y="945"/>
                  </a:lnTo>
                  <a:lnTo>
                    <a:pt x="1476" y="945"/>
                  </a:lnTo>
                  <a:lnTo>
                    <a:pt x="1481" y="945"/>
                  </a:lnTo>
                  <a:lnTo>
                    <a:pt x="1486" y="945"/>
                  </a:lnTo>
                  <a:lnTo>
                    <a:pt x="1490" y="945"/>
                  </a:lnTo>
                  <a:lnTo>
                    <a:pt x="1496" y="945"/>
                  </a:lnTo>
                  <a:lnTo>
                    <a:pt x="1501" y="945"/>
                  </a:lnTo>
                  <a:lnTo>
                    <a:pt x="1506" y="945"/>
                  </a:lnTo>
                  <a:lnTo>
                    <a:pt x="1510" y="945"/>
                  </a:lnTo>
                  <a:lnTo>
                    <a:pt x="1515" y="945"/>
                  </a:lnTo>
                  <a:lnTo>
                    <a:pt x="1520" y="945"/>
                  </a:lnTo>
                  <a:lnTo>
                    <a:pt x="1526" y="945"/>
                  </a:lnTo>
                  <a:lnTo>
                    <a:pt x="1530" y="945"/>
                  </a:lnTo>
                  <a:lnTo>
                    <a:pt x="1535" y="945"/>
                  </a:lnTo>
                  <a:lnTo>
                    <a:pt x="1540" y="945"/>
                  </a:lnTo>
                  <a:lnTo>
                    <a:pt x="1545" y="945"/>
                  </a:lnTo>
                  <a:lnTo>
                    <a:pt x="1550" y="945"/>
                  </a:lnTo>
                  <a:lnTo>
                    <a:pt x="1555" y="945"/>
                  </a:lnTo>
                  <a:lnTo>
                    <a:pt x="1560" y="945"/>
                  </a:lnTo>
                  <a:lnTo>
                    <a:pt x="1565" y="945"/>
                  </a:lnTo>
                  <a:lnTo>
                    <a:pt x="1570" y="943"/>
                  </a:lnTo>
                  <a:lnTo>
                    <a:pt x="1574" y="945"/>
                  </a:lnTo>
                  <a:lnTo>
                    <a:pt x="1579" y="945"/>
                  </a:lnTo>
                  <a:lnTo>
                    <a:pt x="1584" y="945"/>
                  </a:lnTo>
                  <a:lnTo>
                    <a:pt x="1590" y="945"/>
                  </a:lnTo>
                  <a:lnTo>
                    <a:pt x="1594" y="945"/>
                  </a:lnTo>
                  <a:lnTo>
                    <a:pt x="1599" y="945"/>
                  </a:lnTo>
                  <a:lnTo>
                    <a:pt x="1604" y="945"/>
                  </a:lnTo>
                  <a:lnTo>
                    <a:pt x="1609" y="945"/>
                  </a:lnTo>
                  <a:lnTo>
                    <a:pt x="1613" y="945"/>
                  </a:lnTo>
                  <a:lnTo>
                    <a:pt x="1619" y="945"/>
                  </a:lnTo>
                  <a:lnTo>
                    <a:pt x="1624" y="945"/>
                  </a:lnTo>
                  <a:lnTo>
                    <a:pt x="1629" y="945"/>
                  </a:lnTo>
                  <a:lnTo>
                    <a:pt x="1633" y="945"/>
                  </a:lnTo>
                  <a:lnTo>
                    <a:pt x="1638" y="945"/>
                  </a:lnTo>
                  <a:lnTo>
                    <a:pt x="1643" y="945"/>
                  </a:lnTo>
                  <a:lnTo>
                    <a:pt x="1648" y="945"/>
                  </a:lnTo>
                  <a:lnTo>
                    <a:pt x="1653" y="945"/>
                  </a:lnTo>
                  <a:lnTo>
                    <a:pt x="1658" y="945"/>
                  </a:lnTo>
                  <a:lnTo>
                    <a:pt x="1663" y="945"/>
                  </a:lnTo>
                  <a:lnTo>
                    <a:pt x="1668" y="945"/>
                  </a:lnTo>
                  <a:lnTo>
                    <a:pt x="1672" y="945"/>
                  </a:lnTo>
                  <a:lnTo>
                    <a:pt x="1677" y="943"/>
                  </a:lnTo>
                  <a:lnTo>
                    <a:pt x="1683" y="943"/>
                  </a:lnTo>
                  <a:lnTo>
                    <a:pt x="1688" y="943"/>
                  </a:lnTo>
                  <a:lnTo>
                    <a:pt x="1692" y="941"/>
                  </a:lnTo>
                  <a:lnTo>
                    <a:pt x="1697" y="939"/>
                  </a:lnTo>
                  <a:lnTo>
                    <a:pt x="1702" y="937"/>
                  </a:lnTo>
                  <a:lnTo>
                    <a:pt x="1707" y="933"/>
                  </a:lnTo>
                  <a:lnTo>
                    <a:pt x="1711" y="929"/>
                  </a:lnTo>
                  <a:lnTo>
                    <a:pt x="1717" y="928"/>
                  </a:lnTo>
                  <a:lnTo>
                    <a:pt x="1722" y="926"/>
                  </a:lnTo>
                  <a:lnTo>
                    <a:pt x="1727" y="926"/>
                  </a:lnTo>
                  <a:lnTo>
                    <a:pt x="1731" y="926"/>
                  </a:lnTo>
                  <a:lnTo>
                    <a:pt x="1736" y="928"/>
                  </a:lnTo>
                  <a:lnTo>
                    <a:pt x="1741" y="928"/>
                  </a:lnTo>
                  <a:lnTo>
                    <a:pt x="1747" y="929"/>
                  </a:lnTo>
                  <a:lnTo>
                    <a:pt x="1752" y="931"/>
                  </a:lnTo>
                  <a:lnTo>
                    <a:pt x="1756" y="933"/>
                  </a:lnTo>
                  <a:lnTo>
                    <a:pt x="1761" y="935"/>
                  </a:lnTo>
                  <a:lnTo>
                    <a:pt x="1766" y="935"/>
                  </a:lnTo>
                  <a:lnTo>
                    <a:pt x="1771" y="937"/>
                  </a:lnTo>
                  <a:lnTo>
                    <a:pt x="1776" y="937"/>
                  </a:lnTo>
                  <a:lnTo>
                    <a:pt x="1781" y="937"/>
                  </a:lnTo>
                  <a:lnTo>
                    <a:pt x="1786" y="939"/>
                  </a:lnTo>
                  <a:lnTo>
                    <a:pt x="1791" y="939"/>
                  </a:lnTo>
                  <a:lnTo>
                    <a:pt x="1795" y="939"/>
                  </a:lnTo>
                  <a:lnTo>
                    <a:pt x="1800" y="939"/>
                  </a:lnTo>
                  <a:lnTo>
                    <a:pt x="1805" y="939"/>
                  </a:lnTo>
                  <a:lnTo>
                    <a:pt x="1811" y="939"/>
                  </a:lnTo>
                  <a:lnTo>
                    <a:pt x="1815" y="941"/>
                  </a:lnTo>
                  <a:lnTo>
                    <a:pt x="1820" y="939"/>
                  </a:lnTo>
                  <a:lnTo>
                    <a:pt x="1825" y="939"/>
                  </a:lnTo>
                  <a:lnTo>
                    <a:pt x="1830" y="939"/>
                  </a:lnTo>
                  <a:lnTo>
                    <a:pt x="1834" y="939"/>
                  </a:lnTo>
                  <a:lnTo>
                    <a:pt x="1840" y="939"/>
                  </a:lnTo>
                  <a:lnTo>
                    <a:pt x="1845" y="939"/>
                  </a:lnTo>
                  <a:lnTo>
                    <a:pt x="1850" y="939"/>
                  </a:lnTo>
                  <a:lnTo>
                    <a:pt x="1854" y="939"/>
                  </a:lnTo>
                  <a:lnTo>
                    <a:pt x="1859" y="939"/>
                  </a:lnTo>
                  <a:lnTo>
                    <a:pt x="1864" y="939"/>
                  </a:lnTo>
                  <a:lnTo>
                    <a:pt x="1869" y="939"/>
                  </a:lnTo>
                  <a:lnTo>
                    <a:pt x="1874" y="939"/>
                  </a:lnTo>
                  <a:lnTo>
                    <a:pt x="1879" y="939"/>
                  </a:lnTo>
                  <a:lnTo>
                    <a:pt x="1884" y="939"/>
                  </a:lnTo>
                  <a:lnTo>
                    <a:pt x="1889" y="939"/>
                  </a:lnTo>
                  <a:lnTo>
                    <a:pt x="1893" y="941"/>
                  </a:lnTo>
                  <a:lnTo>
                    <a:pt x="1898" y="941"/>
                  </a:lnTo>
                  <a:lnTo>
                    <a:pt x="1904" y="941"/>
                  </a:lnTo>
                  <a:lnTo>
                    <a:pt x="1909" y="941"/>
                  </a:lnTo>
                  <a:lnTo>
                    <a:pt x="1913" y="941"/>
                  </a:lnTo>
                  <a:lnTo>
                    <a:pt x="1918" y="941"/>
                  </a:lnTo>
                  <a:lnTo>
                    <a:pt x="1923" y="941"/>
                  </a:lnTo>
                  <a:lnTo>
                    <a:pt x="1928" y="941"/>
                  </a:lnTo>
                  <a:lnTo>
                    <a:pt x="1932" y="939"/>
                  </a:lnTo>
                  <a:lnTo>
                    <a:pt x="1938" y="939"/>
                  </a:lnTo>
                  <a:lnTo>
                    <a:pt x="1943" y="939"/>
                  </a:lnTo>
                  <a:lnTo>
                    <a:pt x="1948" y="939"/>
                  </a:lnTo>
                  <a:lnTo>
                    <a:pt x="1953" y="939"/>
                  </a:lnTo>
                  <a:lnTo>
                    <a:pt x="1957" y="939"/>
                  </a:lnTo>
                  <a:lnTo>
                    <a:pt x="1962" y="939"/>
                  </a:lnTo>
                  <a:lnTo>
                    <a:pt x="1968" y="939"/>
                  </a:lnTo>
                  <a:lnTo>
                    <a:pt x="1973" y="937"/>
                  </a:lnTo>
                  <a:lnTo>
                    <a:pt x="1977" y="937"/>
                  </a:lnTo>
                  <a:lnTo>
                    <a:pt x="1982" y="937"/>
                  </a:lnTo>
                  <a:lnTo>
                    <a:pt x="1987" y="937"/>
                  </a:lnTo>
                  <a:lnTo>
                    <a:pt x="1992" y="935"/>
                  </a:lnTo>
                  <a:lnTo>
                    <a:pt x="1996" y="935"/>
                  </a:lnTo>
                  <a:lnTo>
                    <a:pt x="2002" y="935"/>
                  </a:lnTo>
                  <a:lnTo>
                    <a:pt x="2007" y="935"/>
                  </a:lnTo>
                  <a:lnTo>
                    <a:pt x="2012" y="935"/>
                  </a:lnTo>
                  <a:lnTo>
                    <a:pt x="2016" y="933"/>
                  </a:lnTo>
                  <a:lnTo>
                    <a:pt x="2021" y="933"/>
                  </a:lnTo>
                  <a:lnTo>
                    <a:pt x="2026" y="931"/>
                  </a:lnTo>
                  <a:lnTo>
                    <a:pt x="2032" y="931"/>
                  </a:lnTo>
                  <a:lnTo>
                    <a:pt x="2036" y="931"/>
                  </a:lnTo>
                  <a:lnTo>
                    <a:pt x="2041" y="929"/>
                  </a:lnTo>
                  <a:lnTo>
                    <a:pt x="2046" y="929"/>
                  </a:lnTo>
                  <a:lnTo>
                    <a:pt x="2051" y="929"/>
                  </a:lnTo>
                  <a:lnTo>
                    <a:pt x="2055" y="929"/>
                  </a:lnTo>
                  <a:lnTo>
                    <a:pt x="2061" y="931"/>
                  </a:lnTo>
                  <a:lnTo>
                    <a:pt x="2066" y="931"/>
                  </a:lnTo>
                  <a:lnTo>
                    <a:pt x="2071" y="931"/>
                  </a:lnTo>
                  <a:lnTo>
                    <a:pt x="2075" y="931"/>
                  </a:lnTo>
                  <a:lnTo>
                    <a:pt x="2080" y="933"/>
                  </a:lnTo>
                  <a:lnTo>
                    <a:pt x="2085" y="933"/>
                  </a:lnTo>
                  <a:lnTo>
                    <a:pt x="2090" y="933"/>
                  </a:lnTo>
                  <a:lnTo>
                    <a:pt x="2095" y="933"/>
                  </a:lnTo>
                  <a:lnTo>
                    <a:pt x="2100" y="933"/>
                  </a:lnTo>
                  <a:lnTo>
                    <a:pt x="2105" y="933"/>
                  </a:lnTo>
                  <a:lnTo>
                    <a:pt x="2110" y="931"/>
                  </a:lnTo>
                  <a:lnTo>
                    <a:pt x="2114" y="931"/>
                  </a:lnTo>
                  <a:lnTo>
                    <a:pt x="2119" y="929"/>
                  </a:lnTo>
                  <a:lnTo>
                    <a:pt x="2125" y="928"/>
                  </a:lnTo>
                  <a:lnTo>
                    <a:pt x="2130" y="928"/>
                  </a:lnTo>
                  <a:lnTo>
                    <a:pt x="2134" y="926"/>
                  </a:lnTo>
                  <a:lnTo>
                    <a:pt x="2139" y="926"/>
                  </a:lnTo>
                  <a:lnTo>
                    <a:pt x="2144" y="926"/>
                  </a:lnTo>
                  <a:lnTo>
                    <a:pt x="2149" y="926"/>
                  </a:lnTo>
                  <a:lnTo>
                    <a:pt x="2155" y="926"/>
                  </a:lnTo>
                  <a:lnTo>
                    <a:pt x="2159" y="928"/>
                  </a:lnTo>
                  <a:lnTo>
                    <a:pt x="2164" y="928"/>
                  </a:lnTo>
                  <a:lnTo>
                    <a:pt x="2169" y="929"/>
                  </a:lnTo>
                  <a:lnTo>
                    <a:pt x="2174" y="929"/>
                  </a:lnTo>
                  <a:lnTo>
                    <a:pt x="2178" y="929"/>
                  </a:lnTo>
                  <a:lnTo>
                    <a:pt x="2183" y="929"/>
                  </a:lnTo>
                  <a:lnTo>
                    <a:pt x="2189" y="929"/>
                  </a:lnTo>
                  <a:lnTo>
                    <a:pt x="2194" y="929"/>
                  </a:lnTo>
                  <a:lnTo>
                    <a:pt x="2198" y="931"/>
                  </a:lnTo>
                  <a:lnTo>
                    <a:pt x="2203" y="931"/>
                  </a:lnTo>
                  <a:lnTo>
                    <a:pt x="2208" y="931"/>
                  </a:lnTo>
                  <a:lnTo>
                    <a:pt x="2213" y="931"/>
                  </a:lnTo>
                  <a:lnTo>
                    <a:pt x="2217" y="931"/>
                  </a:lnTo>
                  <a:lnTo>
                    <a:pt x="2223" y="931"/>
                  </a:lnTo>
                  <a:lnTo>
                    <a:pt x="2228" y="931"/>
                  </a:lnTo>
                  <a:lnTo>
                    <a:pt x="2233" y="931"/>
                  </a:lnTo>
                  <a:lnTo>
                    <a:pt x="2237" y="931"/>
                  </a:lnTo>
                  <a:lnTo>
                    <a:pt x="2242" y="931"/>
                  </a:lnTo>
                  <a:lnTo>
                    <a:pt x="2247" y="931"/>
                  </a:lnTo>
                  <a:lnTo>
                    <a:pt x="2253" y="931"/>
                  </a:lnTo>
                  <a:lnTo>
                    <a:pt x="2257" y="929"/>
                  </a:lnTo>
                  <a:lnTo>
                    <a:pt x="2262" y="929"/>
                  </a:lnTo>
                  <a:lnTo>
                    <a:pt x="2267" y="929"/>
                  </a:lnTo>
                  <a:lnTo>
                    <a:pt x="2272" y="929"/>
                  </a:lnTo>
                  <a:lnTo>
                    <a:pt x="2276" y="928"/>
                  </a:lnTo>
                  <a:lnTo>
                    <a:pt x="2282" y="928"/>
                  </a:lnTo>
                  <a:lnTo>
                    <a:pt x="2287" y="928"/>
                  </a:lnTo>
                  <a:lnTo>
                    <a:pt x="2292" y="926"/>
                  </a:lnTo>
                  <a:lnTo>
                    <a:pt x="2296" y="926"/>
                  </a:lnTo>
                  <a:lnTo>
                    <a:pt x="2301" y="926"/>
                  </a:lnTo>
                  <a:lnTo>
                    <a:pt x="2306" y="928"/>
                  </a:lnTo>
                  <a:lnTo>
                    <a:pt x="2311" y="928"/>
                  </a:lnTo>
                  <a:lnTo>
                    <a:pt x="2316" y="928"/>
                  </a:lnTo>
                  <a:lnTo>
                    <a:pt x="2321" y="928"/>
                  </a:lnTo>
                  <a:lnTo>
                    <a:pt x="2326" y="928"/>
                  </a:lnTo>
                  <a:lnTo>
                    <a:pt x="2331" y="928"/>
                  </a:lnTo>
                  <a:lnTo>
                    <a:pt x="2335" y="928"/>
                  </a:lnTo>
                  <a:lnTo>
                    <a:pt x="2340" y="928"/>
                  </a:lnTo>
                  <a:lnTo>
                    <a:pt x="2346" y="928"/>
                  </a:lnTo>
                  <a:lnTo>
                    <a:pt x="2351" y="928"/>
                  </a:lnTo>
                  <a:lnTo>
                    <a:pt x="2356" y="928"/>
                  </a:lnTo>
                  <a:lnTo>
                    <a:pt x="2360" y="928"/>
                  </a:lnTo>
                  <a:lnTo>
                    <a:pt x="2365" y="928"/>
                  </a:lnTo>
                  <a:lnTo>
                    <a:pt x="2370" y="928"/>
                  </a:lnTo>
                  <a:lnTo>
                    <a:pt x="2375" y="928"/>
                  </a:lnTo>
                  <a:lnTo>
                    <a:pt x="2380" y="928"/>
                  </a:lnTo>
                  <a:lnTo>
                    <a:pt x="2385" y="928"/>
                  </a:lnTo>
                  <a:lnTo>
                    <a:pt x="2390" y="928"/>
                  </a:lnTo>
                  <a:lnTo>
                    <a:pt x="2395" y="926"/>
                  </a:lnTo>
                  <a:lnTo>
                    <a:pt x="2399" y="926"/>
                  </a:lnTo>
                  <a:lnTo>
                    <a:pt x="2404" y="926"/>
                  </a:lnTo>
                  <a:lnTo>
                    <a:pt x="2410" y="926"/>
                  </a:lnTo>
                  <a:lnTo>
                    <a:pt x="2415" y="924"/>
                  </a:lnTo>
                  <a:lnTo>
                    <a:pt x="2419" y="924"/>
                  </a:lnTo>
                  <a:lnTo>
                    <a:pt x="2424" y="922"/>
                  </a:lnTo>
                  <a:lnTo>
                    <a:pt x="2429" y="922"/>
                  </a:lnTo>
                  <a:lnTo>
                    <a:pt x="2434" y="920"/>
                  </a:lnTo>
                  <a:lnTo>
                    <a:pt x="2438" y="916"/>
                  </a:lnTo>
                  <a:lnTo>
                    <a:pt x="2444" y="912"/>
                  </a:lnTo>
                  <a:lnTo>
                    <a:pt x="2449" y="906"/>
                  </a:lnTo>
                  <a:lnTo>
                    <a:pt x="2454" y="903"/>
                  </a:lnTo>
                  <a:lnTo>
                    <a:pt x="2458" y="899"/>
                  </a:lnTo>
                  <a:lnTo>
                    <a:pt x="2463" y="895"/>
                  </a:lnTo>
                  <a:lnTo>
                    <a:pt x="2468" y="893"/>
                  </a:lnTo>
                  <a:lnTo>
                    <a:pt x="2474" y="893"/>
                  </a:lnTo>
                  <a:lnTo>
                    <a:pt x="2478" y="893"/>
                  </a:lnTo>
                  <a:lnTo>
                    <a:pt x="2483" y="893"/>
                  </a:lnTo>
                  <a:lnTo>
                    <a:pt x="2488" y="891"/>
                  </a:lnTo>
                  <a:lnTo>
                    <a:pt x="2493" y="887"/>
                  </a:lnTo>
                  <a:lnTo>
                    <a:pt x="2497" y="883"/>
                  </a:lnTo>
                  <a:lnTo>
                    <a:pt x="2503" y="878"/>
                  </a:lnTo>
                  <a:lnTo>
                    <a:pt x="2508" y="872"/>
                  </a:lnTo>
                  <a:lnTo>
                    <a:pt x="2513" y="868"/>
                  </a:lnTo>
                  <a:lnTo>
                    <a:pt x="2517" y="866"/>
                  </a:lnTo>
                  <a:lnTo>
                    <a:pt x="2522" y="868"/>
                  </a:lnTo>
                  <a:lnTo>
                    <a:pt x="2527" y="872"/>
                  </a:lnTo>
                  <a:lnTo>
                    <a:pt x="2532" y="878"/>
                  </a:lnTo>
                  <a:lnTo>
                    <a:pt x="2537" y="885"/>
                  </a:lnTo>
                  <a:lnTo>
                    <a:pt x="2542" y="891"/>
                  </a:lnTo>
                  <a:lnTo>
                    <a:pt x="2547" y="895"/>
                  </a:lnTo>
                  <a:lnTo>
                    <a:pt x="2552" y="901"/>
                  </a:lnTo>
                  <a:lnTo>
                    <a:pt x="2556" y="905"/>
                  </a:lnTo>
                  <a:lnTo>
                    <a:pt x="2561" y="906"/>
                  </a:lnTo>
                  <a:lnTo>
                    <a:pt x="2567" y="910"/>
                  </a:lnTo>
                  <a:lnTo>
                    <a:pt x="2572" y="912"/>
                  </a:lnTo>
                  <a:lnTo>
                    <a:pt x="2577" y="914"/>
                  </a:lnTo>
                  <a:lnTo>
                    <a:pt x="2581" y="916"/>
                  </a:lnTo>
                  <a:lnTo>
                    <a:pt x="2586" y="916"/>
                  </a:lnTo>
                  <a:lnTo>
                    <a:pt x="2591" y="918"/>
                  </a:lnTo>
                  <a:lnTo>
                    <a:pt x="2596" y="918"/>
                  </a:lnTo>
                  <a:lnTo>
                    <a:pt x="2601" y="918"/>
                  </a:lnTo>
                  <a:lnTo>
                    <a:pt x="2606" y="920"/>
                  </a:lnTo>
                  <a:lnTo>
                    <a:pt x="2611" y="920"/>
                  </a:lnTo>
                  <a:lnTo>
                    <a:pt x="2616" y="920"/>
                  </a:lnTo>
                  <a:lnTo>
                    <a:pt x="2620" y="920"/>
                  </a:lnTo>
                  <a:lnTo>
                    <a:pt x="2625" y="920"/>
                  </a:lnTo>
                  <a:lnTo>
                    <a:pt x="2631" y="920"/>
                  </a:lnTo>
                  <a:lnTo>
                    <a:pt x="2636" y="918"/>
                  </a:lnTo>
                  <a:lnTo>
                    <a:pt x="2640" y="918"/>
                  </a:lnTo>
                  <a:lnTo>
                    <a:pt x="2645" y="918"/>
                  </a:lnTo>
                  <a:lnTo>
                    <a:pt x="2650" y="918"/>
                  </a:lnTo>
                  <a:lnTo>
                    <a:pt x="2655" y="918"/>
                  </a:lnTo>
                  <a:lnTo>
                    <a:pt x="2659" y="918"/>
                  </a:lnTo>
                  <a:lnTo>
                    <a:pt x="2665" y="918"/>
                  </a:lnTo>
                  <a:lnTo>
                    <a:pt x="2670" y="918"/>
                  </a:lnTo>
                  <a:lnTo>
                    <a:pt x="2675" y="918"/>
                  </a:lnTo>
                  <a:lnTo>
                    <a:pt x="2679" y="918"/>
                  </a:lnTo>
                  <a:lnTo>
                    <a:pt x="2684" y="918"/>
                  </a:lnTo>
                  <a:lnTo>
                    <a:pt x="2689" y="918"/>
                  </a:lnTo>
                  <a:lnTo>
                    <a:pt x="2695" y="918"/>
                  </a:lnTo>
                  <a:lnTo>
                    <a:pt x="2699" y="918"/>
                  </a:lnTo>
                  <a:lnTo>
                    <a:pt x="2704" y="918"/>
                  </a:lnTo>
                  <a:lnTo>
                    <a:pt x="2709" y="918"/>
                  </a:lnTo>
                  <a:lnTo>
                    <a:pt x="2714" y="918"/>
                  </a:lnTo>
                  <a:lnTo>
                    <a:pt x="2718" y="918"/>
                  </a:lnTo>
                  <a:lnTo>
                    <a:pt x="2724" y="918"/>
                  </a:lnTo>
                  <a:lnTo>
                    <a:pt x="2729" y="918"/>
                  </a:lnTo>
                  <a:lnTo>
                    <a:pt x="2734" y="918"/>
                  </a:lnTo>
                  <a:lnTo>
                    <a:pt x="2738" y="918"/>
                  </a:lnTo>
                  <a:lnTo>
                    <a:pt x="2743" y="918"/>
                  </a:lnTo>
                  <a:lnTo>
                    <a:pt x="2748" y="918"/>
                  </a:lnTo>
                  <a:lnTo>
                    <a:pt x="2753" y="918"/>
                  </a:lnTo>
                  <a:lnTo>
                    <a:pt x="2758" y="918"/>
                  </a:lnTo>
                  <a:lnTo>
                    <a:pt x="2763" y="918"/>
                  </a:lnTo>
                  <a:lnTo>
                    <a:pt x="2768" y="918"/>
                  </a:lnTo>
                  <a:lnTo>
                    <a:pt x="2773" y="916"/>
                  </a:lnTo>
                  <a:lnTo>
                    <a:pt x="2778" y="916"/>
                  </a:lnTo>
                  <a:lnTo>
                    <a:pt x="2782" y="916"/>
                  </a:lnTo>
                  <a:lnTo>
                    <a:pt x="2788" y="916"/>
                  </a:lnTo>
                  <a:lnTo>
                    <a:pt x="2793" y="914"/>
                  </a:lnTo>
                  <a:lnTo>
                    <a:pt x="2798" y="914"/>
                  </a:lnTo>
                  <a:lnTo>
                    <a:pt x="2802" y="914"/>
                  </a:lnTo>
                  <a:lnTo>
                    <a:pt x="2807" y="914"/>
                  </a:lnTo>
                  <a:lnTo>
                    <a:pt x="2812" y="914"/>
                  </a:lnTo>
                  <a:lnTo>
                    <a:pt x="2817" y="914"/>
                  </a:lnTo>
                  <a:lnTo>
                    <a:pt x="2822" y="914"/>
                  </a:lnTo>
                  <a:lnTo>
                    <a:pt x="2827" y="914"/>
                  </a:lnTo>
                  <a:lnTo>
                    <a:pt x="2832" y="914"/>
                  </a:lnTo>
                  <a:lnTo>
                    <a:pt x="2837" y="914"/>
                  </a:lnTo>
                  <a:lnTo>
                    <a:pt x="2841" y="914"/>
                  </a:lnTo>
                  <a:lnTo>
                    <a:pt x="2846" y="912"/>
                  </a:lnTo>
                  <a:lnTo>
                    <a:pt x="2852" y="912"/>
                  </a:lnTo>
                  <a:lnTo>
                    <a:pt x="2857" y="910"/>
                  </a:lnTo>
                  <a:lnTo>
                    <a:pt x="2861" y="910"/>
                  </a:lnTo>
                  <a:lnTo>
                    <a:pt x="2866" y="908"/>
                  </a:lnTo>
                  <a:lnTo>
                    <a:pt x="2871" y="906"/>
                  </a:lnTo>
                  <a:lnTo>
                    <a:pt x="2876" y="906"/>
                  </a:lnTo>
                  <a:lnTo>
                    <a:pt x="2880" y="906"/>
                  </a:lnTo>
                  <a:lnTo>
                    <a:pt x="2886" y="906"/>
                  </a:lnTo>
                  <a:lnTo>
                    <a:pt x="2891" y="906"/>
                  </a:lnTo>
                  <a:lnTo>
                    <a:pt x="2896" y="906"/>
                  </a:lnTo>
                  <a:lnTo>
                    <a:pt x="2900" y="906"/>
                  </a:lnTo>
                  <a:lnTo>
                    <a:pt x="2905" y="906"/>
                  </a:lnTo>
                  <a:lnTo>
                    <a:pt x="2910" y="906"/>
                  </a:lnTo>
                  <a:lnTo>
                    <a:pt x="2916" y="906"/>
                  </a:lnTo>
                  <a:lnTo>
                    <a:pt x="2920" y="906"/>
                  </a:lnTo>
                  <a:lnTo>
                    <a:pt x="2925" y="908"/>
                  </a:lnTo>
                  <a:lnTo>
                    <a:pt x="2930" y="908"/>
                  </a:lnTo>
                  <a:lnTo>
                    <a:pt x="2935" y="908"/>
                  </a:lnTo>
                  <a:lnTo>
                    <a:pt x="2939" y="908"/>
                  </a:lnTo>
                  <a:lnTo>
                    <a:pt x="2945" y="908"/>
                  </a:lnTo>
                  <a:lnTo>
                    <a:pt x="2950" y="908"/>
                  </a:lnTo>
                  <a:lnTo>
                    <a:pt x="2955" y="908"/>
                  </a:lnTo>
                  <a:lnTo>
                    <a:pt x="2959" y="908"/>
                  </a:lnTo>
                  <a:lnTo>
                    <a:pt x="2964" y="908"/>
                  </a:lnTo>
                  <a:lnTo>
                    <a:pt x="2969" y="908"/>
                  </a:lnTo>
                  <a:lnTo>
                    <a:pt x="2974" y="908"/>
                  </a:lnTo>
                  <a:lnTo>
                    <a:pt x="2980" y="908"/>
                  </a:lnTo>
                  <a:lnTo>
                    <a:pt x="2984" y="908"/>
                  </a:lnTo>
                  <a:lnTo>
                    <a:pt x="2989" y="908"/>
                  </a:lnTo>
                  <a:lnTo>
                    <a:pt x="2994" y="908"/>
                  </a:lnTo>
                  <a:lnTo>
                    <a:pt x="2999" y="908"/>
                  </a:lnTo>
                  <a:lnTo>
                    <a:pt x="3003" y="908"/>
                  </a:lnTo>
                  <a:lnTo>
                    <a:pt x="3009" y="908"/>
                  </a:lnTo>
                  <a:lnTo>
                    <a:pt x="3014" y="906"/>
                  </a:lnTo>
                  <a:lnTo>
                    <a:pt x="3019" y="908"/>
                  </a:lnTo>
                  <a:lnTo>
                    <a:pt x="3023" y="906"/>
                  </a:lnTo>
                  <a:lnTo>
                    <a:pt x="3028" y="906"/>
                  </a:lnTo>
                  <a:lnTo>
                    <a:pt x="3033" y="906"/>
                  </a:lnTo>
                  <a:lnTo>
                    <a:pt x="3038" y="905"/>
                  </a:lnTo>
                  <a:lnTo>
                    <a:pt x="3043" y="903"/>
                  </a:lnTo>
                  <a:lnTo>
                    <a:pt x="3048" y="901"/>
                  </a:lnTo>
                  <a:lnTo>
                    <a:pt x="3053" y="895"/>
                  </a:lnTo>
                  <a:lnTo>
                    <a:pt x="3058" y="889"/>
                  </a:lnTo>
                  <a:lnTo>
                    <a:pt x="3062" y="882"/>
                  </a:lnTo>
                  <a:lnTo>
                    <a:pt x="3067" y="872"/>
                  </a:lnTo>
                  <a:lnTo>
                    <a:pt x="3073" y="864"/>
                  </a:lnTo>
                  <a:lnTo>
                    <a:pt x="3078" y="857"/>
                  </a:lnTo>
                  <a:lnTo>
                    <a:pt x="3082" y="853"/>
                  </a:lnTo>
                  <a:lnTo>
                    <a:pt x="3087" y="853"/>
                  </a:lnTo>
                  <a:lnTo>
                    <a:pt x="3092" y="855"/>
                  </a:lnTo>
                  <a:lnTo>
                    <a:pt x="3097" y="858"/>
                  </a:lnTo>
                  <a:lnTo>
                    <a:pt x="3101" y="864"/>
                  </a:lnTo>
                  <a:lnTo>
                    <a:pt x="3107" y="870"/>
                  </a:lnTo>
                  <a:lnTo>
                    <a:pt x="3112" y="876"/>
                  </a:lnTo>
                  <a:lnTo>
                    <a:pt x="3117" y="880"/>
                  </a:lnTo>
                  <a:lnTo>
                    <a:pt x="3121" y="883"/>
                  </a:lnTo>
                  <a:lnTo>
                    <a:pt x="3126" y="887"/>
                  </a:lnTo>
                  <a:lnTo>
                    <a:pt x="3131" y="889"/>
                  </a:lnTo>
                  <a:lnTo>
                    <a:pt x="3137" y="893"/>
                  </a:lnTo>
                  <a:lnTo>
                    <a:pt x="3141" y="895"/>
                  </a:lnTo>
                  <a:lnTo>
                    <a:pt x="3146" y="897"/>
                  </a:lnTo>
                  <a:lnTo>
                    <a:pt x="3151" y="899"/>
                  </a:lnTo>
                  <a:lnTo>
                    <a:pt x="3156" y="899"/>
                  </a:lnTo>
                  <a:lnTo>
                    <a:pt x="3160" y="901"/>
                  </a:lnTo>
                  <a:lnTo>
                    <a:pt x="3166" y="901"/>
                  </a:lnTo>
                  <a:lnTo>
                    <a:pt x="3171" y="901"/>
                  </a:lnTo>
                  <a:lnTo>
                    <a:pt x="3176" y="901"/>
                  </a:lnTo>
                  <a:lnTo>
                    <a:pt x="3181" y="899"/>
                  </a:lnTo>
                  <a:lnTo>
                    <a:pt x="3185" y="899"/>
                  </a:lnTo>
                  <a:lnTo>
                    <a:pt x="3190" y="897"/>
                  </a:lnTo>
                  <a:lnTo>
                    <a:pt x="3195" y="895"/>
                  </a:lnTo>
                  <a:lnTo>
                    <a:pt x="3201" y="893"/>
                  </a:lnTo>
                  <a:lnTo>
                    <a:pt x="3205" y="889"/>
                  </a:lnTo>
                  <a:lnTo>
                    <a:pt x="3210" y="885"/>
                  </a:lnTo>
                  <a:lnTo>
                    <a:pt x="3215" y="882"/>
                  </a:lnTo>
                  <a:lnTo>
                    <a:pt x="3220" y="876"/>
                  </a:lnTo>
                  <a:lnTo>
                    <a:pt x="3224" y="870"/>
                  </a:lnTo>
                  <a:lnTo>
                    <a:pt x="3230" y="866"/>
                  </a:lnTo>
                  <a:lnTo>
                    <a:pt x="3235" y="864"/>
                  </a:lnTo>
                  <a:lnTo>
                    <a:pt x="3240" y="864"/>
                  </a:lnTo>
                  <a:lnTo>
                    <a:pt x="3244" y="866"/>
                  </a:lnTo>
                  <a:lnTo>
                    <a:pt x="3249" y="870"/>
                  </a:lnTo>
                  <a:lnTo>
                    <a:pt x="3254" y="874"/>
                  </a:lnTo>
                  <a:lnTo>
                    <a:pt x="3259" y="878"/>
                  </a:lnTo>
                  <a:lnTo>
                    <a:pt x="3264" y="880"/>
                  </a:lnTo>
                  <a:lnTo>
                    <a:pt x="3269" y="883"/>
                  </a:lnTo>
                  <a:lnTo>
                    <a:pt x="3274" y="885"/>
                  </a:lnTo>
                  <a:lnTo>
                    <a:pt x="3279" y="887"/>
                  </a:lnTo>
                  <a:lnTo>
                    <a:pt x="3283" y="887"/>
                  </a:lnTo>
                  <a:lnTo>
                    <a:pt x="3288" y="889"/>
                  </a:lnTo>
                  <a:lnTo>
                    <a:pt x="3294" y="889"/>
                  </a:lnTo>
                  <a:lnTo>
                    <a:pt x="3299" y="889"/>
                  </a:lnTo>
                  <a:lnTo>
                    <a:pt x="3303" y="887"/>
                  </a:lnTo>
                  <a:lnTo>
                    <a:pt x="3308" y="885"/>
                  </a:lnTo>
                  <a:lnTo>
                    <a:pt x="3313" y="883"/>
                  </a:lnTo>
                  <a:lnTo>
                    <a:pt x="3318" y="880"/>
                  </a:lnTo>
                  <a:lnTo>
                    <a:pt x="3322" y="874"/>
                  </a:lnTo>
                  <a:lnTo>
                    <a:pt x="3328" y="866"/>
                  </a:lnTo>
                  <a:lnTo>
                    <a:pt x="3333" y="857"/>
                  </a:lnTo>
                  <a:lnTo>
                    <a:pt x="3338" y="847"/>
                  </a:lnTo>
                  <a:lnTo>
                    <a:pt x="3342" y="832"/>
                  </a:lnTo>
                  <a:lnTo>
                    <a:pt x="3347" y="816"/>
                  </a:lnTo>
                  <a:lnTo>
                    <a:pt x="3352" y="799"/>
                  </a:lnTo>
                  <a:lnTo>
                    <a:pt x="3358" y="782"/>
                  </a:lnTo>
                  <a:lnTo>
                    <a:pt x="3362" y="763"/>
                  </a:lnTo>
                  <a:lnTo>
                    <a:pt x="3367" y="741"/>
                  </a:lnTo>
                  <a:lnTo>
                    <a:pt x="3372" y="722"/>
                  </a:lnTo>
                  <a:lnTo>
                    <a:pt x="3377" y="703"/>
                  </a:lnTo>
                  <a:lnTo>
                    <a:pt x="3382" y="684"/>
                  </a:lnTo>
                  <a:lnTo>
                    <a:pt x="3387" y="667"/>
                  </a:lnTo>
                  <a:lnTo>
                    <a:pt x="3392" y="651"/>
                  </a:lnTo>
                  <a:lnTo>
                    <a:pt x="3397" y="638"/>
                  </a:lnTo>
                  <a:lnTo>
                    <a:pt x="3402" y="628"/>
                  </a:lnTo>
                  <a:lnTo>
                    <a:pt x="3406" y="622"/>
                  </a:lnTo>
                  <a:lnTo>
                    <a:pt x="3411" y="620"/>
                  </a:lnTo>
                  <a:lnTo>
                    <a:pt x="3416" y="620"/>
                  </a:lnTo>
                  <a:lnTo>
                    <a:pt x="3422" y="624"/>
                  </a:lnTo>
                  <a:lnTo>
                    <a:pt x="3426" y="630"/>
                  </a:lnTo>
                  <a:lnTo>
                    <a:pt x="3431" y="638"/>
                  </a:lnTo>
                  <a:lnTo>
                    <a:pt x="3436" y="645"/>
                  </a:lnTo>
                  <a:lnTo>
                    <a:pt x="3441" y="655"/>
                  </a:lnTo>
                  <a:lnTo>
                    <a:pt x="3445" y="663"/>
                  </a:lnTo>
                  <a:lnTo>
                    <a:pt x="3451" y="672"/>
                  </a:lnTo>
                  <a:lnTo>
                    <a:pt x="3456" y="682"/>
                  </a:lnTo>
                  <a:lnTo>
                    <a:pt x="3461" y="690"/>
                  </a:lnTo>
                  <a:lnTo>
                    <a:pt x="3465" y="699"/>
                  </a:lnTo>
                  <a:lnTo>
                    <a:pt x="3470" y="705"/>
                  </a:lnTo>
                  <a:lnTo>
                    <a:pt x="3475" y="713"/>
                  </a:lnTo>
                  <a:lnTo>
                    <a:pt x="3480" y="720"/>
                  </a:lnTo>
                  <a:lnTo>
                    <a:pt x="3485" y="726"/>
                  </a:lnTo>
                  <a:lnTo>
                    <a:pt x="3490" y="732"/>
                  </a:lnTo>
                  <a:lnTo>
                    <a:pt x="3495" y="736"/>
                  </a:lnTo>
                  <a:lnTo>
                    <a:pt x="3500" y="741"/>
                  </a:lnTo>
                  <a:lnTo>
                    <a:pt x="3504" y="745"/>
                  </a:lnTo>
                  <a:lnTo>
                    <a:pt x="3509" y="749"/>
                  </a:lnTo>
                  <a:lnTo>
                    <a:pt x="3515" y="753"/>
                  </a:lnTo>
                  <a:lnTo>
                    <a:pt x="3520" y="757"/>
                  </a:lnTo>
                  <a:lnTo>
                    <a:pt x="3524" y="761"/>
                  </a:lnTo>
                  <a:lnTo>
                    <a:pt x="3529" y="764"/>
                  </a:lnTo>
                  <a:lnTo>
                    <a:pt x="3534" y="768"/>
                  </a:lnTo>
                  <a:lnTo>
                    <a:pt x="3539" y="770"/>
                  </a:lnTo>
                  <a:lnTo>
                    <a:pt x="3543" y="774"/>
                  </a:lnTo>
                  <a:lnTo>
                    <a:pt x="3549" y="778"/>
                  </a:lnTo>
                  <a:lnTo>
                    <a:pt x="3554" y="780"/>
                  </a:lnTo>
                  <a:lnTo>
                    <a:pt x="3559" y="782"/>
                  </a:lnTo>
                  <a:lnTo>
                    <a:pt x="3563" y="786"/>
                  </a:lnTo>
                  <a:lnTo>
                    <a:pt x="3568" y="787"/>
                  </a:lnTo>
                  <a:lnTo>
                    <a:pt x="3573" y="791"/>
                  </a:lnTo>
                  <a:lnTo>
                    <a:pt x="3579" y="793"/>
                  </a:lnTo>
                  <a:lnTo>
                    <a:pt x="3584" y="795"/>
                  </a:lnTo>
                  <a:lnTo>
                    <a:pt x="3588" y="797"/>
                  </a:lnTo>
                  <a:lnTo>
                    <a:pt x="3593" y="799"/>
                  </a:lnTo>
                  <a:lnTo>
                    <a:pt x="3598" y="801"/>
                  </a:lnTo>
                  <a:lnTo>
                    <a:pt x="3603" y="803"/>
                  </a:lnTo>
                  <a:lnTo>
                    <a:pt x="3608" y="805"/>
                  </a:lnTo>
                  <a:lnTo>
                    <a:pt x="3613" y="807"/>
                  </a:lnTo>
                  <a:lnTo>
                    <a:pt x="3618" y="809"/>
                  </a:lnTo>
                  <a:lnTo>
                    <a:pt x="3623" y="810"/>
                  </a:lnTo>
                  <a:lnTo>
                    <a:pt x="3627" y="812"/>
                  </a:lnTo>
                  <a:lnTo>
                    <a:pt x="3632" y="814"/>
                  </a:lnTo>
                  <a:lnTo>
                    <a:pt x="3637" y="816"/>
                  </a:lnTo>
                  <a:lnTo>
                    <a:pt x="3643" y="816"/>
                  </a:lnTo>
                  <a:lnTo>
                    <a:pt x="3647" y="818"/>
                  </a:lnTo>
                  <a:lnTo>
                    <a:pt x="3652" y="820"/>
                  </a:lnTo>
                  <a:lnTo>
                    <a:pt x="3657" y="820"/>
                  </a:lnTo>
                  <a:lnTo>
                    <a:pt x="3662" y="822"/>
                  </a:lnTo>
                  <a:lnTo>
                    <a:pt x="3666" y="824"/>
                  </a:lnTo>
                  <a:lnTo>
                    <a:pt x="3672" y="824"/>
                  </a:lnTo>
                  <a:lnTo>
                    <a:pt x="3677" y="826"/>
                  </a:lnTo>
                  <a:lnTo>
                    <a:pt x="3682" y="828"/>
                  </a:lnTo>
                  <a:lnTo>
                    <a:pt x="3685" y="82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5" name="Rectangle 271">
              <a:extLst>
                <a:ext uri="{FF2B5EF4-FFF2-40B4-BE49-F238E27FC236}">
                  <a16:creationId xmlns:a16="http://schemas.microsoft.com/office/drawing/2014/main" id="{7D4A1D32-4735-1FCB-CE30-D939747EB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417" y="2219517"/>
              <a:ext cx="4475280" cy="85725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A2DD6D6-66A7-1D78-AE7E-6316C2926F7E}"/>
                </a:ext>
              </a:extLst>
            </p:cNvPr>
            <p:cNvSpPr txBox="1"/>
            <p:nvPr/>
          </p:nvSpPr>
          <p:spPr>
            <a:xfrm>
              <a:off x="801762" y="2648007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R1</a:t>
              </a:r>
              <a:endParaRPr kumimoji="1" lang="ja-JP" altLang="en-US" sz="1050" dirty="0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A65B1F17-D3CF-7D60-91BE-92E017EEE6DA}"/>
                </a:ext>
              </a:extLst>
            </p:cNvPr>
            <p:cNvSpPr txBox="1"/>
            <p:nvPr/>
          </p:nvSpPr>
          <p:spPr>
            <a:xfrm>
              <a:off x="975498" y="2683059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R2</a:t>
              </a:r>
              <a:endParaRPr kumimoji="1" lang="ja-JP" altLang="en-US" sz="1050" dirty="0"/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9D6D3E68-B888-77F7-D158-A1E067848EB9}"/>
                </a:ext>
              </a:extLst>
            </p:cNvPr>
            <p:cNvSpPr txBox="1"/>
            <p:nvPr/>
          </p:nvSpPr>
          <p:spPr>
            <a:xfrm>
              <a:off x="1899042" y="2747216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A1</a:t>
              </a:r>
              <a:endParaRPr kumimoji="1" lang="ja-JP" altLang="en-US" sz="1050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F264E1BF-A940-F455-8051-6EBB8C5EA571}"/>
                </a:ext>
              </a:extLst>
            </p:cNvPr>
            <p:cNvSpPr txBox="1"/>
            <p:nvPr/>
          </p:nvSpPr>
          <p:spPr>
            <a:xfrm>
              <a:off x="2859162" y="2747216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A2</a:t>
              </a:r>
              <a:endParaRPr kumimoji="1" lang="ja-JP" altLang="en-US" sz="1050" dirty="0"/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E74093B9-49F2-ECA4-812D-3477671D3B23}"/>
                </a:ext>
              </a:extLst>
            </p:cNvPr>
            <p:cNvSpPr txBox="1"/>
            <p:nvPr/>
          </p:nvSpPr>
          <p:spPr>
            <a:xfrm>
              <a:off x="3738414" y="2718033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A3</a:t>
              </a:r>
              <a:endParaRPr kumimoji="1" lang="ja-JP" altLang="en-US" sz="1050" dirty="0"/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4A15202F-6330-4720-DEA5-30590A722FB0}"/>
                </a:ext>
              </a:extLst>
            </p:cNvPr>
            <p:cNvSpPr txBox="1"/>
            <p:nvPr/>
          </p:nvSpPr>
          <p:spPr>
            <a:xfrm>
              <a:off x="4423167" y="2701496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A4</a:t>
              </a:r>
              <a:endParaRPr kumimoji="1" lang="ja-JP" altLang="en-US" sz="1050" dirty="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C7F3CA06-3079-1C1A-34BC-087466AA83C4}"/>
                </a:ext>
              </a:extLst>
            </p:cNvPr>
            <p:cNvSpPr txBox="1"/>
            <p:nvPr/>
          </p:nvSpPr>
          <p:spPr>
            <a:xfrm>
              <a:off x="4615329" y="2709116"/>
              <a:ext cx="3843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A5</a:t>
              </a:r>
              <a:endParaRPr kumimoji="1" lang="ja-JP" altLang="en-US" sz="1050" dirty="0"/>
            </a:p>
          </p:txBody>
        </p:sp>
        <p:sp>
          <p:nvSpPr>
            <p:cNvPr id="63" name="Rectangle 237">
              <a:extLst>
                <a:ext uri="{FF2B5EF4-FFF2-40B4-BE49-F238E27FC236}">
                  <a16:creationId xmlns:a16="http://schemas.microsoft.com/office/drawing/2014/main" id="{85EAB10F-098D-5063-E1BC-EF62BE675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4078" y="31339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ea typeface="ＭＳ ゴシック" charset="-128"/>
                </a:rPr>
                <a:t>14</a:t>
              </a:r>
              <a:endParaRPr lang="en-US" altLang="ja-JP" dirty="0"/>
            </a:p>
          </p:txBody>
        </p:sp>
        <p:sp>
          <p:nvSpPr>
            <p:cNvPr id="64" name="Rectangle 85">
              <a:extLst>
                <a:ext uri="{FF2B5EF4-FFF2-40B4-BE49-F238E27FC236}">
                  <a16:creationId xmlns:a16="http://schemas.microsoft.com/office/drawing/2014/main" id="{CF31F498-36FB-A552-A1FE-C9F3C99995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53554" y="2481364"/>
              <a:ext cx="58509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700" dirty="0" err="1">
                  <a:solidFill>
                    <a:srgbClr val="000000"/>
                  </a:solidFill>
                  <a:latin typeface="+mn-lt"/>
                  <a:ea typeface="ＭＳ ゴシック" panose="020B0609070205080204" pitchFamily="49" charset="-128"/>
                </a:rPr>
                <a:t>mAU</a:t>
              </a:r>
              <a:r>
                <a:rPr lang="en-US" altLang="ja-JP" sz="700" dirty="0">
                  <a:solidFill>
                    <a:srgbClr val="000000"/>
                  </a:solidFill>
                  <a:latin typeface="+mn-lt"/>
                  <a:ea typeface="ＭＳ ゴシック" panose="020B0609070205080204" pitchFamily="49" charset="-128"/>
                </a:rPr>
                <a:t> (220 nm)</a:t>
              </a:r>
              <a:endParaRPr lang="en-US" altLang="ja-JP" sz="1600" dirty="0">
                <a:latin typeface="+mn-lt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548DC1E0-3C5E-A9B4-5D97-536CC7A6F8F3}"/>
                </a:ext>
              </a:extLst>
            </p:cNvPr>
            <p:cNvSpPr txBox="1"/>
            <p:nvPr/>
          </p:nvSpPr>
          <p:spPr>
            <a:xfrm>
              <a:off x="1317976" y="2241539"/>
              <a:ext cx="75077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RYGSG</a:t>
              </a:r>
              <a:endParaRPr kumimoji="1" lang="ja-JP" altLang="en-US" sz="1050" dirty="0"/>
            </a:p>
          </p:txBody>
        </p:sp>
        <p:sp>
          <p:nvSpPr>
            <p:cNvPr id="66" name="テキスト ボックス 2">
              <a:extLst>
                <a:ext uri="{FF2B5EF4-FFF2-40B4-BE49-F238E27FC236}">
                  <a16:creationId xmlns:a16="http://schemas.microsoft.com/office/drawing/2014/main" id="{348C0C35-33F0-F046-994B-D791D1DC6F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6611" y="1915551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ja-JP" sz="1200" dirty="0"/>
                <a:t>(a)</a:t>
              </a:r>
              <a:endParaRPr lang="ja-JP" altLang="en-US" sz="1200" dirty="0"/>
            </a:p>
          </p:txBody>
        </p:sp>
      </p:grp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CF8AC331-FB18-5825-5FA2-70F910DF76F4}"/>
              </a:ext>
            </a:extLst>
          </p:cNvPr>
          <p:cNvSpPr txBox="1"/>
          <p:nvPr/>
        </p:nvSpPr>
        <p:spPr>
          <a:xfrm>
            <a:off x="627698" y="5014009"/>
            <a:ext cx="798576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Identification of cleavage sites of A</a:t>
            </a:r>
            <a:r>
              <a:rPr kumimoji="1" lang="el-GR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-29 by RYGSG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ach peak were corrected and applied MS analysis to determine the cleavage site. (b) Peaks R1-2 and A1-5 were identified as the fragment peptides of Aβ11-29 and RYGSG, respectively, by MS analysis on 2 days.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2566310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Line 181">
            <a:extLst>
              <a:ext uri="{FF2B5EF4-FFF2-40B4-BE49-F238E27FC236}">
                <a16:creationId xmlns:a16="http://schemas.microsoft.com/office/drawing/2014/main" id="{60576964-17C6-00DD-7595-EDE7EFB672BD}"/>
              </a:ext>
            </a:extLst>
          </p:cNvPr>
          <p:cNvSpPr>
            <a:spLocks noChangeShapeType="1"/>
          </p:cNvSpPr>
          <p:nvPr/>
        </p:nvSpPr>
        <p:spPr bwMode="auto">
          <a:xfrm>
            <a:off x="864117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" name="Line 186">
            <a:extLst>
              <a:ext uri="{FF2B5EF4-FFF2-40B4-BE49-F238E27FC236}">
                <a16:creationId xmlns:a16="http://schemas.microsoft.com/office/drawing/2014/main" id="{DB59C8CB-CCF2-486B-55BA-85FA37893965}"/>
              </a:ext>
            </a:extLst>
          </p:cNvPr>
          <p:cNvSpPr>
            <a:spLocks noChangeShapeType="1"/>
          </p:cNvSpPr>
          <p:nvPr/>
        </p:nvSpPr>
        <p:spPr bwMode="auto">
          <a:xfrm>
            <a:off x="1421251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6" name="Line 191">
            <a:extLst>
              <a:ext uri="{FF2B5EF4-FFF2-40B4-BE49-F238E27FC236}">
                <a16:creationId xmlns:a16="http://schemas.microsoft.com/office/drawing/2014/main" id="{1A361E60-4228-FBCF-5C1E-38EAAF9DB2C5}"/>
              </a:ext>
            </a:extLst>
          </p:cNvPr>
          <p:cNvSpPr>
            <a:spLocks noChangeShapeType="1"/>
          </p:cNvSpPr>
          <p:nvPr/>
        </p:nvSpPr>
        <p:spPr bwMode="auto">
          <a:xfrm>
            <a:off x="1982027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7" name="Line 196">
            <a:extLst>
              <a:ext uri="{FF2B5EF4-FFF2-40B4-BE49-F238E27FC236}">
                <a16:creationId xmlns:a16="http://schemas.microsoft.com/office/drawing/2014/main" id="{91CF0653-0F4D-1074-658D-FB09B9D23802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9161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8" name="Line 201">
            <a:extLst>
              <a:ext uri="{FF2B5EF4-FFF2-40B4-BE49-F238E27FC236}">
                <a16:creationId xmlns:a16="http://schemas.microsoft.com/office/drawing/2014/main" id="{237C3F10-6B3B-5B95-A3A9-50EA00279218}"/>
              </a:ext>
            </a:extLst>
          </p:cNvPr>
          <p:cNvSpPr>
            <a:spLocks noChangeShapeType="1"/>
          </p:cNvSpPr>
          <p:nvPr/>
        </p:nvSpPr>
        <p:spPr bwMode="auto">
          <a:xfrm>
            <a:off x="3099936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9" name="Line 206">
            <a:extLst>
              <a:ext uri="{FF2B5EF4-FFF2-40B4-BE49-F238E27FC236}">
                <a16:creationId xmlns:a16="http://schemas.microsoft.com/office/drawing/2014/main" id="{1E2A0358-8256-9C25-89B9-F6EC438631BC}"/>
              </a:ext>
            </a:extLst>
          </p:cNvPr>
          <p:cNvSpPr>
            <a:spLocks noChangeShapeType="1"/>
          </p:cNvSpPr>
          <p:nvPr/>
        </p:nvSpPr>
        <p:spPr bwMode="auto">
          <a:xfrm>
            <a:off x="3657071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0" name="Line 211">
            <a:extLst>
              <a:ext uri="{FF2B5EF4-FFF2-40B4-BE49-F238E27FC236}">
                <a16:creationId xmlns:a16="http://schemas.microsoft.com/office/drawing/2014/main" id="{DBE758B7-5950-72C8-7AB8-7A8CFFA4CCD3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7846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1" name="Line 216">
            <a:extLst>
              <a:ext uri="{FF2B5EF4-FFF2-40B4-BE49-F238E27FC236}">
                <a16:creationId xmlns:a16="http://schemas.microsoft.com/office/drawing/2014/main" id="{4FE59534-E050-E8D2-A909-EADA569F55FD}"/>
              </a:ext>
            </a:extLst>
          </p:cNvPr>
          <p:cNvSpPr>
            <a:spLocks noChangeShapeType="1"/>
          </p:cNvSpPr>
          <p:nvPr/>
        </p:nvSpPr>
        <p:spPr bwMode="auto">
          <a:xfrm>
            <a:off x="4774980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2" name="Line 221">
            <a:extLst>
              <a:ext uri="{FF2B5EF4-FFF2-40B4-BE49-F238E27FC236}">
                <a16:creationId xmlns:a16="http://schemas.microsoft.com/office/drawing/2014/main" id="{EDC57AE3-1050-82EC-F8E4-EC5873E01FE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5756" y="1894532"/>
            <a:ext cx="3641" cy="269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3" name="Line 222">
            <a:extLst>
              <a:ext uri="{FF2B5EF4-FFF2-40B4-BE49-F238E27FC236}">
                <a16:creationId xmlns:a16="http://schemas.microsoft.com/office/drawing/2014/main" id="{E1C52D88-26C7-911E-6EE3-C4A4480DD596}"/>
              </a:ext>
            </a:extLst>
          </p:cNvPr>
          <p:cNvSpPr>
            <a:spLocks noChangeShapeType="1"/>
          </p:cNvSpPr>
          <p:nvPr/>
        </p:nvSpPr>
        <p:spPr bwMode="auto">
          <a:xfrm>
            <a:off x="864117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" name="Rectangle 223">
            <a:extLst>
              <a:ext uri="{FF2B5EF4-FFF2-40B4-BE49-F238E27FC236}">
                <a16:creationId xmlns:a16="http://schemas.microsoft.com/office/drawing/2014/main" id="{29BD42BC-C294-EEB6-ABEC-B6F01850CA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672" y="195168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6</a:t>
            </a:r>
            <a:endParaRPr lang="en-US" altLang="ja-JP" dirty="0"/>
          </a:p>
        </p:txBody>
      </p:sp>
      <p:sp>
        <p:nvSpPr>
          <p:cNvPr id="15" name="Line 224">
            <a:extLst>
              <a:ext uri="{FF2B5EF4-FFF2-40B4-BE49-F238E27FC236}">
                <a16:creationId xmlns:a16="http://schemas.microsoft.com/office/drawing/2014/main" id="{F93AF6E3-5A01-AE7C-7FC6-27AC38C1BD51}"/>
              </a:ext>
            </a:extLst>
          </p:cNvPr>
          <p:cNvSpPr>
            <a:spLocks noChangeShapeType="1"/>
          </p:cNvSpPr>
          <p:nvPr/>
        </p:nvSpPr>
        <p:spPr bwMode="auto">
          <a:xfrm>
            <a:off x="1421251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6" name="Rectangle 225">
            <a:extLst>
              <a:ext uri="{FF2B5EF4-FFF2-40B4-BE49-F238E27FC236}">
                <a16:creationId xmlns:a16="http://schemas.microsoft.com/office/drawing/2014/main" id="{37242B74-AE9B-E3E3-2283-600A1DEDE8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3806" y="195168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7</a:t>
            </a:r>
            <a:endParaRPr lang="en-US" altLang="ja-JP" dirty="0"/>
          </a:p>
        </p:txBody>
      </p:sp>
      <p:sp>
        <p:nvSpPr>
          <p:cNvPr id="17" name="Line 226">
            <a:extLst>
              <a:ext uri="{FF2B5EF4-FFF2-40B4-BE49-F238E27FC236}">
                <a16:creationId xmlns:a16="http://schemas.microsoft.com/office/drawing/2014/main" id="{9DCC32B0-41F5-6FEA-4CE4-8CC6261854E7}"/>
              </a:ext>
            </a:extLst>
          </p:cNvPr>
          <p:cNvSpPr>
            <a:spLocks noChangeShapeType="1"/>
          </p:cNvSpPr>
          <p:nvPr/>
        </p:nvSpPr>
        <p:spPr bwMode="auto">
          <a:xfrm>
            <a:off x="1982027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8" name="Rectangle 227">
            <a:extLst>
              <a:ext uri="{FF2B5EF4-FFF2-40B4-BE49-F238E27FC236}">
                <a16:creationId xmlns:a16="http://schemas.microsoft.com/office/drawing/2014/main" id="{81381D2E-9F9B-E439-C68E-FA0B7A5316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4107" y="195168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8</a:t>
            </a:r>
            <a:endParaRPr lang="en-US" altLang="ja-JP" dirty="0"/>
          </a:p>
        </p:txBody>
      </p:sp>
      <p:sp>
        <p:nvSpPr>
          <p:cNvPr id="19" name="Line 228">
            <a:extLst>
              <a:ext uri="{FF2B5EF4-FFF2-40B4-BE49-F238E27FC236}">
                <a16:creationId xmlns:a16="http://schemas.microsoft.com/office/drawing/2014/main" id="{9E6913D2-0318-08AA-5E15-34B1A2273B76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9161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" name="Rectangle 229">
            <a:extLst>
              <a:ext uri="{FF2B5EF4-FFF2-40B4-BE49-F238E27FC236}">
                <a16:creationId xmlns:a16="http://schemas.microsoft.com/office/drawing/2014/main" id="{045BDDD5-2D02-7B2D-BC58-1F23CFFD68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1241" y="195168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9</a:t>
            </a:r>
            <a:endParaRPr lang="en-US" altLang="ja-JP" dirty="0"/>
          </a:p>
        </p:txBody>
      </p:sp>
      <p:sp>
        <p:nvSpPr>
          <p:cNvPr id="21" name="Line 230">
            <a:extLst>
              <a:ext uri="{FF2B5EF4-FFF2-40B4-BE49-F238E27FC236}">
                <a16:creationId xmlns:a16="http://schemas.microsoft.com/office/drawing/2014/main" id="{D9DCFF26-BCC8-C679-9807-74170D8AE050}"/>
              </a:ext>
            </a:extLst>
          </p:cNvPr>
          <p:cNvSpPr>
            <a:spLocks noChangeShapeType="1"/>
          </p:cNvSpPr>
          <p:nvPr/>
        </p:nvSpPr>
        <p:spPr bwMode="auto">
          <a:xfrm>
            <a:off x="3099936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2" name="Rectangle 231">
            <a:extLst>
              <a:ext uri="{FF2B5EF4-FFF2-40B4-BE49-F238E27FC236}">
                <a16:creationId xmlns:a16="http://schemas.microsoft.com/office/drawing/2014/main" id="{1A637FEB-35F3-4705-FFB4-81E84BE4F0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55406" y="195168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10</a:t>
            </a:r>
            <a:endParaRPr lang="en-US" altLang="ja-JP" dirty="0"/>
          </a:p>
        </p:txBody>
      </p:sp>
      <p:sp>
        <p:nvSpPr>
          <p:cNvPr id="23" name="Line 232">
            <a:extLst>
              <a:ext uri="{FF2B5EF4-FFF2-40B4-BE49-F238E27FC236}">
                <a16:creationId xmlns:a16="http://schemas.microsoft.com/office/drawing/2014/main" id="{B111FE77-A08C-4F23-A1AE-70671D08049F}"/>
              </a:ext>
            </a:extLst>
          </p:cNvPr>
          <p:cNvSpPr>
            <a:spLocks noChangeShapeType="1"/>
          </p:cNvSpPr>
          <p:nvPr/>
        </p:nvSpPr>
        <p:spPr bwMode="auto">
          <a:xfrm>
            <a:off x="3657071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4" name="Rectangle 233">
            <a:extLst>
              <a:ext uri="{FF2B5EF4-FFF2-40B4-BE49-F238E27FC236}">
                <a16:creationId xmlns:a16="http://schemas.microsoft.com/office/drawing/2014/main" id="{5B951107-9B22-688B-ABE8-8F3155AC61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7777" y="195168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11</a:t>
            </a:r>
            <a:endParaRPr lang="en-US" altLang="ja-JP" dirty="0"/>
          </a:p>
        </p:txBody>
      </p:sp>
      <p:sp>
        <p:nvSpPr>
          <p:cNvPr id="25" name="Line 234">
            <a:extLst>
              <a:ext uri="{FF2B5EF4-FFF2-40B4-BE49-F238E27FC236}">
                <a16:creationId xmlns:a16="http://schemas.microsoft.com/office/drawing/2014/main" id="{C8E9293B-E961-23DE-C161-CFB8748C3DC0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7846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6" name="Rectangle 235">
            <a:extLst>
              <a:ext uri="{FF2B5EF4-FFF2-40B4-BE49-F238E27FC236}">
                <a16:creationId xmlns:a16="http://schemas.microsoft.com/office/drawing/2014/main" id="{760A8BF5-9863-9BF6-ACBE-37ADD8B4C6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4436" y="195168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12</a:t>
            </a:r>
            <a:endParaRPr lang="en-US" altLang="ja-JP" dirty="0"/>
          </a:p>
        </p:txBody>
      </p:sp>
      <p:sp>
        <p:nvSpPr>
          <p:cNvPr id="27" name="Line 236">
            <a:extLst>
              <a:ext uri="{FF2B5EF4-FFF2-40B4-BE49-F238E27FC236}">
                <a16:creationId xmlns:a16="http://schemas.microsoft.com/office/drawing/2014/main" id="{59DB3AA8-A6CE-EF5B-E1B3-DD62F8620953}"/>
              </a:ext>
            </a:extLst>
          </p:cNvPr>
          <p:cNvSpPr>
            <a:spLocks noChangeShapeType="1"/>
          </p:cNvSpPr>
          <p:nvPr/>
        </p:nvSpPr>
        <p:spPr bwMode="auto">
          <a:xfrm>
            <a:off x="4774980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8" name="Rectangle 237">
            <a:extLst>
              <a:ext uri="{FF2B5EF4-FFF2-40B4-BE49-F238E27FC236}">
                <a16:creationId xmlns:a16="http://schemas.microsoft.com/office/drawing/2014/main" id="{ADCFFD70-1E6F-3A09-4D3A-D5E2BB5D0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5212" y="195168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13</a:t>
            </a:r>
            <a:endParaRPr lang="en-US" altLang="ja-JP" dirty="0"/>
          </a:p>
        </p:txBody>
      </p:sp>
      <p:sp>
        <p:nvSpPr>
          <p:cNvPr id="29" name="Line 238">
            <a:extLst>
              <a:ext uri="{FF2B5EF4-FFF2-40B4-BE49-F238E27FC236}">
                <a16:creationId xmlns:a16="http://schemas.microsoft.com/office/drawing/2014/main" id="{D104EC6A-6189-2747-9AA0-D9D20A390F23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5756" y="1894532"/>
            <a:ext cx="3641" cy="5556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" name="Rectangle 239">
            <a:extLst>
              <a:ext uri="{FF2B5EF4-FFF2-40B4-BE49-F238E27FC236}">
                <a16:creationId xmlns:a16="http://schemas.microsoft.com/office/drawing/2014/main" id="{67729566-01AA-BC20-4EA5-A585111995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9153" y="2075507"/>
            <a:ext cx="26129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(min.)</a:t>
            </a:r>
            <a:endParaRPr lang="en-US" altLang="ja-JP" dirty="0"/>
          </a:p>
        </p:txBody>
      </p:sp>
      <p:sp>
        <p:nvSpPr>
          <p:cNvPr id="31" name="Line 244">
            <a:extLst>
              <a:ext uri="{FF2B5EF4-FFF2-40B4-BE49-F238E27FC236}">
                <a16:creationId xmlns:a16="http://schemas.microsoft.com/office/drawing/2014/main" id="{B3F5487F-A8A4-8CDA-93AF-9665DE58C45A}"/>
              </a:ext>
            </a:extLst>
          </p:cNvPr>
          <p:cNvSpPr>
            <a:spLocks noChangeShapeType="1"/>
          </p:cNvSpPr>
          <p:nvPr/>
        </p:nvSpPr>
        <p:spPr bwMode="auto">
          <a:xfrm>
            <a:off x="838627" y="1692920"/>
            <a:ext cx="21848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" name="Line 249">
            <a:extLst>
              <a:ext uri="{FF2B5EF4-FFF2-40B4-BE49-F238E27FC236}">
                <a16:creationId xmlns:a16="http://schemas.microsoft.com/office/drawing/2014/main" id="{FE099CAF-0802-FC99-0E35-B8F3137B6796}"/>
              </a:ext>
            </a:extLst>
          </p:cNvPr>
          <p:cNvSpPr>
            <a:spLocks noChangeShapeType="1"/>
          </p:cNvSpPr>
          <p:nvPr/>
        </p:nvSpPr>
        <p:spPr bwMode="auto">
          <a:xfrm>
            <a:off x="838627" y="1478607"/>
            <a:ext cx="21848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3" name="Line 254">
            <a:extLst>
              <a:ext uri="{FF2B5EF4-FFF2-40B4-BE49-F238E27FC236}">
                <a16:creationId xmlns:a16="http://schemas.microsoft.com/office/drawing/2014/main" id="{2E44A1C2-BD24-9F65-D42C-7FFA0AACC210}"/>
              </a:ext>
            </a:extLst>
          </p:cNvPr>
          <p:cNvSpPr>
            <a:spLocks noChangeShapeType="1"/>
          </p:cNvSpPr>
          <p:nvPr/>
        </p:nvSpPr>
        <p:spPr bwMode="auto">
          <a:xfrm>
            <a:off x="838627" y="1267470"/>
            <a:ext cx="21848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4" name="Line 259">
            <a:extLst>
              <a:ext uri="{FF2B5EF4-FFF2-40B4-BE49-F238E27FC236}">
                <a16:creationId xmlns:a16="http://schemas.microsoft.com/office/drawing/2014/main" id="{5A6E8A70-B0FD-D0C1-87A1-B4020F7B444E}"/>
              </a:ext>
            </a:extLst>
          </p:cNvPr>
          <p:cNvSpPr>
            <a:spLocks noChangeShapeType="1"/>
          </p:cNvSpPr>
          <p:nvPr/>
        </p:nvSpPr>
        <p:spPr bwMode="auto">
          <a:xfrm>
            <a:off x="838627" y="1053157"/>
            <a:ext cx="21848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5" name="Line 260">
            <a:extLst>
              <a:ext uri="{FF2B5EF4-FFF2-40B4-BE49-F238E27FC236}">
                <a16:creationId xmlns:a16="http://schemas.microsoft.com/office/drawing/2014/main" id="{74A188AC-7720-4232-A04C-25B4FCB53ED7}"/>
              </a:ext>
            </a:extLst>
          </p:cNvPr>
          <p:cNvSpPr>
            <a:spLocks noChangeShapeType="1"/>
          </p:cNvSpPr>
          <p:nvPr/>
        </p:nvSpPr>
        <p:spPr bwMode="auto">
          <a:xfrm>
            <a:off x="816779" y="1692920"/>
            <a:ext cx="4369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6" name="Rectangle 261">
            <a:extLst>
              <a:ext uri="{FF2B5EF4-FFF2-40B4-BE49-F238E27FC236}">
                <a16:creationId xmlns:a16="http://schemas.microsoft.com/office/drawing/2014/main" id="{63970274-2297-AF6F-FB70-01EF7B3CE7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119" y="164053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>
                <a:solidFill>
                  <a:srgbClr val="000000"/>
                </a:solidFill>
                <a:ea typeface="ＭＳ ゴシック" charset="-128"/>
              </a:rPr>
              <a:t>25</a:t>
            </a:r>
            <a:endParaRPr lang="en-US" altLang="ja-JP"/>
          </a:p>
        </p:txBody>
      </p:sp>
      <p:sp>
        <p:nvSpPr>
          <p:cNvPr id="37" name="Line 262">
            <a:extLst>
              <a:ext uri="{FF2B5EF4-FFF2-40B4-BE49-F238E27FC236}">
                <a16:creationId xmlns:a16="http://schemas.microsoft.com/office/drawing/2014/main" id="{8E926C8B-8D94-E893-84BD-2D4E4EBE1B56}"/>
              </a:ext>
            </a:extLst>
          </p:cNvPr>
          <p:cNvSpPr>
            <a:spLocks noChangeShapeType="1"/>
          </p:cNvSpPr>
          <p:nvPr/>
        </p:nvSpPr>
        <p:spPr bwMode="auto">
          <a:xfrm>
            <a:off x="816779" y="1478607"/>
            <a:ext cx="4369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8" name="Rectangle 263">
            <a:extLst>
              <a:ext uri="{FF2B5EF4-FFF2-40B4-BE49-F238E27FC236}">
                <a16:creationId xmlns:a16="http://schemas.microsoft.com/office/drawing/2014/main" id="{77DB6AA7-7C76-4E7A-800C-26303D57C3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119" y="142780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>
                <a:solidFill>
                  <a:srgbClr val="000000"/>
                </a:solidFill>
                <a:ea typeface="ＭＳ ゴシック" charset="-128"/>
              </a:rPr>
              <a:t>50</a:t>
            </a:r>
            <a:endParaRPr lang="en-US" altLang="ja-JP"/>
          </a:p>
        </p:txBody>
      </p:sp>
      <p:sp>
        <p:nvSpPr>
          <p:cNvPr id="39" name="Line 264">
            <a:extLst>
              <a:ext uri="{FF2B5EF4-FFF2-40B4-BE49-F238E27FC236}">
                <a16:creationId xmlns:a16="http://schemas.microsoft.com/office/drawing/2014/main" id="{840328AD-440A-D10B-EE4A-3B6E3059B211}"/>
              </a:ext>
            </a:extLst>
          </p:cNvPr>
          <p:cNvSpPr>
            <a:spLocks noChangeShapeType="1"/>
          </p:cNvSpPr>
          <p:nvPr/>
        </p:nvSpPr>
        <p:spPr bwMode="auto">
          <a:xfrm>
            <a:off x="816779" y="1267470"/>
            <a:ext cx="4369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0" name="Rectangle 265">
            <a:extLst>
              <a:ext uri="{FF2B5EF4-FFF2-40B4-BE49-F238E27FC236}">
                <a16:creationId xmlns:a16="http://schemas.microsoft.com/office/drawing/2014/main" id="{BCACEA71-AD80-5013-2EDD-623A21C55A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119" y="121508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>
                <a:solidFill>
                  <a:srgbClr val="000000"/>
                </a:solidFill>
                <a:ea typeface="ＭＳ ゴシック" charset="-128"/>
              </a:rPr>
              <a:t>75</a:t>
            </a:r>
            <a:endParaRPr lang="en-US" altLang="ja-JP"/>
          </a:p>
        </p:txBody>
      </p:sp>
      <p:sp>
        <p:nvSpPr>
          <p:cNvPr id="41" name="Line 266">
            <a:extLst>
              <a:ext uri="{FF2B5EF4-FFF2-40B4-BE49-F238E27FC236}">
                <a16:creationId xmlns:a16="http://schemas.microsoft.com/office/drawing/2014/main" id="{E5577BEF-42F1-451E-B01B-4BC8D7167FB4}"/>
              </a:ext>
            </a:extLst>
          </p:cNvPr>
          <p:cNvSpPr>
            <a:spLocks noChangeShapeType="1"/>
          </p:cNvSpPr>
          <p:nvPr/>
        </p:nvSpPr>
        <p:spPr bwMode="auto">
          <a:xfrm>
            <a:off x="816779" y="1053157"/>
            <a:ext cx="4369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" name="Rectangle 267">
            <a:extLst>
              <a:ext uri="{FF2B5EF4-FFF2-40B4-BE49-F238E27FC236}">
                <a16:creationId xmlns:a16="http://schemas.microsoft.com/office/drawing/2014/main" id="{07C476EA-A940-C652-3964-74E8B21D77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422" y="100235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100</a:t>
            </a:r>
            <a:endParaRPr lang="en-US" altLang="ja-JP" dirty="0"/>
          </a:p>
        </p:txBody>
      </p:sp>
      <p:sp>
        <p:nvSpPr>
          <p:cNvPr id="43" name="Rectangle 271">
            <a:extLst>
              <a:ext uri="{FF2B5EF4-FFF2-40B4-BE49-F238E27FC236}">
                <a16:creationId xmlns:a16="http://schemas.microsoft.com/office/drawing/2014/main" id="{1CF7FE7F-B323-65CD-EE21-A5363F78B2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476" y="1037282"/>
            <a:ext cx="4475280" cy="8572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4C31C81-785E-B4D7-CD52-CB555B9B2228}"/>
              </a:ext>
            </a:extLst>
          </p:cNvPr>
          <p:cNvSpPr txBox="1"/>
          <p:nvPr/>
        </p:nvSpPr>
        <p:spPr>
          <a:xfrm>
            <a:off x="1266095" y="1483498"/>
            <a:ext cx="384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1</a:t>
            </a:r>
            <a:endParaRPr kumimoji="1" lang="ja-JP" altLang="en-US" sz="105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1D862D0-CF60-EFDC-40FD-915536D85E67}"/>
              </a:ext>
            </a:extLst>
          </p:cNvPr>
          <p:cNvSpPr txBox="1"/>
          <p:nvPr/>
        </p:nvSpPr>
        <p:spPr>
          <a:xfrm>
            <a:off x="2126020" y="1509084"/>
            <a:ext cx="5263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A1</a:t>
            </a:r>
            <a:endParaRPr kumimoji="1" lang="ja-JP" altLang="en-US" sz="105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CF4AD38-CD3F-CE67-E982-424FBAAF36CC}"/>
              </a:ext>
            </a:extLst>
          </p:cNvPr>
          <p:cNvSpPr txBox="1"/>
          <p:nvPr/>
        </p:nvSpPr>
        <p:spPr>
          <a:xfrm>
            <a:off x="2434387" y="1516342"/>
            <a:ext cx="384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A2</a:t>
            </a:r>
            <a:endParaRPr kumimoji="1" lang="ja-JP" altLang="en-US" sz="1050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7BCC787-0A52-17F2-081D-A7A7B4A4C008}"/>
              </a:ext>
            </a:extLst>
          </p:cNvPr>
          <p:cNvSpPr txBox="1"/>
          <p:nvPr/>
        </p:nvSpPr>
        <p:spPr>
          <a:xfrm>
            <a:off x="2953195" y="1545526"/>
            <a:ext cx="384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A3</a:t>
            </a:r>
            <a:endParaRPr kumimoji="1" lang="ja-JP" altLang="en-US" sz="1050" dirty="0"/>
          </a:p>
        </p:txBody>
      </p:sp>
      <p:sp>
        <p:nvSpPr>
          <p:cNvPr id="48" name="Rectangle 237">
            <a:extLst>
              <a:ext uri="{FF2B5EF4-FFF2-40B4-BE49-F238E27FC236}">
                <a16:creationId xmlns:a16="http://schemas.microsoft.com/office/drawing/2014/main" id="{B501EDAE-6E9A-DB45-8240-1A47255165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8137" y="195168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ea typeface="ＭＳ ゴシック" charset="-128"/>
              </a:rPr>
              <a:t>14</a:t>
            </a:r>
            <a:endParaRPr lang="en-US" altLang="ja-JP" dirty="0"/>
          </a:p>
        </p:txBody>
      </p:sp>
      <p:sp>
        <p:nvSpPr>
          <p:cNvPr id="49" name="テキスト ボックス 2">
            <a:extLst>
              <a:ext uri="{FF2B5EF4-FFF2-40B4-BE49-F238E27FC236}">
                <a16:creationId xmlns:a16="http://schemas.microsoft.com/office/drawing/2014/main" id="{46C05435-C720-22E2-5E3D-5494DAF3A0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853" y="636039"/>
            <a:ext cx="3722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/>
              <a:t>(a)</a:t>
            </a:r>
            <a:endParaRPr lang="ja-JP" altLang="en-US" sz="1200" dirty="0"/>
          </a:p>
        </p:txBody>
      </p:sp>
      <p:sp>
        <p:nvSpPr>
          <p:cNvPr id="50" name="Rectangle 85">
            <a:extLst>
              <a:ext uri="{FF2B5EF4-FFF2-40B4-BE49-F238E27FC236}">
                <a16:creationId xmlns:a16="http://schemas.microsoft.com/office/drawing/2014/main" id="{514956C6-99DD-DF53-05EC-C98C9844CD7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613" y="1299129"/>
            <a:ext cx="58509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700" dirty="0" err="1">
                <a:solidFill>
                  <a:srgbClr val="000000"/>
                </a:solidFill>
                <a:latin typeface="+mn-lt"/>
                <a:ea typeface="ＭＳ ゴシック" panose="020B0609070205080204" pitchFamily="49" charset="-128"/>
              </a:rPr>
              <a:t>mAU</a:t>
            </a:r>
            <a:r>
              <a:rPr lang="en-US" altLang="ja-JP" sz="700" dirty="0">
                <a:solidFill>
                  <a:srgbClr val="000000"/>
                </a:solidFill>
                <a:latin typeface="+mn-lt"/>
                <a:ea typeface="ＭＳ ゴシック" panose="020B0609070205080204" pitchFamily="49" charset="-128"/>
              </a:rPr>
              <a:t> (220 nm)</a:t>
            </a:r>
            <a:endParaRPr lang="en-US" altLang="ja-JP" sz="1600" dirty="0">
              <a:latin typeface="+mn-lt"/>
            </a:endParaRPr>
          </a:p>
        </p:txBody>
      </p:sp>
      <p:sp>
        <p:nvSpPr>
          <p:cNvPr id="51" name="Freeform 779">
            <a:extLst>
              <a:ext uri="{FF2B5EF4-FFF2-40B4-BE49-F238E27FC236}">
                <a16:creationId xmlns:a16="http://schemas.microsoft.com/office/drawing/2014/main" id="{AEB9D5F2-89FC-D56C-409C-7E29CA6A8628}"/>
              </a:ext>
            </a:extLst>
          </p:cNvPr>
          <p:cNvSpPr>
            <a:spLocks/>
          </p:cNvSpPr>
          <p:nvPr/>
        </p:nvSpPr>
        <p:spPr bwMode="auto">
          <a:xfrm>
            <a:off x="870457" y="1294685"/>
            <a:ext cx="4472233" cy="465436"/>
          </a:xfrm>
          <a:custGeom>
            <a:avLst/>
            <a:gdLst>
              <a:gd name="T0" fmla="*/ 0 w 4265"/>
              <a:gd name="T1" fmla="*/ 19 h 585"/>
              <a:gd name="T2" fmla="*/ 0 w 4265"/>
              <a:gd name="T3" fmla="*/ 18 h 585"/>
              <a:gd name="T4" fmla="*/ 0 w 4265"/>
              <a:gd name="T5" fmla="*/ 18 h 585"/>
              <a:gd name="T6" fmla="*/ 0 w 4265"/>
              <a:gd name="T7" fmla="*/ 18 h 585"/>
              <a:gd name="T8" fmla="*/ 0 w 4265"/>
              <a:gd name="T9" fmla="*/ 18 h 585"/>
              <a:gd name="T10" fmla="*/ 0 w 4265"/>
              <a:gd name="T11" fmla="*/ 18 h 585"/>
              <a:gd name="T12" fmla="*/ 0 w 4265"/>
              <a:gd name="T13" fmla="*/ 18 h 585"/>
              <a:gd name="T14" fmla="*/ 0 w 4265"/>
              <a:gd name="T15" fmla="*/ 18 h 585"/>
              <a:gd name="T16" fmla="*/ 0 w 4265"/>
              <a:gd name="T17" fmla="*/ 18 h 585"/>
              <a:gd name="T18" fmla="*/ 0 w 4265"/>
              <a:gd name="T19" fmla="*/ 3 h 585"/>
              <a:gd name="T20" fmla="*/ 1 w 4265"/>
              <a:gd name="T21" fmla="*/ 15 h 585"/>
              <a:gd name="T22" fmla="*/ 1 w 4265"/>
              <a:gd name="T23" fmla="*/ 18 h 585"/>
              <a:gd name="T24" fmla="*/ 1 w 4265"/>
              <a:gd name="T25" fmla="*/ 17 h 585"/>
              <a:gd name="T26" fmla="*/ 1 w 4265"/>
              <a:gd name="T27" fmla="*/ 18 h 585"/>
              <a:gd name="T28" fmla="*/ 1 w 4265"/>
              <a:gd name="T29" fmla="*/ 18 h 585"/>
              <a:gd name="T30" fmla="*/ 1 w 4265"/>
              <a:gd name="T31" fmla="*/ 18 h 585"/>
              <a:gd name="T32" fmla="*/ 1 w 4265"/>
              <a:gd name="T33" fmla="*/ 18 h 585"/>
              <a:gd name="T34" fmla="*/ 1 w 4265"/>
              <a:gd name="T35" fmla="*/ 18 h 585"/>
              <a:gd name="T36" fmla="*/ 1 w 4265"/>
              <a:gd name="T37" fmla="*/ 18 h 585"/>
              <a:gd name="T38" fmla="*/ 1 w 4265"/>
              <a:gd name="T39" fmla="*/ 18 h 585"/>
              <a:gd name="T40" fmla="*/ 1 w 4265"/>
              <a:gd name="T41" fmla="*/ 18 h 585"/>
              <a:gd name="T42" fmla="*/ 1 w 4265"/>
              <a:gd name="T43" fmla="*/ 18 h 585"/>
              <a:gd name="T44" fmla="*/ 1 w 4265"/>
              <a:gd name="T45" fmla="*/ 18 h 585"/>
              <a:gd name="T46" fmla="*/ 1 w 4265"/>
              <a:gd name="T47" fmla="*/ 18 h 585"/>
              <a:gd name="T48" fmla="*/ 1 w 4265"/>
              <a:gd name="T49" fmla="*/ 18 h 585"/>
              <a:gd name="T50" fmla="*/ 2 w 4265"/>
              <a:gd name="T51" fmla="*/ 18 h 585"/>
              <a:gd name="T52" fmla="*/ 2 w 4265"/>
              <a:gd name="T53" fmla="*/ 18 h 585"/>
              <a:gd name="T54" fmla="*/ 2 w 4265"/>
              <a:gd name="T55" fmla="*/ 18 h 585"/>
              <a:gd name="T56" fmla="*/ 2 w 4265"/>
              <a:gd name="T57" fmla="*/ 18 h 585"/>
              <a:gd name="T58" fmla="*/ 2 w 4265"/>
              <a:gd name="T59" fmla="*/ 18 h 585"/>
              <a:gd name="T60" fmla="*/ 2 w 4265"/>
              <a:gd name="T61" fmla="*/ 18 h 585"/>
              <a:gd name="T62" fmla="*/ 2 w 4265"/>
              <a:gd name="T63" fmla="*/ 18 h 585"/>
              <a:gd name="T64" fmla="*/ 2 w 4265"/>
              <a:gd name="T65" fmla="*/ 18 h 585"/>
              <a:gd name="T66" fmla="*/ 2 w 4265"/>
              <a:gd name="T67" fmla="*/ 18 h 585"/>
              <a:gd name="T68" fmla="*/ 2 w 4265"/>
              <a:gd name="T69" fmla="*/ 18 h 585"/>
              <a:gd name="T70" fmla="*/ 2 w 4265"/>
              <a:gd name="T71" fmla="*/ 18 h 585"/>
              <a:gd name="T72" fmla="*/ 2 w 4265"/>
              <a:gd name="T73" fmla="*/ 17 h 585"/>
              <a:gd name="T74" fmla="*/ 2 w 4265"/>
              <a:gd name="T75" fmla="*/ 3 h 585"/>
              <a:gd name="T76" fmla="*/ 2 w 4265"/>
              <a:gd name="T77" fmla="*/ 15 h 585"/>
              <a:gd name="T78" fmla="*/ 2 w 4265"/>
              <a:gd name="T79" fmla="*/ 17 h 585"/>
              <a:gd name="T80" fmla="*/ 3 w 4265"/>
              <a:gd name="T81" fmla="*/ 17 h 585"/>
              <a:gd name="T82" fmla="*/ 3 w 4265"/>
              <a:gd name="T83" fmla="*/ 18 h 585"/>
              <a:gd name="T84" fmla="*/ 3 w 4265"/>
              <a:gd name="T85" fmla="*/ 18 h 585"/>
              <a:gd name="T86" fmla="*/ 3 w 4265"/>
              <a:gd name="T87" fmla="*/ 16 h 585"/>
              <a:gd name="T88" fmla="*/ 3 w 4265"/>
              <a:gd name="T89" fmla="*/ 17 h 585"/>
              <a:gd name="T90" fmla="*/ 3 w 4265"/>
              <a:gd name="T91" fmla="*/ 17 h 585"/>
              <a:gd name="T92" fmla="*/ 3 w 4265"/>
              <a:gd name="T93" fmla="*/ 18 h 585"/>
              <a:gd name="T94" fmla="*/ 3 w 4265"/>
              <a:gd name="T95" fmla="*/ 18 h 585"/>
              <a:gd name="T96" fmla="*/ 3 w 4265"/>
              <a:gd name="T97" fmla="*/ 18 h 585"/>
              <a:gd name="T98" fmla="*/ 3 w 4265"/>
              <a:gd name="T99" fmla="*/ 17 h 585"/>
              <a:gd name="T100" fmla="*/ 3 w 4265"/>
              <a:gd name="T101" fmla="*/ 17 h 585"/>
              <a:gd name="T102" fmla="*/ 3 w 4265"/>
              <a:gd name="T103" fmla="*/ 17 h 585"/>
              <a:gd name="T104" fmla="*/ 3 w 4265"/>
              <a:gd name="T105" fmla="*/ 17 h 585"/>
              <a:gd name="T106" fmla="*/ 3 w 4265"/>
              <a:gd name="T107" fmla="*/ 17 h 585"/>
              <a:gd name="T108" fmla="*/ 3 w 4265"/>
              <a:gd name="T109" fmla="*/ 17 h 585"/>
              <a:gd name="T110" fmla="*/ 4 w 4265"/>
              <a:gd name="T111" fmla="*/ 17 h 585"/>
              <a:gd name="T112" fmla="*/ 4 w 4265"/>
              <a:gd name="T113" fmla="*/ 17 h 585"/>
              <a:gd name="T114" fmla="*/ 4 w 4265"/>
              <a:gd name="T115" fmla="*/ 13 h 585"/>
              <a:gd name="T116" fmla="*/ 4 w 4265"/>
              <a:gd name="T117" fmla="*/ 7 h 585"/>
              <a:gd name="T118" fmla="*/ 4 w 4265"/>
              <a:gd name="T119" fmla="*/ 11 h 585"/>
              <a:gd name="T120" fmla="*/ 4 w 4265"/>
              <a:gd name="T121" fmla="*/ 13 h 585"/>
              <a:gd name="T122" fmla="*/ 4 w 4265"/>
              <a:gd name="T123" fmla="*/ 14 h 585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</a:gdLst>
            <a:ahLst/>
            <a:cxnLst>
              <a:cxn ang="T124">
                <a:pos x="T0" y="T1"/>
              </a:cxn>
              <a:cxn ang="T125">
                <a:pos x="T2" y="T3"/>
              </a:cxn>
              <a:cxn ang="T126">
                <a:pos x="T4" y="T5"/>
              </a:cxn>
              <a:cxn ang="T127">
                <a:pos x="T6" y="T7"/>
              </a:cxn>
              <a:cxn ang="T128">
                <a:pos x="T8" y="T9"/>
              </a:cxn>
              <a:cxn ang="T129">
                <a:pos x="T10" y="T11"/>
              </a:cxn>
              <a:cxn ang="T130">
                <a:pos x="T12" y="T13"/>
              </a:cxn>
              <a:cxn ang="T131">
                <a:pos x="T14" y="T15"/>
              </a:cxn>
              <a:cxn ang="T132">
                <a:pos x="T16" y="T17"/>
              </a:cxn>
              <a:cxn ang="T133">
                <a:pos x="T18" y="T19"/>
              </a:cxn>
              <a:cxn ang="T134">
                <a:pos x="T20" y="T21"/>
              </a:cxn>
              <a:cxn ang="T135">
                <a:pos x="T22" y="T23"/>
              </a:cxn>
              <a:cxn ang="T136">
                <a:pos x="T24" y="T25"/>
              </a:cxn>
              <a:cxn ang="T137">
                <a:pos x="T26" y="T27"/>
              </a:cxn>
              <a:cxn ang="T138">
                <a:pos x="T28" y="T29"/>
              </a:cxn>
              <a:cxn ang="T139">
                <a:pos x="T30" y="T31"/>
              </a:cxn>
              <a:cxn ang="T140">
                <a:pos x="T32" y="T33"/>
              </a:cxn>
              <a:cxn ang="T141">
                <a:pos x="T34" y="T35"/>
              </a:cxn>
              <a:cxn ang="T142">
                <a:pos x="T36" y="T37"/>
              </a:cxn>
              <a:cxn ang="T143">
                <a:pos x="T38" y="T39"/>
              </a:cxn>
              <a:cxn ang="T144">
                <a:pos x="T40" y="T41"/>
              </a:cxn>
              <a:cxn ang="T145">
                <a:pos x="T42" y="T43"/>
              </a:cxn>
              <a:cxn ang="T146">
                <a:pos x="T44" y="T45"/>
              </a:cxn>
              <a:cxn ang="T147">
                <a:pos x="T46" y="T47"/>
              </a:cxn>
              <a:cxn ang="T148">
                <a:pos x="T48" y="T49"/>
              </a:cxn>
              <a:cxn ang="T149">
                <a:pos x="T50" y="T51"/>
              </a:cxn>
              <a:cxn ang="T150">
                <a:pos x="T52" y="T53"/>
              </a:cxn>
              <a:cxn ang="T151">
                <a:pos x="T54" y="T55"/>
              </a:cxn>
              <a:cxn ang="T152">
                <a:pos x="T56" y="T57"/>
              </a:cxn>
              <a:cxn ang="T153">
                <a:pos x="T58" y="T59"/>
              </a:cxn>
              <a:cxn ang="T154">
                <a:pos x="T60" y="T61"/>
              </a:cxn>
              <a:cxn ang="T155">
                <a:pos x="T62" y="T63"/>
              </a:cxn>
              <a:cxn ang="T156">
                <a:pos x="T64" y="T65"/>
              </a:cxn>
              <a:cxn ang="T157">
                <a:pos x="T66" y="T67"/>
              </a:cxn>
              <a:cxn ang="T158">
                <a:pos x="T68" y="T69"/>
              </a:cxn>
              <a:cxn ang="T159">
                <a:pos x="T70" y="T71"/>
              </a:cxn>
              <a:cxn ang="T160">
                <a:pos x="T72" y="T73"/>
              </a:cxn>
              <a:cxn ang="T161">
                <a:pos x="T74" y="T75"/>
              </a:cxn>
              <a:cxn ang="T162">
                <a:pos x="T76" y="T77"/>
              </a:cxn>
              <a:cxn ang="T163">
                <a:pos x="T78" y="T79"/>
              </a:cxn>
              <a:cxn ang="T164">
                <a:pos x="T80" y="T81"/>
              </a:cxn>
              <a:cxn ang="T165">
                <a:pos x="T82" y="T83"/>
              </a:cxn>
              <a:cxn ang="T166">
                <a:pos x="T84" y="T85"/>
              </a:cxn>
              <a:cxn ang="T167">
                <a:pos x="T86" y="T87"/>
              </a:cxn>
              <a:cxn ang="T168">
                <a:pos x="T88" y="T89"/>
              </a:cxn>
              <a:cxn ang="T169">
                <a:pos x="T90" y="T91"/>
              </a:cxn>
              <a:cxn ang="T170">
                <a:pos x="T92" y="T93"/>
              </a:cxn>
              <a:cxn ang="T171">
                <a:pos x="T94" y="T95"/>
              </a:cxn>
              <a:cxn ang="T172">
                <a:pos x="T96" y="T97"/>
              </a:cxn>
              <a:cxn ang="T173">
                <a:pos x="T98" y="T99"/>
              </a:cxn>
              <a:cxn ang="T174">
                <a:pos x="T100" y="T101"/>
              </a:cxn>
              <a:cxn ang="T175">
                <a:pos x="T102" y="T103"/>
              </a:cxn>
              <a:cxn ang="T176">
                <a:pos x="T104" y="T105"/>
              </a:cxn>
              <a:cxn ang="T177">
                <a:pos x="T106" y="T107"/>
              </a:cxn>
              <a:cxn ang="T178">
                <a:pos x="T108" y="T109"/>
              </a:cxn>
              <a:cxn ang="T179">
                <a:pos x="T110" y="T111"/>
              </a:cxn>
              <a:cxn ang="T180">
                <a:pos x="T112" y="T113"/>
              </a:cxn>
              <a:cxn ang="T181">
                <a:pos x="T114" y="T115"/>
              </a:cxn>
              <a:cxn ang="T182">
                <a:pos x="T116" y="T117"/>
              </a:cxn>
              <a:cxn ang="T183">
                <a:pos x="T118" y="T119"/>
              </a:cxn>
              <a:cxn ang="T184">
                <a:pos x="T120" y="T121"/>
              </a:cxn>
              <a:cxn ang="T185">
                <a:pos x="T122" y="T123"/>
              </a:cxn>
            </a:cxnLst>
            <a:rect l="0" t="0" r="r" b="b"/>
            <a:pathLst>
              <a:path w="4265" h="585">
                <a:moveTo>
                  <a:pt x="0" y="585"/>
                </a:moveTo>
                <a:lnTo>
                  <a:pt x="2" y="585"/>
                </a:lnTo>
                <a:lnTo>
                  <a:pt x="8" y="585"/>
                </a:lnTo>
                <a:lnTo>
                  <a:pt x="12" y="583"/>
                </a:lnTo>
                <a:lnTo>
                  <a:pt x="18" y="583"/>
                </a:lnTo>
                <a:lnTo>
                  <a:pt x="24" y="583"/>
                </a:lnTo>
                <a:lnTo>
                  <a:pt x="30" y="581"/>
                </a:lnTo>
                <a:lnTo>
                  <a:pt x="35" y="581"/>
                </a:lnTo>
                <a:lnTo>
                  <a:pt x="41" y="581"/>
                </a:lnTo>
                <a:lnTo>
                  <a:pt x="47" y="579"/>
                </a:lnTo>
                <a:lnTo>
                  <a:pt x="53" y="579"/>
                </a:lnTo>
                <a:lnTo>
                  <a:pt x="58" y="579"/>
                </a:lnTo>
                <a:lnTo>
                  <a:pt x="64" y="577"/>
                </a:lnTo>
                <a:lnTo>
                  <a:pt x="70" y="577"/>
                </a:lnTo>
                <a:lnTo>
                  <a:pt x="76" y="577"/>
                </a:lnTo>
                <a:lnTo>
                  <a:pt x="82" y="575"/>
                </a:lnTo>
                <a:lnTo>
                  <a:pt x="86" y="575"/>
                </a:lnTo>
                <a:lnTo>
                  <a:pt x="92" y="575"/>
                </a:lnTo>
                <a:lnTo>
                  <a:pt x="98" y="575"/>
                </a:lnTo>
                <a:lnTo>
                  <a:pt x="104" y="573"/>
                </a:lnTo>
                <a:lnTo>
                  <a:pt x="109" y="573"/>
                </a:lnTo>
                <a:lnTo>
                  <a:pt x="115" y="573"/>
                </a:lnTo>
                <a:lnTo>
                  <a:pt x="121" y="572"/>
                </a:lnTo>
                <a:lnTo>
                  <a:pt x="127" y="572"/>
                </a:lnTo>
                <a:lnTo>
                  <a:pt x="132" y="572"/>
                </a:lnTo>
                <a:lnTo>
                  <a:pt x="138" y="572"/>
                </a:lnTo>
                <a:lnTo>
                  <a:pt x="144" y="570"/>
                </a:lnTo>
                <a:lnTo>
                  <a:pt x="150" y="570"/>
                </a:lnTo>
                <a:lnTo>
                  <a:pt x="155" y="570"/>
                </a:lnTo>
                <a:lnTo>
                  <a:pt x="161" y="570"/>
                </a:lnTo>
                <a:lnTo>
                  <a:pt x="167" y="570"/>
                </a:lnTo>
                <a:lnTo>
                  <a:pt x="173" y="570"/>
                </a:lnTo>
                <a:lnTo>
                  <a:pt x="179" y="570"/>
                </a:lnTo>
                <a:lnTo>
                  <a:pt x="183" y="570"/>
                </a:lnTo>
                <a:lnTo>
                  <a:pt x="189" y="570"/>
                </a:lnTo>
                <a:lnTo>
                  <a:pt x="195" y="570"/>
                </a:lnTo>
                <a:lnTo>
                  <a:pt x="201" y="568"/>
                </a:lnTo>
                <a:lnTo>
                  <a:pt x="206" y="566"/>
                </a:lnTo>
                <a:lnTo>
                  <a:pt x="212" y="564"/>
                </a:lnTo>
                <a:lnTo>
                  <a:pt x="218" y="560"/>
                </a:lnTo>
                <a:lnTo>
                  <a:pt x="224" y="558"/>
                </a:lnTo>
                <a:lnTo>
                  <a:pt x="229" y="558"/>
                </a:lnTo>
                <a:lnTo>
                  <a:pt x="235" y="558"/>
                </a:lnTo>
                <a:lnTo>
                  <a:pt x="241" y="558"/>
                </a:lnTo>
                <a:lnTo>
                  <a:pt x="247" y="560"/>
                </a:lnTo>
                <a:lnTo>
                  <a:pt x="251" y="560"/>
                </a:lnTo>
                <a:lnTo>
                  <a:pt x="257" y="562"/>
                </a:lnTo>
                <a:lnTo>
                  <a:pt x="263" y="562"/>
                </a:lnTo>
                <a:lnTo>
                  <a:pt x="269" y="562"/>
                </a:lnTo>
                <a:lnTo>
                  <a:pt x="275" y="560"/>
                </a:lnTo>
                <a:lnTo>
                  <a:pt x="280" y="560"/>
                </a:lnTo>
                <a:lnTo>
                  <a:pt x="286" y="558"/>
                </a:lnTo>
                <a:lnTo>
                  <a:pt x="292" y="558"/>
                </a:lnTo>
                <a:lnTo>
                  <a:pt x="298" y="558"/>
                </a:lnTo>
                <a:lnTo>
                  <a:pt x="303" y="556"/>
                </a:lnTo>
                <a:lnTo>
                  <a:pt x="309" y="556"/>
                </a:lnTo>
                <a:lnTo>
                  <a:pt x="315" y="556"/>
                </a:lnTo>
                <a:lnTo>
                  <a:pt x="321" y="556"/>
                </a:lnTo>
                <a:lnTo>
                  <a:pt x="326" y="558"/>
                </a:lnTo>
                <a:lnTo>
                  <a:pt x="332" y="558"/>
                </a:lnTo>
                <a:lnTo>
                  <a:pt x="337" y="560"/>
                </a:lnTo>
                <a:lnTo>
                  <a:pt x="343" y="562"/>
                </a:lnTo>
                <a:lnTo>
                  <a:pt x="348" y="562"/>
                </a:lnTo>
                <a:lnTo>
                  <a:pt x="354" y="564"/>
                </a:lnTo>
                <a:lnTo>
                  <a:pt x="360" y="564"/>
                </a:lnTo>
                <a:lnTo>
                  <a:pt x="366" y="566"/>
                </a:lnTo>
                <a:lnTo>
                  <a:pt x="372" y="566"/>
                </a:lnTo>
                <a:lnTo>
                  <a:pt x="377" y="566"/>
                </a:lnTo>
                <a:lnTo>
                  <a:pt x="383" y="566"/>
                </a:lnTo>
                <a:lnTo>
                  <a:pt x="389" y="566"/>
                </a:lnTo>
                <a:lnTo>
                  <a:pt x="395" y="566"/>
                </a:lnTo>
                <a:lnTo>
                  <a:pt x="400" y="566"/>
                </a:lnTo>
                <a:lnTo>
                  <a:pt x="406" y="566"/>
                </a:lnTo>
                <a:lnTo>
                  <a:pt x="412" y="566"/>
                </a:lnTo>
                <a:lnTo>
                  <a:pt x="418" y="568"/>
                </a:lnTo>
                <a:lnTo>
                  <a:pt x="422" y="568"/>
                </a:lnTo>
                <a:lnTo>
                  <a:pt x="428" y="568"/>
                </a:lnTo>
                <a:lnTo>
                  <a:pt x="434" y="568"/>
                </a:lnTo>
                <a:lnTo>
                  <a:pt x="440" y="568"/>
                </a:lnTo>
                <a:lnTo>
                  <a:pt x="445" y="568"/>
                </a:lnTo>
                <a:lnTo>
                  <a:pt x="451" y="566"/>
                </a:lnTo>
                <a:lnTo>
                  <a:pt x="457" y="564"/>
                </a:lnTo>
                <a:lnTo>
                  <a:pt x="463" y="558"/>
                </a:lnTo>
                <a:lnTo>
                  <a:pt x="469" y="552"/>
                </a:lnTo>
                <a:lnTo>
                  <a:pt x="474" y="545"/>
                </a:lnTo>
                <a:lnTo>
                  <a:pt x="480" y="539"/>
                </a:lnTo>
                <a:lnTo>
                  <a:pt x="486" y="537"/>
                </a:lnTo>
                <a:lnTo>
                  <a:pt x="492" y="539"/>
                </a:lnTo>
                <a:lnTo>
                  <a:pt x="496" y="541"/>
                </a:lnTo>
                <a:lnTo>
                  <a:pt x="502" y="543"/>
                </a:lnTo>
                <a:lnTo>
                  <a:pt x="508" y="547"/>
                </a:lnTo>
                <a:lnTo>
                  <a:pt x="514" y="550"/>
                </a:lnTo>
                <a:lnTo>
                  <a:pt x="519" y="552"/>
                </a:lnTo>
                <a:lnTo>
                  <a:pt x="525" y="552"/>
                </a:lnTo>
                <a:lnTo>
                  <a:pt x="531" y="550"/>
                </a:lnTo>
                <a:lnTo>
                  <a:pt x="537" y="547"/>
                </a:lnTo>
                <a:lnTo>
                  <a:pt x="542" y="543"/>
                </a:lnTo>
                <a:lnTo>
                  <a:pt x="548" y="537"/>
                </a:lnTo>
                <a:lnTo>
                  <a:pt x="554" y="535"/>
                </a:lnTo>
                <a:lnTo>
                  <a:pt x="560" y="535"/>
                </a:lnTo>
                <a:lnTo>
                  <a:pt x="566" y="537"/>
                </a:lnTo>
                <a:lnTo>
                  <a:pt x="571" y="539"/>
                </a:lnTo>
                <a:lnTo>
                  <a:pt x="577" y="543"/>
                </a:lnTo>
                <a:lnTo>
                  <a:pt x="583" y="547"/>
                </a:lnTo>
                <a:lnTo>
                  <a:pt x="588" y="550"/>
                </a:lnTo>
                <a:lnTo>
                  <a:pt x="593" y="554"/>
                </a:lnTo>
                <a:lnTo>
                  <a:pt x="599" y="556"/>
                </a:lnTo>
                <a:lnTo>
                  <a:pt x="605" y="558"/>
                </a:lnTo>
                <a:lnTo>
                  <a:pt x="611" y="560"/>
                </a:lnTo>
                <a:lnTo>
                  <a:pt x="616" y="558"/>
                </a:lnTo>
                <a:lnTo>
                  <a:pt x="622" y="556"/>
                </a:lnTo>
                <a:lnTo>
                  <a:pt x="628" y="552"/>
                </a:lnTo>
                <a:lnTo>
                  <a:pt x="634" y="549"/>
                </a:lnTo>
                <a:lnTo>
                  <a:pt x="639" y="541"/>
                </a:lnTo>
                <a:lnTo>
                  <a:pt x="645" y="524"/>
                </a:lnTo>
                <a:lnTo>
                  <a:pt x="651" y="481"/>
                </a:lnTo>
                <a:lnTo>
                  <a:pt x="657" y="403"/>
                </a:lnTo>
                <a:lnTo>
                  <a:pt x="661" y="291"/>
                </a:lnTo>
                <a:lnTo>
                  <a:pt x="667" y="170"/>
                </a:lnTo>
                <a:lnTo>
                  <a:pt x="673" y="69"/>
                </a:lnTo>
                <a:lnTo>
                  <a:pt x="679" y="11"/>
                </a:lnTo>
                <a:lnTo>
                  <a:pt x="685" y="0"/>
                </a:lnTo>
                <a:lnTo>
                  <a:pt x="690" y="28"/>
                </a:lnTo>
                <a:lnTo>
                  <a:pt x="696" y="80"/>
                </a:lnTo>
                <a:lnTo>
                  <a:pt x="702" y="144"/>
                </a:lnTo>
                <a:lnTo>
                  <a:pt x="708" y="207"/>
                </a:lnTo>
                <a:lnTo>
                  <a:pt x="713" y="264"/>
                </a:lnTo>
                <a:lnTo>
                  <a:pt x="719" y="318"/>
                </a:lnTo>
                <a:lnTo>
                  <a:pt x="725" y="364"/>
                </a:lnTo>
                <a:lnTo>
                  <a:pt x="731" y="406"/>
                </a:lnTo>
                <a:lnTo>
                  <a:pt x="735" y="441"/>
                </a:lnTo>
                <a:lnTo>
                  <a:pt x="741" y="470"/>
                </a:lnTo>
                <a:lnTo>
                  <a:pt x="747" y="493"/>
                </a:lnTo>
                <a:lnTo>
                  <a:pt x="753" y="512"/>
                </a:lnTo>
                <a:lnTo>
                  <a:pt x="758" y="525"/>
                </a:lnTo>
                <a:lnTo>
                  <a:pt x="764" y="537"/>
                </a:lnTo>
                <a:lnTo>
                  <a:pt x="770" y="545"/>
                </a:lnTo>
                <a:lnTo>
                  <a:pt x="776" y="550"/>
                </a:lnTo>
                <a:lnTo>
                  <a:pt x="782" y="556"/>
                </a:lnTo>
                <a:lnTo>
                  <a:pt x="787" y="558"/>
                </a:lnTo>
                <a:lnTo>
                  <a:pt x="793" y="562"/>
                </a:lnTo>
                <a:lnTo>
                  <a:pt x="799" y="564"/>
                </a:lnTo>
                <a:lnTo>
                  <a:pt x="805" y="564"/>
                </a:lnTo>
                <a:lnTo>
                  <a:pt x="810" y="566"/>
                </a:lnTo>
                <a:lnTo>
                  <a:pt x="816" y="566"/>
                </a:lnTo>
                <a:lnTo>
                  <a:pt x="822" y="566"/>
                </a:lnTo>
                <a:lnTo>
                  <a:pt x="828" y="566"/>
                </a:lnTo>
                <a:lnTo>
                  <a:pt x="832" y="566"/>
                </a:lnTo>
                <a:lnTo>
                  <a:pt x="838" y="564"/>
                </a:lnTo>
                <a:lnTo>
                  <a:pt x="844" y="564"/>
                </a:lnTo>
                <a:lnTo>
                  <a:pt x="850" y="560"/>
                </a:lnTo>
                <a:lnTo>
                  <a:pt x="855" y="556"/>
                </a:lnTo>
                <a:lnTo>
                  <a:pt x="861" y="547"/>
                </a:lnTo>
                <a:lnTo>
                  <a:pt x="867" y="539"/>
                </a:lnTo>
                <a:lnTo>
                  <a:pt x="873" y="531"/>
                </a:lnTo>
                <a:lnTo>
                  <a:pt x="879" y="525"/>
                </a:lnTo>
                <a:lnTo>
                  <a:pt x="884" y="524"/>
                </a:lnTo>
                <a:lnTo>
                  <a:pt x="890" y="525"/>
                </a:lnTo>
                <a:lnTo>
                  <a:pt x="896" y="529"/>
                </a:lnTo>
                <a:lnTo>
                  <a:pt x="902" y="533"/>
                </a:lnTo>
                <a:lnTo>
                  <a:pt x="906" y="539"/>
                </a:lnTo>
                <a:lnTo>
                  <a:pt x="912" y="543"/>
                </a:lnTo>
                <a:lnTo>
                  <a:pt x="918" y="549"/>
                </a:lnTo>
                <a:lnTo>
                  <a:pt x="924" y="552"/>
                </a:lnTo>
                <a:lnTo>
                  <a:pt x="929" y="554"/>
                </a:lnTo>
                <a:lnTo>
                  <a:pt x="935" y="558"/>
                </a:lnTo>
                <a:lnTo>
                  <a:pt x="941" y="560"/>
                </a:lnTo>
                <a:lnTo>
                  <a:pt x="947" y="562"/>
                </a:lnTo>
                <a:lnTo>
                  <a:pt x="952" y="564"/>
                </a:lnTo>
                <a:lnTo>
                  <a:pt x="958" y="566"/>
                </a:lnTo>
                <a:lnTo>
                  <a:pt x="964" y="566"/>
                </a:lnTo>
                <a:lnTo>
                  <a:pt x="970" y="568"/>
                </a:lnTo>
                <a:lnTo>
                  <a:pt x="976" y="568"/>
                </a:lnTo>
                <a:lnTo>
                  <a:pt x="981" y="568"/>
                </a:lnTo>
                <a:lnTo>
                  <a:pt x="986" y="568"/>
                </a:lnTo>
                <a:lnTo>
                  <a:pt x="992" y="566"/>
                </a:lnTo>
                <a:lnTo>
                  <a:pt x="998" y="566"/>
                </a:lnTo>
                <a:lnTo>
                  <a:pt x="1003" y="564"/>
                </a:lnTo>
                <a:lnTo>
                  <a:pt x="1009" y="562"/>
                </a:lnTo>
                <a:lnTo>
                  <a:pt x="1015" y="560"/>
                </a:lnTo>
                <a:lnTo>
                  <a:pt x="1021" y="560"/>
                </a:lnTo>
                <a:lnTo>
                  <a:pt x="1026" y="560"/>
                </a:lnTo>
                <a:lnTo>
                  <a:pt x="1032" y="562"/>
                </a:lnTo>
                <a:lnTo>
                  <a:pt x="1038" y="562"/>
                </a:lnTo>
                <a:lnTo>
                  <a:pt x="1044" y="564"/>
                </a:lnTo>
                <a:lnTo>
                  <a:pt x="1049" y="566"/>
                </a:lnTo>
                <a:lnTo>
                  <a:pt x="1055" y="566"/>
                </a:lnTo>
                <a:lnTo>
                  <a:pt x="1061" y="568"/>
                </a:lnTo>
                <a:lnTo>
                  <a:pt x="1067" y="568"/>
                </a:lnTo>
                <a:lnTo>
                  <a:pt x="1073" y="568"/>
                </a:lnTo>
                <a:lnTo>
                  <a:pt x="1077" y="568"/>
                </a:lnTo>
                <a:lnTo>
                  <a:pt x="1083" y="570"/>
                </a:lnTo>
                <a:lnTo>
                  <a:pt x="1089" y="570"/>
                </a:lnTo>
                <a:lnTo>
                  <a:pt x="1095" y="570"/>
                </a:lnTo>
                <a:lnTo>
                  <a:pt x="1100" y="570"/>
                </a:lnTo>
                <a:lnTo>
                  <a:pt x="1106" y="570"/>
                </a:lnTo>
                <a:lnTo>
                  <a:pt x="1112" y="570"/>
                </a:lnTo>
                <a:lnTo>
                  <a:pt x="1118" y="570"/>
                </a:lnTo>
                <a:lnTo>
                  <a:pt x="1123" y="570"/>
                </a:lnTo>
                <a:lnTo>
                  <a:pt x="1129" y="570"/>
                </a:lnTo>
                <a:lnTo>
                  <a:pt x="1135" y="570"/>
                </a:lnTo>
                <a:lnTo>
                  <a:pt x="1141" y="570"/>
                </a:lnTo>
                <a:lnTo>
                  <a:pt x="1145" y="570"/>
                </a:lnTo>
                <a:lnTo>
                  <a:pt x="1151" y="568"/>
                </a:lnTo>
                <a:lnTo>
                  <a:pt x="1157" y="568"/>
                </a:lnTo>
                <a:lnTo>
                  <a:pt x="1163" y="566"/>
                </a:lnTo>
                <a:lnTo>
                  <a:pt x="1169" y="566"/>
                </a:lnTo>
                <a:lnTo>
                  <a:pt x="1174" y="566"/>
                </a:lnTo>
                <a:lnTo>
                  <a:pt x="1180" y="566"/>
                </a:lnTo>
                <a:lnTo>
                  <a:pt x="1186" y="566"/>
                </a:lnTo>
                <a:lnTo>
                  <a:pt x="1192" y="566"/>
                </a:lnTo>
                <a:lnTo>
                  <a:pt x="1197" y="566"/>
                </a:lnTo>
                <a:lnTo>
                  <a:pt x="1203" y="566"/>
                </a:lnTo>
                <a:lnTo>
                  <a:pt x="1209" y="568"/>
                </a:lnTo>
                <a:lnTo>
                  <a:pt x="1215" y="568"/>
                </a:lnTo>
                <a:lnTo>
                  <a:pt x="1220" y="568"/>
                </a:lnTo>
                <a:lnTo>
                  <a:pt x="1226" y="570"/>
                </a:lnTo>
                <a:lnTo>
                  <a:pt x="1232" y="570"/>
                </a:lnTo>
                <a:lnTo>
                  <a:pt x="1237" y="570"/>
                </a:lnTo>
                <a:lnTo>
                  <a:pt x="1242" y="570"/>
                </a:lnTo>
                <a:lnTo>
                  <a:pt x="1248" y="570"/>
                </a:lnTo>
                <a:lnTo>
                  <a:pt x="1254" y="570"/>
                </a:lnTo>
                <a:lnTo>
                  <a:pt x="1260" y="570"/>
                </a:lnTo>
                <a:lnTo>
                  <a:pt x="1266" y="570"/>
                </a:lnTo>
                <a:lnTo>
                  <a:pt x="1271" y="570"/>
                </a:lnTo>
                <a:lnTo>
                  <a:pt x="1277" y="568"/>
                </a:lnTo>
                <a:lnTo>
                  <a:pt x="1283" y="566"/>
                </a:lnTo>
                <a:lnTo>
                  <a:pt x="1289" y="562"/>
                </a:lnTo>
                <a:lnTo>
                  <a:pt x="1294" y="558"/>
                </a:lnTo>
                <a:lnTo>
                  <a:pt x="1300" y="554"/>
                </a:lnTo>
                <a:lnTo>
                  <a:pt x="1306" y="550"/>
                </a:lnTo>
                <a:lnTo>
                  <a:pt x="1312" y="550"/>
                </a:lnTo>
                <a:lnTo>
                  <a:pt x="1316" y="550"/>
                </a:lnTo>
                <a:lnTo>
                  <a:pt x="1322" y="552"/>
                </a:lnTo>
                <a:lnTo>
                  <a:pt x="1328" y="552"/>
                </a:lnTo>
                <a:lnTo>
                  <a:pt x="1334" y="554"/>
                </a:lnTo>
                <a:lnTo>
                  <a:pt x="1339" y="554"/>
                </a:lnTo>
                <a:lnTo>
                  <a:pt x="1345" y="556"/>
                </a:lnTo>
                <a:lnTo>
                  <a:pt x="1351" y="556"/>
                </a:lnTo>
                <a:lnTo>
                  <a:pt x="1357" y="558"/>
                </a:lnTo>
                <a:lnTo>
                  <a:pt x="1363" y="558"/>
                </a:lnTo>
                <a:lnTo>
                  <a:pt x="1368" y="560"/>
                </a:lnTo>
                <a:lnTo>
                  <a:pt x="1374" y="562"/>
                </a:lnTo>
                <a:lnTo>
                  <a:pt x="1380" y="564"/>
                </a:lnTo>
                <a:lnTo>
                  <a:pt x="1386" y="566"/>
                </a:lnTo>
                <a:lnTo>
                  <a:pt x="1390" y="568"/>
                </a:lnTo>
                <a:lnTo>
                  <a:pt x="1396" y="568"/>
                </a:lnTo>
                <a:lnTo>
                  <a:pt x="1402" y="570"/>
                </a:lnTo>
                <a:lnTo>
                  <a:pt x="1408" y="570"/>
                </a:lnTo>
                <a:lnTo>
                  <a:pt x="1413" y="570"/>
                </a:lnTo>
                <a:lnTo>
                  <a:pt x="1419" y="570"/>
                </a:lnTo>
                <a:lnTo>
                  <a:pt x="1425" y="572"/>
                </a:lnTo>
                <a:lnTo>
                  <a:pt x="1431" y="572"/>
                </a:lnTo>
                <a:lnTo>
                  <a:pt x="1436" y="572"/>
                </a:lnTo>
                <a:lnTo>
                  <a:pt x="1442" y="572"/>
                </a:lnTo>
                <a:lnTo>
                  <a:pt x="1448" y="572"/>
                </a:lnTo>
                <a:lnTo>
                  <a:pt x="1454" y="572"/>
                </a:lnTo>
                <a:lnTo>
                  <a:pt x="1460" y="572"/>
                </a:lnTo>
                <a:lnTo>
                  <a:pt x="1465" y="572"/>
                </a:lnTo>
                <a:lnTo>
                  <a:pt x="1471" y="572"/>
                </a:lnTo>
                <a:lnTo>
                  <a:pt x="1477" y="572"/>
                </a:lnTo>
                <a:lnTo>
                  <a:pt x="1482" y="572"/>
                </a:lnTo>
                <a:lnTo>
                  <a:pt x="1487" y="572"/>
                </a:lnTo>
                <a:lnTo>
                  <a:pt x="1493" y="572"/>
                </a:lnTo>
                <a:lnTo>
                  <a:pt x="1499" y="572"/>
                </a:lnTo>
                <a:lnTo>
                  <a:pt x="1505" y="572"/>
                </a:lnTo>
                <a:lnTo>
                  <a:pt x="1510" y="572"/>
                </a:lnTo>
                <a:lnTo>
                  <a:pt x="1516" y="572"/>
                </a:lnTo>
                <a:lnTo>
                  <a:pt x="1522" y="572"/>
                </a:lnTo>
                <a:lnTo>
                  <a:pt x="1528" y="572"/>
                </a:lnTo>
                <a:lnTo>
                  <a:pt x="1533" y="572"/>
                </a:lnTo>
                <a:lnTo>
                  <a:pt x="1539" y="572"/>
                </a:lnTo>
                <a:lnTo>
                  <a:pt x="1545" y="572"/>
                </a:lnTo>
                <a:lnTo>
                  <a:pt x="1551" y="572"/>
                </a:lnTo>
                <a:lnTo>
                  <a:pt x="1557" y="572"/>
                </a:lnTo>
                <a:lnTo>
                  <a:pt x="1561" y="572"/>
                </a:lnTo>
                <a:lnTo>
                  <a:pt x="1567" y="572"/>
                </a:lnTo>
                <a:lnTo>
                  <a:pt x="1573" y="572"/>
                </a:lnTo>
                <a:lnTo>
                  <a:pt x="1579" y="572"/>
                </a:lnTo>
                <a:lnTo>
                  <a:pt x="1584" y="572"/>
                </a:lnTo>
                <a:lnTo>
                  <a:pt x="1590" y="570"/>
                </a:lnTo>
                <a:lnTo>
                  <a:pt x="1596" y="568"/>
                </a:lnTo>
                <a:lnTo>
                  <a:pt x="1602" y="566"/>
                </a:lnTo>
                <a:lnTo>
                  <a:pt x="1607" y="562"/>
                </a:lnTo>
                <a:lnTo>
                  <a:pt x="1613" y="560"/>
                </a:lnTo>
                <a:lnTo>
                  <a:pt x="1619" y="558"/>
                </a:lnTo>
                <a:lnTo>
                  <a:pt x="1625" y="558"/>
                </a:lnTo>
                <a:lnTo>
                  <a:pt x="1630" y="558"/>
                </a:lnTo>
                <a:lnTo>
                  <a:pt x="1635" y="560"/>
                </a:lnTo>
                <a:lnTo>
                  <a:pt x="1641" y="562"/>
                </a:lnTo>
                <a:lnTo>
                  <a:pt x="1647" y="564"/>
                </a:lnTo>
                <a:lnTo>
                  <a:pt x="1653" y="566"/>
                </a:lnTo>
                <a:lnTo>
                  <a:pt x="1658" y="566"/>
                </a:lnTo>
                <a:lnTo>
                  <a:pt x="1664" y="568"/>
                </a:lnTo>
                <a:lnTo>
                  <a:pt x="1670" y="568"/>
                </a:lnTo>
                <a:lnTo>
                  <a:pt x="1676" y="568"/>
                </a:lnTo>
                <a:lnTo>
                  <a:pt x="1681" y="570"/>
                </a:lnTo>
                <a:lnTo>
                  <a:pt x="1687" y="570"/>
                </a:lnTo>
                <a:lnTo>
                  <a:pt x="1693" y="570"/>
                </a:lnTo>
                <a:lnTo>
                  <a:pt x="1699" y="570"/>
                </a:lnTo>
                <a:lnTo>
                  <a:pt x="1704" y="572"/>
                </a:lnTo>
                <a:lnTo>
                  <a:pt x="1710" y="572"/>
                </a:lnTo>
                <a:lnTo>
                  <a:pt x="1716" y="572"/>
                </a:lnTo>
                <a:lnTo>
                  <a:pt x="1722" y="572"/>
                </a:lnTo>
                <a:lnTo>
                  <a:pt x="1726" y="572"/>
                </a:lnTo>
                <a:lnTo>
                  <a:pt x="1732" y="572"/>
                </a:lnTo>
                <a:lnTo>
                  <a:pt x="1738" y="572"/>
                </a:lnTo>
                <a:lnTo>
                  <a:pt x="1744" y="572"/>
                </a:lnTo>
                <a:lnTo>
                  <a:pt x="1750" y="572"/>
                </a:lnTo>
                <a:lnTo>
                  <a:pt x="1755" y="572"/>
                </a:lnTo>
                <a:lnTo>
                  <a:pt x="1761" y="572"/>
                </a:lnTo>
                <a:lnTo>
                  <a:pt x="1767" y="572"/>
                </a:lnTo>
                <a:lnTo>
                  <a:pt x="1773" y="570"/>
                </a:lnTo>
                <a:lnTo>
                  <a:pt x="1778" y="570"/>
                </a:lnTo>
                <a:lnTo>
                  <a:pt x="1784" y="570"/>
                </a:lnTo>
                <a:lnTo>
                  <a:pt x="1790" y="568"/>
                </a:lnTo>
                <a:lnTo>
                  <a:pt x="1796" y="568"/>
                </a:lnTo>
                <a:lnTo>
                  <a:pt x="1800" y="568"/>
                </a:lnTo>
                <a:lnTo>
                  <a:pt x="1806" y="568"/>
                </a:lnTo>
                <a:lnTo>
                  <a:pt x="1812" y="568"/>
                </a:lnTo>
                <a:lnTo>
                  <a:pt x="1818" y="570"/>
                </a:lnTo>
                <a:lnTo>
                  <a:pt x="1823" y="570"/>
                </a:lnTo>
                <a:lnTo>
                  <a:pt x="1829" y="570"/>
                </a:lnTo>
                <a:lnTo>
                  <a:pt x="1835" y="570"/>
                </a:lnTo>
                <a:lnTo>
                  <a:pt x="1841" y="570"/>
                </a:lnTo>
                <a:lnTo>
                  <a:pt x="1846" y="570"/>
                </a:lnTo>
                <a:lnTo>
                  <a:pt x="1852" y="570"/>
                </a:lnTo>
                <a:lnTo>
                  <a:pt x="1858" y="570"/>
                </a:lnTo>
                <a:lnTo>
                  <a:pt x="1864" y="570"/>
                </a:lnTo>
                <a:lnTo>
                  <a:pt x="1870" y="570"/>
                </a:lnTo>
                <a:lnTo>
                  <a:pt x="1875" y="572"/>
                </a:lnTo>
                <a:lnTo>
                  <a:pt x="1880" y="572"/>
                </a:lnTo>
                <a:lnTo>
                  <a:pt x="1886" y="572"/>
                </a:lnTo>
                <a:lnTo>
                  <a:pt x="1892" y="570"/>
                </a:lnTo>
                <a:lnTo>
                  <a:pt x="1897" y="570"/>
                </a:lnTo>
                <a:lnTo>
                  <a:pt x="1903" y="570"/>
                </a:lnTo>
                <a:lnTo>
                  <a:pt x="1909" y="570"/>
                </a:lnTo>
                <a:lnTo>
                  <a:pt x="1915" y="570"/>
                </a:lnTo>
                <a:lnTo>
                  <a:pt x="1920" y="570"/>
                </a:lnTo>
                <a:lnTo>
                  <a:pt x="1926" y="570"/>
                </a:lnTo>
                <a:lnTo>
                  <a:pt x="1932" y="570"/>
                </a:lnTo>
                <a:lnTo>
                  <a:pt x="1938" y="570"/>
                </a:lnTo>
                <a:lnTo>
                  <a:pt x="1943" y="570"/>
                </a:lnTo>
                <a:lnTo>
                  <a:pt x="1949" y="570"/>
                </a:lnTo>
                <a:lnTo>
                  <a:pt x="1955" y="570"/>
                </a:lnTo>
                <a:lnTo>
                  <a:pt x="1961" y="570"/>
                </a:lnTo>
                <a:lnTo>
                  <a:pt x="1967" y="570"/>
                </a:lnTo>
                <a:lnTo>
                  <a:pt x="1971" y="570"/>
                </a:lnTo>
                <a:lnTo>
                  <a:pt x="1977" y="570"/>
                </a:lnTo>
                <a:lnTo>
                  <a:pt x="1983" y="570"/>
                </a:lnTo>
                <a:lnTo>
                  <a:pt x="1989" y="570"/>
                </a:lnTo>
                <a:lnTo>
                  <a:pt x="1994" y="570"/>
                </a:lnTo>
                <a:lnTo>
                  <a:pt x="2000" y="570"/>
                </a:lnTo>
                <a:lnTo>
                  <a:pt x="2006" y="570"/>
                </a:lnTo>
                <a:lnTo>
                  <a:pt x="2012" y="568"/>
                </a:lnTo>
                <a:lnTo>
                  <a:pt x="2017" y="568"/>
                </a:lnTo>
                <a:lnTo>
                  <a:pt x="2023" y="568"/>
                </a:lnTo>
                <a:lnTo>
                  <a:pt x="2029" y="568"/>
                </a:lnTo>
                <a:lnTo>
                  <a:pt x="2035" y="568"/>
                </a:lnTo>
                <a:lnTo>
                  <a:pt x="2039" y="566"/>
                </a:lnTo>
                <a:lnTo>
                  <a:pt x="2045" y="566"/>
                </a:lnTo>
                <a:lnTo>
                  <a:pt x="2051" y="564"/>
                </a:lnTo>
                <a:lnTo>
                  <a:pt x="2057" y="562"/>
                </a:lnTo>
                <a:lnTo>
                  <a:pt x="2063" y="562"/>
                </a:lnTo>
                <a:lnTo>
                  <a:pt x="2068" y="560"/>
                </a:lnTo>
                <a:lnTo>
                  <a:pt x="2074" y="560"/>
                </a:lnTo>
                <a:lnTo>
                  <a:pt x="2080" y="558"/>
                </a:lnTo>
                <a:lnTo>
                  <a:pt x="2086" y="558"/>
                </a:lnTo>
                <a:lnTo>
                  <a:pt x="2091" y="558"/>
                </a:lnTo>
                <a:lnTo>
                  <a:pt x="2097" y="556"/>
                </a:lnTo>
                <a:lnTo>
                  <a:pt x="2103" y="556"/>
                </a:lnTo>
                <a:lnTo>
                  <a:pt x="2109" y="554"/>
                </a:lnTo>
                <a:lnTo>
                  <a:pt x="2114" y="554"/>
                </a:lnTo>
                <a:lnTo>
                  <a:pt x="2120" y="554"/>
                </a:lnTo>
                <a:lnTo>
                  <a:pt x="2126" y="556"/>
                </a:lnTo>
                <a:lnTo>
                  <a:pt x="2131" y="556"/>
                </a:lnTo>
                <a:lnTo>
                  <a:pt x="2136" y="558"/>
                </a:lnTo>
                <a:lnTo>
                  <a:pt x="2142" y="558"/>
                </a:lnTo>
                <a:lnTo>
                  <a:pt x="2148" y="560"/>
                </a:lnTo>
                <a:lnTo>
                  <a:pt x="2154" y="560"/>
                </a:lnTo>
                <a:lnTo>
                  <a:pt x="2160" y="562"/>
                </a:lnTo>
                <a:lnTo>
                  <a:pt x="2165" y="562"/>
                </a:lnTo>
                <a:lnTo>
                  <a:pt x="2171" y="562"/>
                </a:lnTo>
                <a:lnTo>
                  <a:pt x="2177" y="562"/>
                </a:lnTo>
                <a:lnTo>
                  <a:pt x="2183" y="564"/>
                </a:lnTo>
                <a:lnTo>
                  <a:pt x="2188" y="564"/>
                </a:lnTo>
                <a:lnTo>
                  <a:pt x="2194" y="564"/>
                </a:lnTo>
                <a:lnTo>
                  <a:pt x="2200" y="564"/>
                </a:lnTo>
                <a:lnTo>
                  <a:pt x="2206" y="564"/>
                </a:lnTo>
                <a:lnTo>
                  <a:pt x="2210" y="564"/>
                </a:lnTo>
                <a:lnTo>
                  <a:pt x="2216" y="564"/>
                </a:lnTo>
                <a:lnTo>
                  <a:pt x="2222" y="564"/>
                </a:lnTo>
                <a:lnTo>
                  <a:pt x="2228" y="564"/>
                </a:lnTo>
                <a:lnTo>
                  <a:pt x="2233" y="564"/>
                </a:lnTo>
                <a:lnTo>
                  <a:pt x="2239" y="564"/>
                </a:lnTo>
                <a:lnTo>
                  <a:pt x="2245" y="564"/>
                </a:lnTo>
                <a:lnTo>
                  <a:pt x="2251" y="564"/>
                </a:lnTo>
                <a:lnTo>
                  <a:pt x="2257" y="562"/>
                </a:lnTo>
                <a:lnTo>
                  <a:pt x="2262" y="562"/>
                </a:lnTo>
                <a:lnTo>
                  <a:pt x="2268" y="562"/>
                </a:lnTo>
                <a:lnTo>
                  <a:pt x="2274" y="560"/>
                </a:lnTo>
                <a:lnTo>
                  <a:pt x="2280" y="560"/>
                </a:lnTo>
                <a:lnTo>
                  <a:pt x="2284" y="560"/>
                </a:lnTo>
                <a:lnTo>
                  <a:pt x="2290" y="560"/>
                </a:lnTo>
                <a:lnTo>
                  <a:pt x="2296" y="560"/>
                </a:lnTo>
                <a:lnTo>
                  <a:pt x="2302" y="560"/>
                </a:lnTo>
                <a:lnTo>
                  <a:pt x="2307" y="560"/>
                </a:lnTo>
                <a:lnTo>
                  <a:pt x="2313" y="560"/>
                </a:lnTo>
                <a:lnTo>
                  <a:pt x="2319" y="560"/>
                </a:lnTo>
                <a:lnTo>
                  <a:pt x="2325" y="560"/>
                </a:lnTo>
                <a:lnTo>
                  <a:pt x="2330" y="558"/>
                </a:lnTo>
                <a:lnTo>
                  <a:pt x="2336" y="556"/>
                </a:lnTo>
                <a:lnTo>
                  <a:pt x="2342" y="554"/>
                </a:lnTo>
                <a:lnTo>
                  <a:pt x="2348" y="554"/>
                </a:lnTo>
                <a:lnTo>
                  <a:pt x="2354" y="554"/>
                </a:lnTo>
                <a:lnTo>
                  <a:pt x="2359" y="554"/>
                </a:lnTo>
                <a:lnTo>
                  <a:pt x="2365" y="554"/>
                </a:lnTo>
                <a:lnTo>
                  <a:pt x="2371" y="556"/>
                </a:lnTo>
                <a:lnTo>
                  <a:pt x="2377" y="556"/>
                </a:lnTo>
                <a:lnTo>
                  <a:pt x="2381" y="558"/>
                </a:lnTo>
                <a:lnTo>
                  <a:pt x="2387" y="558"/>
                </a:lnTo>
                <a:lnTo>
                  <a:pt x="2393" y="558"/>
                </a:lnTo>
                <a:lnTo>
                  <a:pt x="2399" y="558"/>
                </a:lnTo>
                <a:lnTo>
                  <a:pt x="2404" y="560"/>
                </a:lnTo>
                <a:lnTo>
                  <a:pt x="2410" y="560"/>
                </a:lnTo>
                <a:lnTo>
                  <a:pt x="2416" y="560"/>
                </a:lnTo>
                <a:lnTo>
                  <a:pt x="2422" y="560"/>
                </a:lnTo>
                <a:lnTo>
                  <a:pt x="2427" y="558"/>
                </a:lnTo>
                <a:lnTo>
                  <a:pt x="2433" y="558"/>
                </a:lnTo>
                <a:lnTo>
                  <a:pt x="2439" y="558"/>
                </a:lnTo>
                <a:lnTo>
                  <a:pt x="2445" y="556"/>
                </a:lnTo>
                <a:lnTo>
                  <a:pt x="2451" y="554"/>
                </a:lnTo>
                <a:lnTo>
                  <a:pt x="2455" y="552"/>
                </a:lnTo>
                <a:lnTo>
                  <a:pt x="2461" y="549"/>
                </a:lnTo>
                <a:lnTo>
                  <a:pt x="2467" y="543"/>
                </a:lnTo>
                <a:lnTo>
                  <a:pt x="2473" y="539"/>
                </a:lnTo>
                <a:lnTo>
                  <a:pt x="2478" y="535"/>
                </a:lnTo>
                <a:lnTo>
                  <a:pt x="2484" y="531"/>
                </a:lnTo>
                <a:lnTo>
                  <a:pt x="2490" y="529"/>
                </a:lnTo>
                <a:lnTo>
                  <a:pt x="2496" y="527"/>
                </a:lnTo>
                <a:lnTo>
                  <a:pt x="2501" y="525"/>
                </a:lnTo>
                <a:lnTo>
                  <a:pt x="2507" y="524"/>
                </a:lnTo>
                <a:lnTo>
                  <a:pt x="2513" y="524"/>
                </a:lnTo>
                <a:lnTo>
                  <a:pt x="2519" y="524"/>
                </a:lnTo>
                <a:lnTo>
                  <a:pt x="2524" y="524"/>
                </a:lnTo>
                <a:lnTo>
                  <a:pt x="2529" y="522"/>
                </a:lnTo>
                <a:lnTo>
                  <a:pt x="2535" y="516"/>
                </a:lnTo>
                <a:lnTo>
                  <a:pt x="2541" y="504"/>
                </a:lnTo>
                <a:lnTo>
                  <a:pt x="2547" y="481"/>
                </a:lnTo>
                <a:lnTo>
                  <a:pt x="2552" y="443"/>
                </a:lnTo>
                <a:lnTo>
                  <a:pt x="2558" y="382"/>
                </a:lnTo>
                <a:lnTo>
                  <a:pt x="2564" y="301"/>
                </a:lnTo>
                <a:lnTo>
                  <a:pt x="2570" y="215"/>
                </a:lnTo>
                <a:lnTo>
                  <a:pt x="2575" y="140"/>
                </a:lnTo>
                <a:lnTo>
                  <a:pt x="2581" y="96"/>
                </a:lnTo>
                <a:lnTo>
                  <a:pt x="2587" y="84"/>
                </a:lnTo>
                <a:lnTo>
                  <a:pt x="2593" y="105"/>
                </a:lnTo>
                <a:lnTo>
                  <a:pt x="2598" y="147"/>
                </a:lnTo>
                <a:lnTo>
                  <a:pt x="2604" y="199"/>
                </a:lnTo>
                <a:lnTo>
                  <a:pt x="2610" y="253"/>
                </a:lnTo>
                <a:lnTo>
                  <a:pt x="2616" y="301"/>
                </a:lnTo>
                <a:lnTo>
                  <a:pt x="2620" y="341"/>
                </a:lnTo>
                <a:lnTo>
                  <a:pt x="2626" y="376"/>
                </a:lnTo>
                <a:lnTo>
                  <a:pt x="2632" y="403"/>
                </a:lnTo>
                <a:lnTo>
                  <a:pt x="2638" y="428"/>
                </a:lnTo>
                <a:lnTo>
                  <a:pt x="2644" y="447"/>
                </a:lnTo>
                <a:lnTo>
                  <a:pt x="2649" y="462"/>
                </a:lnTo>
                <a:lnTo>
                  <a:pt x="2655" y="476"/>
                </a:lnTo>
                <a:lnTo>
                  <a:pt x="2661" y="485"/>
                </a:lnTo>
                <a:lnTo>
                  <a:pt x="2667" y="489"/>
                </a:lnTo>
                <a:lnTo>
                  <a:pt x="2672" y="491"/>
                </a:lnTo>
                <a:lnTo>
                  <a:pt x="2678" y="491"/>
                </a:lnTo>
                <a:lnTo>
                  <a:pt x="2684" y="489"/>
                </a:lnTo>
                <a:lnTo>
                  <a:pt x="2690" y="489"/>
                </a:lnTo>
                <a:lnTo>
                  <a:pt x="2694" y="491"/>
                </a:lnTo>
                <a:lnTo>
                  <a:pt x="2700" y="495"/>
                </a:lnTo>
                <a:lnTo>
                  <a:pt x="2706" y="499"/>
                </a:lnTo>
                <a:lnTo>
                  <a:pt x="2712" y="506"/>
                </a:lnTo>
                <a:lnTo>
                  <a:pt x="2717" y="512"/>
                </a:lnTo>
                <a:lnTo>
                  <a:pt x="2723" y="518"/>
                </a:lnTo>
                <a:lnTo>
                  <a:pt x="2729" y="522"/>
                </a:lnTo>
                <a:lnTo>
                  <a:pt x="2735" y="524"/>
                </a:lnTo>
                <a:lnTo>
                  <a:pt x="2741" y="525"/>
                </a:lnTo>
                <a:lnTo>
                  <a:pt x="2746" y="527"/>
                </a:lnTo>
                <a:lnTo>
                  <a:pt x="2752" y="527"/>
                </a:lnTo>
                <a:lnTo>
                  <a:pt x="2758" y="529"/>
                </a:lnTo>
                <a:lnTo>
                  <a:pt x="2764" y="531"/>
                </a:lnTo>
                <a:lnTo>
                  <a:pt x="2769" y="535"/>
                </a:lnTo>
                <a:lnTo>
                  <a:pt x="2775" y="537"/>
                </a:lnTo>
                <a:lnTo>
                  <a:pt x="2780" y="539"/>
                </a:lnTo>
                <a:lnTo>
                  <a:pt x="2786" y="541"/>
                </a:lnTo>
                <a:lnTo>
                  <a:pt x="2791" y="543"/>
                </a:lnTo>
                <a:lnTo>
                  <a:pt x="2797" y="545"/>
                </a:lnTo>
                <a:lnTo>
                  <a:pt x="2803" y="545"/>
                </a:lnTo>
                <a:lnTo>
                  <a:pt x="2809" y="547"/>
                </a:lnTo>
                <a:lnTo>
                  <a:pt x="2814" y="547"/>
                </a:lnTo>
                <a:lnTo>
                  <a:pt x="2820" y="547"/>
                </a:lnTo>
                <a:lnTo>
                  <a:pt x="2826" y="547"/>
                </a:lnTo>
                <a:lnTo>
                  <a:pt x="2832" y="547"/>
                </a:lnTo>
                <a:lnTo>
                  <a:pt x="2838" y="547"/>
                </a:lnTo>
                <a:lnTo>
                  <a:pt x="2843" y="545"/>
                </a:lnTo>
                <a:lnTo>
                  <a:pt x="2849" y="545"/>
                </a:lnTo>
                <a:lnTo>
                  <a:pt x="2855" y="545"/>
                </a:lnTo>
                <a:lnTo>
                  <a:pt x="2861" y="545"/>
                </a:lnTo>
                <a:lnTo>
                  <a:pt x="2865" y="547"/>
                </a:lnTo>
                <a:lnTo>
                  <a:pt x="2871" y="547"/>
                </a:lnTo>
                <a:lnTo>
                  <a:pt x="2877" y="547"/>
                </a:lnTo>
                <a:lnTo>
                  <a:pt x="2883" y="549"/>
                </a:lnTo>
                <a:lnTo>
                  <a:pt x="2888" y="549"/>
                </a:lnTo>
                <a:lnTo>
                  <a:pt x="2894" y="549"/>
                </a:lnTo>
                <a:lnTo>
                  <a:pt x="2900" y="550"/>
                </a:lnTo>
                <a:lnTo>
                  <a:pt x="2906" y="550"/>
                </a:lnTo>
                <a:lnTo>
                  <a:pt x="2911" y="550"/>
                </a:lnTo>
                <a:lnTo>
                  <a:pt x="2917" y="550"/>
                </a:lnTo>
                <a:lnTo>
                  <a:pt x="2923" y="550"/>
                </a:lnTo>
                <a:lnTo>
                  <a:pt x="2929" y="550"/>
                </a:lnTo>
                <a:lnTo>
                  <a:pt x="2935" y="550"/>
                </a:lnTo>
                <a:lnTo>
                  <a:pt x="2939" y="550"/>
                </a:lnTo>
                <a:lnTo>
                  <a:pt x="2945" y="550"/>
                </a:lnTo>
                <a:lnTo>
                  <a:pt x="2951" y="549"/>
                </a:lnTo>
                <a:lnTo>
                  <a:pt x="2957" y="545"/>
                </a:lnTo>
                <a:lnTo>
                  <a:pt x="2962" y="539"/>
                </a:lnTo>
                <a:lnTo>
                  <a:pt x="2968" y="533"/>
                </a:lnTo>
                <a:lnTo>
                  <a:pt x="2974" y="525"/>
                </a:lnTo>
                <a:lnTo>
                  <a:pt x="2980" y="518"/>
                </a:lnTo>
                <a:lnTo>
                  <a:pt x="2985" y="514"/>
                </a:lnTo>
                <a:lnTo>
                  <a:pt x="2991" y="512"/>
                </a:lnTo>
                <a:lnTo>
                  <a:pt x="2997" y="512"/>
                </a:lnTo>
                <a:lnTo>
                  <a:pt x="3003" y="516"/>
                </a:lnTo>
                <a:lnTo>
                  <a:pt x="3008" y="518"/>
                </a:lnTo>
                <a:lnTo>
                  <a:pt x="3014" y="522"/>
                </a:lnTo>
                <a:lnTo>
                  <a:pt x="3020" y="525"/>
                </a:lnTo>
                <a:lnTo>
                  <a:pt x="3026" y="527"/>
                </a:lnTo>
                <a:lnTo>
                  <a:pt x="3031" y="531"/>
                </a:lnTo>
                <a:lnTo>
                  <a:pt x="3036" y="533"/>
                </a:lnTo>
                <a:lnTo>
                  <a:pt x="3042" y="535"/>
                </a:lnTo>
                <a:lnTo>
                  <a:pt x="3048" y="537"/>
                </a:lnTo>
                <a:lnTo>
                  <a:pt x="3054" y="535"/>
                </a:lnTo>
                <a:lnTo>
                  <a:pt x="3059" y="535"/>
                </a:lnTo>
                <a:lnTo>
                  <a:pt x="3065" y="533"/>
                </a:lnTo>
                <a:lnTo>
                  <a:pt x="3071" y="531"/>
                </a:lnTo>
                <a:lnTo>
                  <a:pt x="3077" y="531"/>
                </a:lnTo>
                <a:lnTo>
                  <a:pt x="3082" y="531"/>
                </a:lnTo>
                <a:lnTo>
                  <a:pt x="3088" y="531"/>
                </a:lnTo>
                <a:lnTo>
                  <a:pt x="3094" y="533"/>
                </a:lnTo>
                <a:lnTo>
                  <a:pt x="3100" y="535"/>
                </a:lnTo>
                <a:lnTo>
                  <a:pt x="3104" y="535"/>
                </a:lnTo>
                <a:lnTo>
                  <a:pt x="3110" y="537"/>
                </a:lnTo>
                <a:lnTo>
                  <a:pt x="3116" y="537"/>
                </a:lnTo>
                <a:lnTo>
                  <a:pt x="3122" y="539"/>
                </a:lnTo>
                <a:lnTo>
                  <a:pt x="3127" y="539"/>
                </a:lnTo>
                <a:lnTo>
                  <a:pt x="3133" y="541"/>
                </a:lnTo>
                <a:lnTo>
                  <a:pt x="3139" y="543"/>
                </a:lnTo>
                <a:lnTo>
                  <a:pt x="3145" y="543"/>
                </a:lnTo>
                <a:lnTo>
                  <a:pt x="3151" y="545"/>
                </a:lnTo>
                <a:lnTo>
                  <a:pt x="3156" y="545"/>
                </a:lnTo>
                <a:lnTo>
                  <a:pt x="3162" y="547"/>
                </a:lnTo>
                <a:lnTo>
                  <a:pt x="3168" y="547"/>
                </a:lnTo>
                <a:lnTo>
                  <a:pt x="3174" y="547"/>
                </a:lnTo>
                <a:lnTo>
                  <a:pt x="3178" y="549"/>
                </a:lnTo>
                <a:lnTo>
                  <a:pt x="3184" y="549"/>
                </a:lnTo>
                <a:lnTo>
                  <a:pt x="3190" y="549"/>
                </a:lnTo>
                <a:lnTo>
                  <a:pt x="3196" y="549"/>
                </a:lnTo>
                <a:lnTo>
                  <a:pt x="3201" y="547"/>
                </a:lnTo>
                <a:lnTo>
                  <a:pt x="3207" y="547"/>
                </a:lnTo>
                <a:lnTo>
                  <a:pt x="3213" y="547"/>
                </a:lnTo>
                <a:lnTo>
                  <a:pt x="3219" y="547"/>
                </a:lnTo>
                <a:lnTo>
                  <a:pt x="3224" y="547"/>
                </a:lnTo>
                <a:lnTo>
                  <a:pt x="3230" y="547"/>
                </a:lnTo>
                <a:lnTo>
                  <a:pt x="3236" y="547"/>
                </a:lnTo>
                <a:lnTo>
                  <a:pt x="3242" y="545"/>
                </a:lnTo>
                <a:lnTo>
                  <a:pt x="3248" y="545"/>
                </a:lnTo>
                <a:lnTo>
                  <a:pt x="3253" y="545"/>
                </a:lnTo>
                <a:lnTo>
                  <a:pt x="3259" y="545"/>
                </a:lnTo>
                <a:lnTo>
                  <a:pt x="3265" y="545"/>
                </a:lnTo>
                <a:lnTo>
                  <a:pt x="3271" y="545"/>
                </a:lnTo>
                <a:lnTo>
                  <a:pt x="3275" y="545"/>
                </a:lnTo>
                <a:lnTo>
                  <a:pt x="3281" y="545"/>
                </a:lnTo>
                <a:lnTo>
                  <a:pt x="3287" y="545"/>
                </a:lnTo>
                <a:lnTo>
                  <a:pt x="3293" y="545"/>
                </a:lnTo>
                <a:lnTo>
                  <a:pt x="3298" y="545"/>
                </a:lnTo>
                <a:lnTo>
                  <a:pt x="3304" y="545"/>
                </a:lnTo>
                <a:lnTo>
                  <a:pt x="3310" y="545"/>
                </a:lnTo>
                <a:lnTo>
                  <a:pt x="3316" y="545"/>
                </a:lnTo>
                <a:lnTo>
                  <a:pt x="3321" y="545"/>
                </a:lnTo>
                <a:lnTo>
                  <a:pt x="3327" y="545"/>
                </a:lnTo>
                <a:lnTo>
                  <a:pt x="3333" y="545"/>
                </a:lnTo>
                <a:lnTo>
                  <a:pt x="3339" y="545"/>
                </a:lnTo>
                <a:lnTo>
                  <a:pt x="3345" y="543"/>
                </a:lnTo>
                <a:lnTo>
                  <a:pt x="3349" y="543"/>
                </a:lnTo>
                <a:lnTo>
                  <a:pt x="3355" y="543"/>
                </a:lnTo>
                <a:lnTo>
                  <a:pt x="3361" y="543"/>
                </a:lnTo>
                <a:lnTo>
                  <a:pt x="3367" y="543"/>
                </a:lnTo>
                <a:lnTo>
                  <a:pt x="3372" y="541"/>
                </a:lnTo>
                <a:lnTo>
                  <a:pt x="3378" y="541"/>
                </a:lnTo>
                <a:lnTo>
                  <a:pt x="3384" y="541"/>
                </a:lnTo>
                <a:lnTo>
                  <a:pt x="3390" y="541"/>
                </a:lnTo>
                <a:lnTo>
                  <a:pt x="3395" y="541"/>
                </a:lnTo>
                <a:lnTo>
                  <a:pt x="3401" y="541"/>
                </a:lnTo>
                <a:lnTo>
                  <a:pt x="3407" y="541"/>
                </a:lnTo>
                <a:lnTo>
                  <a:pt x="3413" y="539"/>
                </a:lnTo>
                <a:lnTo>
                  <a:pt x="3418" y="539"/>
                </a:lnTo>
                <a:lnTo>
                  <a:pt x="3424" y="539"/>
                </a:lnTo>
                <a:lnTo>
                  <a:pt x="3429" y="539"/>
                </a:lnTo>
                <a:lnTo>
                  <a:pt x="3435" y="539"/>
                </a:lnTo>
                <a:lnTo>
                  <a:pt x="3441" y="539"/>
                </a:lnTo>
                <a:lnTo>
                  <a:pt x="3446" y="539"/>
                </a:lnTo>
                <a:lnTo>
                  <a:pt x="3452" y="539"/>
                </a:lnTo>
                <a:lnTo>
                  <a:pt x="3458" y="539"/>
                </a:lnTo>
                <a:lnTo>
                  <a:pt x="3464" y="537"/>
                </a:lnTo>
                <a:lnTo>
                  <a:pt x="3469" y="537"/>
                </a:lnTo>
                <a:lnTo>
                  <a:pt x="3475" y="537"/>
                </a:lnTo>
                <a:lnTo>
                  <a:pt x="3481" y="537"/>
                </a:lnTo>
                <a:lnTo>
                  <a:pt x="3487" y="537"/>
                </a:lnTo>
                <a:lnTo>
                  <a:pt x="3492" y="535"/>
                </a:lnTo>
                <a:lnTo>
                  <a:pt x="3498" y="535"/>
                </a:lnTo>
                <a:lnTo>
                  <a:pt x="3504" y="535"/>
                </a:lnTo>
                <a:lnTo>
                  <a:pt x="3510" y="535"/>
                </a:lnTo>
                <a:lnTo>
                  <a:pt x="3514" y="533"/>
                </a:lnTo>
                <a:lnTo>
                  <a:pt x="3520" y="533"/>
                </a:lnTo>
                <a:lnTo>
                  <a:pt x="3526" y="533"/>
                </a:lnTo>
                <a:lnTo>
                  <a:pt x="3532" y="533"/>
                </a:lnTo>
                <a:lnTo>
                  <a:pt x="3538" y="533"/>
                </a:lnTo>
                <a:lnTo>
                  <a:pt x="3543" y="531"/>
                </a:lnTo>
                <a:lnTo>
                  <a:pt x="3549" y="531"/>
                </a:lnTo>
                <a:lnTo>
                  <a:pt x="3555" y="531"/>
                </a:lnTo>
                <a:lnTo>
                  <a:pt x="3561" y="531"/>
                </a:lnTo>
                <a:lnTo>
                  <a:pt x="3566" y="531"/>
                </a:lnTo>
                <a:lnTo>
                  <a:pt x="3572" y="531"/>
                </a:lnTo>
                <a:lnTo>
                  <a:pt x="3578" y="531"/>
                </a:lnTo>
                <a:lnTo>
                  <a:pt x="3584" y="531"/>
                </a:lnTo>
                <a:lnTo>
                  <a:pt x="3588" y="531"/>
                </a:lnTo>
                <a:lnTo>
                  <a:pt x="3594" y="531"/>
                </a:lnTo>
                <a:lnTo>
                  <a:pt x="3600" y="529"/>
                </a:lnTo>
                <a:lnTo>
                  <a:pt x="3606" y="529"/>
                </a:lnTo>
                <a:lnTo>
                  <a:pt x="3611" y="529"/>
                </a:lnTo>
                <a:lnTo>
                  <a:pt x="3617" y="529"/>
                </a:lnTo>
                <a:lnTo>
                  <a:pt x="3623" y="529"/>
                </a:lnTo>
                <a:lnTo>
                  <a:pt x="3629" y="529"/>
                </a:lnTo>
                <a:lnTo>
                  <a:pt x="3635" y="529"/>
                </a:lnTo>
                <a:lnTo>
                  <a:pt x="3640" y="529"/>
                </a:lnTo>
                <a:lnTo>
                  <a:pt x="3646" y="529"/>
                </a:lnTo>
                <a:lnTo>
                  <a:pt x="3652" y="529"/>
                </a:lnTo>
                <a:lnTo>
                  <a:pt x="3658" y="529"/>
                </a:lnTo>
                <a:lnTo>
                  <a:pt x="3663" y="529"/>
                </a:lnTo>
                <a:lnTo>
                  <a:pt x="3669" y="529"/>
                </a:lnTo>
                <a:lnTo>
                  <a:pt x="3675" y="527"/>
                </a:lnTo>
                <a:lnTo>
                  <a:pt x="3680" y="527"/>
                </a:lnTo>
                <a:lnTo>
                  <a:pt x="3685" y="527"/>
                </a:lnTo>
                <a:lnTo>
                  <a:pt x="3691" y="527"/>
                </a:lnTo>
                <a:lnTo>
                  <a:pt x="3697" y="527"/>
                </a:lnTo>
                <a:lnTo>
                  <a:pt x="3703" y="527"/>
                </a:lnTo>
                <a:lnTo>
                  <a:pt x="3708" y="527"/>
                </a:lnTo>
                <a:lnTo>
                  <a:pt x="3714" y="527"/>
                </a:lnTo>
                <a:lnTo>
                  <a:pt x="3720" y="525"/>
                </a:lnTo>
                <a:lnTo>
                  <a:pt x="3726" y="525"/>
                </a:lnTo>
                <a:lnTo>
                  <a:pt x="3732" y="525"/>
                </a:lnTo>
                <a:lnTo>
                  <a:pt x="3737" y="525"/>
                </a:lnTo>
                <a:lnTo>
                  <a:pt x="3743" y="525"/>
                </a:lnTo>
                <a:lnTo>
                  <a:pt x="3749" y="525"/>
                </a:lnTo>
                <a:lnTo>
                  <a:pt x="3755" y="525"/>
                </a:lnTo>
                <a:lnTo>
                  <a:pt x="3759" y="525"/>
                </a:lnTo>
                <a:lnTo>
                  <a:pt x="3765" y="524"/>
                </a:lnTo>
                <a:lnTo>
                  <a:pt x="3771" y="524"/>
                </a:lnTo>
                <a:lnTo>
                  <a:pt x="3777" y="524"/>
                </a:lnTo>
                <a:lnTo>
                  <a:pt x="3782" y="524"/>
                </a:lnTo>
                <a:lnTo>
                  <a:pt x="3788" y="524"/>
                </a:lnTo>
                <a:lnTo>
                  <a:pt x="3794" y="524"/>
                </a:lnTo>
                <a:lnTo>
                  <a:pt x="3800" y="524"/>
                </a:lnTo>
                <a:lnTo>
                  <a:pt x="3805" y="522"/>
                </a:lnTo>
                <a:lnTo>
                  <a:pt x="3811" y="522"/>
                </a:lnTo>
                <a:lnTo>
                  <a:pt x="3817" y="522"/>
                </a:lnTo>
                <a:lnTo>
                  <a:pt x="3823" y="522"/>
                </a:lnTo>
                <a:lnTo>
                  <a:pt x="3829" y="522"/>
                </a:lnTo>
                <a:lnTo>
                  <a:pt x="3833" y="520"/>
                </a:lnTo>
                <a:lnTo>
                  <a:pt x="3839" y="520"/>
                </a:lnTo>
                <a:lnTo>
                  <a:pt x="3845" y="520"/>
                </a:lnTo>
                <a:lnTo>
                  <a:pt x="3851" y="520"/>
                </a:lnTo>
                <a:lnTo>
                  <a:pt x="3856" y="520"/>
                </a:lnTo>
                <a:lnTo>
                  <a:pt x="3862" y="518"/>
                </a:lnTo>
                <a:lnTo>
                  <a:pt x="3868" y="518"/>
                </a:lnTo>
                <a:lnTo>
                  <a:pt x="3874" y="518"/>
                </a:lnTo>
                <a:lnTo>
                  <a:pt x="3879" y="518"/>
                </a:lnTo>
                <a:lnTo>
                  <a:pt x="3885" y="516"/>
                </a:lnTo>
                <a:lnTo>
                  <a:pt x="3891" y="516"/>
                </a:lnTo>
                <a:lnTo>
                  <a:pt x="3897" y="514"/>
                </a:lnTo>
                <a:lnTo>
                  <a:pt x="3902" y="512"/>
                </a:lnTo>
                <a:lnTo>
                  <a:pt x="3908" y="510"/>
                </a:lnTo>
                <a:lnTo>
                  <a:pt x="3914" y="508"/>
                </a:lnTo>
                <a:lnTo>
                  <a:pt x="3920" y="504"/>
                </a:lnTo>
                <a:lnTo>
                  <a:pt x="3925" y="501"/>
                </a:lnTo>
                <a:lnTo>
                  <a:pt x="3930" y="493"/>
                </a:lnTo>
                <a:lnTo>
                  <a:pt x="3936" y="479"/>
                </a:lnTo>
                <a:lnTo>
                  <a:pt x="3942" y="462"/>
                </a:lnTo>
                <a:lnTo>
                  <a:pt x="3948" y="437"/>
                </a:lnTo>
                <a:lnTo>
                  <a:pt x="3953" y="408"/>
                </a:lnTo>
                <a:lnTo>
                  <a:pt x="3959" y="376"/>
                </a:lnTo>
                <a:lnTo>
                  <a:pt x="3965" y="343"/>
                </a:lnTo>
                <a:lnTo>
                  <a:pt x="3971" y="309"/>
                </a:lnTo>
                <a:lnTo>
                  <a:pt x="3976" y="280"/>
                </a:lnTo>
                <a:lnTo>
                  <a:pt x="3982" y="255"/>
                </a:lnTo>
                <a:lnTo>
                  <a:pt x="3988" y="238"/>
                </a:lnTo>
                <a:lnTo>
                  <a:pt x="3994" y="226"/>
                </a:lnTo>
                <a:lnTo>
                  <a:pt x="3998" y="220"/>
                </a:lnTo>
                <a:lnTo>
                  <a:pt x="4004" y="220"/>
                </a:lnTo>
                <a:lnTo>
                  <a:pt x="4010" y="220"/>
                </a:lnTo>
                <a:lnTo>
                  <a:pt x="4016" y="222"/>
                </a:lnTo>
                <a:lnTo>
                  <a:pt x="4022" y="224"/>
                </a:lnTo>
                <a:lnTo>
                  <a:pt x="4027" y="224"/>
                </a:lnTo>
                <a:lnTo>
                  <a:pt x="4033" y="224"/>
                </a:lnTo>
                <a:lnTo>
                  <a:pt x="4039" y="228"/>
                </a:lnTo>
                <a:lnTo>
                  <a:pt x="4045" y="232"/>
                </a:lnTo>
                <a:lnTo>
                  <a:pt x="4050" y="239"/>
                </a:lnTo>
                <a:lnTo>
                  <a:pt x="4056" y="249"/>
                </a:lnTo>
                <a:lnTo>
                  <a:pt x="4062" y="259"/>
                </a:lnTo>
                <a:lnTo>
                  <a:pt x="4068" y="272"/>
                </a:lnTo>
                <a:lnTo>
                  <a:pt x="4073" y="286"/>
                </a:lnTo>
                <a:lnTo>
                  <a:pt x="4078" y="299"/>
                </a:lnTo>
                <a:lnTo>
                  <a:pt x="4084" y="311"/>
                </a:lnTo>
                <a:lnTo>
                  <a:pt x="4090" y="324"/>
                </a:lnTo>
                <a:lnTo>
                  <a:pt x="4095" y="335"/>
                </a:lnTo>
                <a:lnTo>
                  <a:pt x="4101" y="345"/>
                </a:lnTo>
                <a:lnTo>
                  <a:pt x="4107" y="355"/>
                </a:lnTo>
                <a:lnTo>
                  <a:pt x="4113" y="364"/>
                </a:lnTo>
                <a:lnTo>
                  <a:pt x="4119" y="374"/>
                </a:lnTo>
                <a:lnTo>
                  <a:pt x="4124" y="380"/>
                </a:lnTo>
                <a:lnTo>
                  <a:pt x="4130" y="387"/>
                </a:lnTo>
                <a:lnTo>
                  <a:pt x="4136" y="393"/>
                </a:lnTo>
                <a:lnTo>
                  <a:pt x="4142" y="399"/>
                </a:lnTo>
                <a:lnTo>
                  <a:pt x="4147" y="405"/>
                </a:lnTo>
                <a:lnTo>
                  <a:pt x="4153" y="408"/>
                </a:lnTo>
                <a:lnTo>
                  <a:pt x="4159" y="412"/>
                </a:lnTo>
                <a:lnTo>
                  <a:pt x="4165" y="416"/>
                </a:lnTo>
                <a:lnTo>
                  <a:pt x="4169" y="420"/>
                </a:lnTo>
                <a:lnTo>
                  <a:pt x="4175" y="422"/>
                </a:lnTo>
                <a:lnTo>
                  <a:pt x="4181" y="426"/>
                </a:lnTo>
                <a:lnTo>
                  <a:pt x="4187" y="428"/>
                </a:lnTo>
                <a:lnTo>
                  <a:pt x="4192" y="430"/>
                </a:lnTo>
                <a:lnTo>
                  <a:pt x="4198" y="431"/>
                </a:lnTo>
                <a:lnTo>
                  <a:pt x="4204" y="435"/>
                </a:lnTo>
                <a:lnTo>
                  <a:pt x="4210" y="435"/>
                </a:lnTo>
                <a:lnTo>
                  <a:pt x="4216" y="437"/>
                </a:lnTo>
                <a:lnTo>
                  <a:pt x="4221" y="439"/>
                </a:lnTo>
                <a:lnTo>
                  <a:pt x="4227" y="441"/>
                </a:lnTo>
                <a:lnTo>
                  <a:pt x="4233" y="443"/>
                </a:lnTo>
                <a:lnTo>
                  <a:pt x="4239" y="443"/>
                </a:lnTo>
                <a:lnTo>
                  <a:pt x="4243" y="445"/>
                </a:lnTo>
                <a:lnTo>
                  <a:pt x="4249" y="445"/>
                </a:lnTo>
                <a:lnTo>
                  <a:pt x="4255" y="447"/>
                </a:lnTo>
                <a:lnTo>
                  <a:pt x="4261" y="447"/>
                </a:lnTo>
                <a:lnTo>
                  <a:pt x="4265" y="449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D03EB46E-22D5-6933-AA9B-3E3E865AA0FE}"/>
              </a:ext>
            </a:extLst>
          </p:cNvPr>
          <p:cNvSpPr txBox="1"/>
          <p:nvPr/>
        </p:nvSpPr>
        <p:spPr>
          <a:xfrm>
            <a:off x="3261237" y="1513101"/>
            <a:ext cx="384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A4</a:t>
            </a:r>
            <a:endParaRPr kumimoji="1" lang="ja-JP" altLang="en-US" sz="1050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104CB4B-FB88-4A93-FE54-0635E8BD5966}"/>
              </a:ext>
            </a:extLst>
          </p:cNvPr>
          <p:cNvSpPr txBox="1"/>
          <p:nvPr/>
        </p:nvSpPr>
        <p:spPr>
          <a:xfrm>
            <a:off x="1256368" y="1072275"/>
            <a:ext cx="7507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GSGYR</a:t>
            </a:r>
            <a:endParaRPr kumimoji="1" lang="ja-JP" altLang="en-US" sz="1050" dirty="0"/>
          </a:p>
        </p:txBody>
      </p:sp>
      <p:sp>
        <p:nvSpPr>
          <p:cNvPr id="105" name="Text Box 5">
            <a:extLst>
              <a:ext uri="{FF2B5EF4-FFF2-40B4-BE49-F238E27FC236}">
                <a16:creationId xmlns:a16="http://schemas.microsoft.com/office/drawing/2014/main" id="{0CCC264D-2D8B-EC75-2F1D-5A8F5B2770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6582" y="1140403"/>
            <a:ext cx="697627" cy="253916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US" altLang="ja-JP" sz="1050" dirty="0">
                <a:latin typeface="Arial" charset="0"/>
                <a:ea typeface="ＭＳ Ｐゴシック" charset="-128"/>
              </a:rPr>
              <a:t>A</a:t>
            </a:r>
            <a:r>
              <a:rPr lang="el-GR" altLang="ja-JP" sz="1050" dirty="0">
                <a:latin typeface="Arial" charset="0"/>
                <a:ea typeface="ＭＳ Ｐゴシック" charset="-128"/>
              </a:rPr>
              <a:t>β</a:t>
            </a:r>
            <a:r>
              <a:rPr lang="en-US" altLang="ja-JP" sz="1050" dirty="0">
                <a:latin typeface="Arial" charset="0"/>
                <a:ea typeface="ＭＳ Ｐゴシック" charset="-128"/>
              </a:rPr>
              <a:t>11-29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C6F0D7E4-5540-5155-6663-9FCA5C035E5D}"/>
              </a:ext>
            </a:extLst>
          </p:cNvPr>
          <p:cNvSpPr txBox="1"/>
          <p:nvPr/>
        </p:nvSpPr>
        <p:spPr>
          <a:xfrm>
            <a:off x="434658" y="4376896"/>
            <a:ext cx="798576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Identification of cleavage sites of A</a:t>
            </a:r>
            <a:r>
              <a:rPr kumimoji="1" lang="el-GR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-29 by GSGYR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ach peak were corrected and applied MS analysis to determine the cleavage site. (b) Peaks R1 and A1-4 were identified as the fragment peptides of Aβ11-29 and GSGYR, respectively, by MS analysis on 5 days. </a:t>
            </a:r>
            <a:endParaRPr lang="ja-JP" altLang="en-US" sz="1200" dirty="0"/>
          </a:p>
        </p:txBody>
      </p:sp>
      <p:graphicFrame>
        <p:nvGraphicFramePr>
          <p:cNvPr id="112" name="表 111">
            <a:extLst>
              <a:ext uri="{FF2B5EF4-FFF2-40B4-BE49-F238E27FC236}">
                <a16:creationId xmlns:a16="http://schemas.microsoft.com/office/drawing/2014/main" id="{2EF00E7F-92CB-20B8-79F9-27B6D0F19E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9756265"/>
              </p:ext>
            </p:extLst>
          </p:nvPr>
        </p:nvGraphicFramePr>
        <p:xfrm>
          <a:off x="769030" y="2482423"/>
          <a:ext cx="4140200" cy="1452037"/>
        </p:xfrm>
        <a:graphic>
          <a:graphicData uri="http://schemas.openxmlformats.org/drawingml/2006/table">
            <a:tbl>
              <a:tblPr/>
              <a:tblGrid>
                <a:gridCol w="431469">
                  <a:extLst>
                    <a:ext uri="{9D8B030D-6E8A-4147-A177-3AD203B41FA5}">
                      <a16:colId xmlns:a16="http://schemas.microsoft.com/office/drawing/2014/main" val="1279659694"/>
                    </a:ext>
                  </a:extLst>
                </a:gridCol>
                <a:gridCol w="1497452">
                  <a:extLst>
                    <a:ext uri="{9D8B030D-6E8A-4147-A177-3AD203B41FA5}">
                      <a16:colId xmlns:a16="http://schemas.microsoft.com/office/drawing/2014/main" val="170111553"/>
                    </a:ext>
                  </a:extLst>
                </a:gridCol>
                <a:gridCol w="1040602">
                  <a:extLst>
                    <a:ext uri="{9D8B030D-6E8A-4147-A177-3AD203B41FA5}">
                      <a16:colId xmlns:a16="http://schemas.microsoft.com/office/drawing/2014/main" val="491872456"/>
                    </a:ext>
                  </a:extLst>
                </a:gridCol>
                <a:gridCol w="1170677">
                  <a:extLst>
                    <a:ext uri="{9D8B030D-6E8A-4147-A177-3AD203B41FA5}">
                      <a16:colId xmlns:a16="http://schemas.microsoft.com/office/drawing/2014/main" val="2825230292"/>
                    </a:ext>
                  </a:extLst>
                </a:gridCol>
              </a:tblGrid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ea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ragm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heoretical M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xperimental M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0051870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GY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1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81.39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826171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AEDVGSN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22.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22.48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089036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VHHQKL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88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88.55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257759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3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VGSN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5.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5.35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5728432"/>
                  </a:ext>
                </a:extLst>
              </a:tr>
              <a:tr h="2137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FFAEDVGSN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68.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268.79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5237723"/>
                  </a:ext>
                </a:extLst>
              </a:tr>
            </a:tbl>
          </a:graphicData>
        </a:graphic>
      </p:graphicFrame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D0731472-BD90-96C3-FB22-99675CFF5736}"/>
              </a:ext>
            </a:extLst>
          </p:cNvPr>
          <p:cNvSpPr txBox="1"/>
          <p:nvPr/>
        </p:nvSpPr>
        <p:spPr>
          <a:xfrm>
            <a:off x="360680" y="2195314"/>
            <a:ext cx="4800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cs typeface="Times New Roman" panose="02020603050405020304" pitchFamily="18" charset="0"/>
              </a:rPr>
              <a:t>(b)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182946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3DEF6CA3-F870-4E09-83D6-67AB1184F1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0159386"/>
              </p:ext>
            </p:extLst>
          </p:nvPr>
        </p:nvGraphicFramePr>
        <p:xfrm>
          <a:off x="1178808" y="1598891"/>
          <a:ext cx="6257496" cy="1935970"/>
        </p:xfrm>
        <a:graphic>
          <a:graphicData uri="http://schemas.openxmlformats.org/drawingml/2006/table">
            <a:tbl>
              <a:tblPr/>
              <a:tblGrid>
                <a:gridCol w="350267">
                  <a:extLst>
                    <a:ext uri="{9D8B030D-6E8A-4147-A177-3AD203B41FA5}">
                      <a16:colId xmlns:a16="http://schemas.microsoft.com/office/drawing/2014/main" val="3120454260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2484064236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2455349836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3805031314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4034366065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3660190332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4212480453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3494026228"/>
                    </a:ext>
                  </a:extLst>
                </a:gridCol>
                <a:gridCol w="643954">
                  <a:extLst>
                    <a:ext uri="{9D8B030D-6E8A-4147-A177-3AD203B41FA5}">
                      <a16:colId xmlns:a16="http://schemas.microsoft.com/office/drawing/2014/main" val="3764724134"/>
                    </a:ext>
                  </a:extLst>
                </a:gridCol>
                <a:gridCol w="755597">
                  <a:extLst>
                    <a:ext uri="{9D8B030D-6E8A-4147-A177-3AD203B41FA5}">
                      <a16:colId xmlns:a16="http://schemas.microsoft.com/office/drawing/2014/main" val="1025784914"/>
                    </a:ext>
                  </a:extLst>
                </a:gridCol>
              </a:tblGrid>
              <a:tr h="145389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GYR 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YGSG(Type-S) 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YGSG(Type-T) 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7668729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-C=O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-C=O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-C=O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-C=O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-C=O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-C=O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7936851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50.45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9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11.5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23.45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6334182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03.51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98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6.16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74.32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9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5125204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37.48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9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2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2.73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92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4.41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7427752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34.16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3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8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24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9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4.45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7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8694339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18.53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9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71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2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38.46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426121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74.36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1.44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41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15.88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6424610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34.58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24.43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17.14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7747966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23.97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9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22.97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04.32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25837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98.37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71.31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19.52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91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8453873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6.69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8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34.05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3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1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46.87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8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31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5852887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ve.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96.21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2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6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280.959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87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62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310.882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25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11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9951098"/>
                  </a:ext>
                </a:extLst>
              </a:tr>
              <a:tr h="13773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.E.M.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10.17372026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25254801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23129310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10.22784908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33706987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331673936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7.163554676</a:t>
                      </a:r>
                    </a:p>
                  </a:txBody>
                  <a:tcPr marL="7652" marR="7652" marT="765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322831845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effectLst/>
                          <a:latin typeface="Arial" panose="020B0604020202020204" pitchFamily="34" charset="0"/>
                        </a:rPr>
                        <a:t>0.244223054</a:t>
                      </a:r>
                    </a:p>
                  </a:txBody>
                  <a:tcPr marL="7652" marR="7652" marT="76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8311069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F1D47ED-0FF4-4BA6-9C4E-23FEF801DF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28219"/>
              </p:ext>
            </p:extLst>
          </p:nvPr>
        </p:nvGraphicFramePr>
        <p:xfrm>
          <a:off x="1178808" y="3840486"/>
          <a:ext cx="6210483" cy="1894309"/>
        </p:xfrm>
        <a:graphic>
          <a:graphicData uri="http://schemas.openxmlformats.org/drawingml/2006/table">
            <a:tbl>
              <a:tblPr/>
              <a:tblGrid>
                <a:gridCol w="349937">
                  <a:extLst>
                    <a:ext uri="{9D8B030D-6E8A-4147-A177-3AD203B41FA5}">
                      <a16:colId xmlns:a16="http://schemas.microsoft.com/office/drawing/2014/main" val="2781072550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2323218927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2714371600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3939975175"/>
                    </a:ext>
                  </a:extLst>
                </a:gridCol>
                <a:gridCol w="586474">
                  <a:extLst>
                    <a:ext uri="{9D8B030D-6E8A-4147-A177-3AD203B41FA5}">
                      <a16:colId xmlns:a16="http://schemas.microsoft.com/office/drawing/2014/main" val="85252014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2783646414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3504368464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1266871494"/>
                    </a:ext>
                  </a:extLst>
                </a:gridCol>
                <a:gridCol w="643624">
                  <a:extLst>
                    <a:ext uri="{9D8B030D-6E8A-4147-A177-3AD203B41FA5}">
                      <a16:colId xmlns:a16="http://schemas.microsoft.com/office/drawing/2014/main" val="3889580221"/>
                    </a:ext>
                  </a:extLst>
                </a:gridCol>
                <a:gridCol w="768704">
                  <a:extLst>
                    <a:ext uri="{9D8B030D-6E8A-4147-A177-3AD203B41FA5}">
                      <a16:colId xmlns:a16="http://schemas.microsoft.com/office/drawing/2014/main" val="976479658"/>
                    </a:ext>
                  </a:extLst>
                </a:gridCol>
              </a:tblGrid>
              <a:tr h="142260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GYR 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YGSG(Type-S) 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YGSG(Type-T) 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8525929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-C=O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-C=O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-C=O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-C=O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-C=O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-C=O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8431387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2.4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87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5.19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67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8.21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3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578616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79.96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3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33.1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6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0192261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1.59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0.16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8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7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70.94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674895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3.58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8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8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18.4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8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5.25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53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3486027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1.42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4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6.1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8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7.16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7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897642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74.32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36.85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3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5.74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2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5949331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1.79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7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8.65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7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1.32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252545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39.61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6.47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69.2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5946004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0.8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3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7.14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25.51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8315498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27.75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8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3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9.98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6.36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825551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ve.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3.322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8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4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49.204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49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4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555.569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91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5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5895529"/>
                  </a:ext>
                </a:extLst>
              </a:tr>
              <a:tr h="1347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.E.M.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4.880252821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263972726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40122425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4.63248469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288857924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16600873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4.037471845</a:t>
                      </a:r>
                    </a:p>
                  </a:txBody>
                  <a:tcPr marL="7487" marR="7487" marT="748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effectLst/>
                          <a:latin typeface="Arial" panose="020B0604020202020204" pitchFamily="34" charset="0"/>
                        </a:rPr>
                        <a:t>0.239037445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effectLst/>
                          <a:latin typeface="Arial" panose="020B0604020202020204" pitchFamily="34" charset="0"/>
                        </a:rPr>
                        <a:t>0.288481542</a:t>
                      </a:r>
                    </a:p>
                  </a:txBody>
                  <a:tcPr marL="7487" marR="7487" marT="74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9327930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1C292D9-D55E-A695-D34C-FFDB89FDD30F}"/>
              </a:ext>
            </a:extLst>
          </p:cNvPr>
          <p:cNvSpPr txBox="1"/>
          <p:nvPr/>
        </p:nvSpPr>
        <p:spPr>
          <a:xfrm>
            <a:off x="900113" y="840545"/>
            <a:ext cx="57534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Docking simulation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Docking to the carbonyl carbon of 17Leu, (b) docking to the carbonyl carbon of 22Glu.</a:t>
            </a:r>
            <a:endParaRPr kumimoji="1"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2">
            <a:extLst>
              <a:ext uri="{FF2B5EF4-FFF2-40B4-BE49-F238E27FC236}">
                <a16:creationId xmlns:a16="http://schemas.microsoft.com/office/drawing/2014/main" id="{6B4755D7-C380-C2BB-7572-3A70E102BB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2993" y="1305669"/>
            <a:ext cx="509980" cy="382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/>
              <a:t>(a)</a:t>
            </a:r>
            <a:endParaRPr lang="ja-JP" altLang="en-US" sz="1200" dirty="0"/>
          </a:p>
        </p:txBody>
      </p:sp>
      <p:sp>
        <p:nvSpPr>
          <p:cNvPr id="6" name="テキスト ボックス 2">
            <a:extLst>
              <a:ext uri="{FF2B5EF4-FFF2-40B4-BE49-F238E27FC236}">
                <a16:creationId xmlns:a16="http://schemas.microsoft.com/office/drawing/2014/main" id="{FB3B8A27-ECFC-422B-968B-F58EA5DEA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8832" y="3574547"/>
            <a:ext cx="509980" cy="382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/>
              <a:t>(b)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980579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C919618-51C2-45CD-9008-223912C92A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441" y="705976"/>
            <a:ext cx="2509907" cy="198658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1A092D1-9A36-4EAF-A3E3-064658A95C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4995" y="734997"/>
            <a:ext cx="2297642" cy="2024816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7401EE0-C710-409B-ADDE-8C5ACD1673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5823" y="784347"/>
            <a:ext cx="2490835" cy="1855565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1C32069-5126-4B8E-8823-065193F38903}"/>
              </a:ext>
            </a:extLst>
          </p:cNvPr>
          <p:cNvSpPr txBox="1"/>
          <p:nvPr/>
        </p:nvSpPr>
        <p:spPr>
          <a:xfrm>
            <a:off x="6502168" y="360276"/>
            <a:ext cx="1822496" cy="382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YGSG(Type-T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430D02E-1BFF-497B-89B8-3A854F7CE83D}"/>
              </a:ext>
            </a:extLst>
          </p:cNvPr>
          <p:cNvSpPr txBox="1"/>
          <p:nvPr/>
        </p:nvSpPr>
        <p:spPr>
          <a:xfrm>
            <a:off x="3484266" y="360276"/>
            <a:ext cx="1886543" cy="382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YGSG(Type-S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768DB88-AE5E-4F13-BFDF-1E55338D7046}"/>
              </a:ext>
            </a:extLst>
          </p:cNvPr>
          <p:cNvSpPr txBox="1"/>
          <p:nvPr/>
        </p:nvSpPr>
        <p:spPr>
          <a:xfrm>
            <a:off x="978979" y="360276"/>
            <a:ext cx="1063345" cy="382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SGY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AC450E3E-9787-4D6B-9EE0-4995F79041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306" y="3627834"/>
            <a:ext cx="2369070" cy="218898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5A5D785E-E614-4FAB-9BCA-CAAB71E6594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521" r="5737"/>
          <a:stretch/>
        </p:blipFill>
        <p:spPr>
          <a:xfrm rot="20572855">
            <a:off x="6410205" y="3571284"/>
            <a:ext cx="2432238" cy="2238134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8A810AC-2328-4144-B64E-5D8E75EDF8A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60897" y="3575985"/>
            <a:ext cx="2395461" cy="2307309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91D1730-FAAC-478D-8276-24DBA153BB45}"/>
              </a:ext>
            </a:extLst>
          </p:cNvPr>
          <p:cNvSpPr txBox="1"/>
          <p:nvPr/>
        </p:nvSpPr>
        <p:spPr>
          <a:xfrm>
            <a:off x="6234428" y="3490736"/>
            <a:ext cx="1822496" cy="382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YGSG(Type-T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E4D6F33-7D27-46AB-8D02-387A8D2DD828}"/>
              </a:ext>
            </a:extLst>
          </p:cNvPr>
          <p:cNvSpPr txBox="1"/>
          <p:nvPr/>
        </p:nvSpPr>
        <p:spPr>
          <a:xfrm>
            <a:off x="3359843" y="3481005"/>
            <a:ext cx="1886543" cy="382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YGSG(Type-S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DF6F85D-7A34-4D1E-A55A-F1A6152A07A5}"/>
              </a:ext>
            </a:extLst>
          </p:cNvPr>
          <p:cNvSpPr txBox="1"/>
          <p:nvPr/>
        </p:nvSpPr>
        <p:spPr>
          <a:xfrm>
            <a:off x="973886" y="3451825"/>
            <a:ext cx="1063345" cy="382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SGY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2">
            <a:extLst>
              <a:ext uri="{FF2B5EF4-FFF2-40B4-BE49-F238E27FC236}">
                <a16:creationId xmlns:a16="http://schemas.microsoft.com/office/drawing/2014/main" id="{658B5A23-FC91-4CB2-90DB-F4F692DA70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801" y="340469"/>
            <a:ext cx="509980" cy="382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/>
              <a:t>(a)</a:t>
            </a:r>
            <a:endParaRPr lang="ja-JP" altLang="en-US" sz="1200" dirty="0"/>
          </a:p>
        </p:txBody>
      </p:sp>
      <p:sp>
        <p:nvSpPr>
          <p:cNvPr id="19" name="テキスト ボックス 2">
            <a:extLst>
              <a:ext uri="{FF2B5EF4-FFF2-40B4-BE49-F238E27FC236}">
                <a16:creationId xmlns:a16="http://schemas.microsoft.com/office/drawing/2014/main" id="{43361A06-A746-4BDF-A361-C9D1F0F4D0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3462787"/>
            <a:ext cx="509980" cy="382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/>
              <a:t>(b)</a:t>
            </a:r>
            <a:endParaRPr lang="ja-JP" altLang="en-US" sz="1200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4152772-D785-1B9C-FD0A-3237E614B7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6543740"/>
              </p:ext>
            </p:extLst>
          </p:nvPr>
        </p:nvGraphicFramePr>
        <p:xfrm>
          <a:off x="6094273" y="2714891"/>
          <a:ext cx="2690311" cy="517407"/>
        </p:xfrm>
        <a:graphic>
          <a:graphicData uri="http://schemas.openxmlformats.org/drawingml/2006/table">
            <a:tbl>
              <a:tblPr/>
              <a:tblGrid>
                <a:gridCol w="1333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66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0204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istance from carbonyl carbon of 17Leu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(Å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256958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①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e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②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Ty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3.1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7.3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C2562DA8-C7E0-B969-8160-82CA1A10AAE9}"/>
              </a:ext>
            </a:extLst>
          </p:cNvPr>
          <p:cNvCxnSpPr/>
          <p:nvPr/>
        </p:nvCxnSpPr>
        <p:spPr>
          <a:xfrm>
            <a:off x="1257300" y="2049780"/>
            <a:ext cx="342900" cy="4114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102D8D62-9B24-0F71-BAD8-2816C3AF053D}"/>
              </a:ext>
            </a:extLst>
          </p:cNvPr>
          <p:cNvCxnSpPr>
            <a:cxnSpLocks/>
          </p:cNvCxnSpPr>
          <p:nvPr/>
        </p:nvCxnSpPr>
        <p:spPr>
          <a:xfrm flipH="1">
            <a:off x="1638300" y="1767840"/>
            <a:ext cx="342900" cy="7010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412B023-5DFE-36EA-726D-4B44ECB8670D}"/>
              </a:ext>
            </a:extLst>
          </p:cNvPr>
          <p:cNvSpPr txBox="1"/>
          <p:nvPr/>
        </p:nvSpPr>
        <p:spPr>
          <a:xfrm>
            <a:off x="1213485" y="2196584"/>
            <a:ext cx="31813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①</a:t>
            </a:r>
            <a:endParaRPr lang="ja-JP" altLang="en-US" sz="105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23121DE-0AA9-426F-1B6A-D1BB7EAB922E}"/>
              </a:ext>
            </a:extLst>
          </p:cNvPr>
          <p:cNvSpPr txBox="1"/>
          <p:nvPr/>
        </p:nvSpPr>
        <p:spPr>
          <a:xfrm>
            <a:off x="1708785" y="2067044"/>
            <a:ext cx="31813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②</a:t>
            </a:r>
            <a:endParaRPr lang="ja-JP" altLang="en-US" sz="1050" dirty="0"/>
          </a:p>
        </p:txBody>
      </p:sp>
      <p:graphicFrame>
        <p:nvGraphicFramePr>
          <p:cNvPr id="25" name="表 24">
            <a:extLst>
              <a:ext uri="{FF2B5EF4-FFF2-40B4-BE49-F238E27FC236}">
                <a16:creationId xmlns:a16="http://schemas.microsoft.com/office/drawing/2014/main" id="{A21A384F-3EFD-EC77-4C9A-8E3859A7F5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8505976"/>
              </p:ext>
            </p:extLst>
          </p:nvPr>
        </p:nvGraphicFramePr>
        <p:xfrm>
          <a:off x="3201712" y="2711648"/>
          <a:ext cx="2690311" cy="517407"/>
        </p:xfrm>
        <a:graphic>
          <a:graphicData uri="http://schemas.openxmlformats.org/drawingml/2006/table">
            <a:tbl>
              <a:tblPr/>
              <a:tblGrid>
                <a:gridCol w="1333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66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0204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istance from carbonyl carbon of 17Leu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(Å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256958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①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e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②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Ty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4.2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6.7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28" name="表 27">
            <a:extLst>
              <a:ext uri="{FF2B5EF4-FFF2-40B4-BE49-F238E27FC236}">
                <a16:creationId xmlns:a16="http://schemas.microsoft.com/office/drawing/2014/main" id="{B18AAAE4-C8F2-251E-A105-546E8BF39B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441211"/>
              </p:ext>
            </p:extLst>
          </p:nvPr>
        </p:nvGraphicFramePr>
        <p:xfrm>
          <a:off x="199753" y="2727861"/>
          <a:ext cx="2690311" cy="517407"/>
        </p:xfrm>
        <a:graphic>
          <a:graphicData uri="http://schemas.openxmlformats.org/drawingml/2006/table">
            <a:tbl>
              <a:tblPr/>
              <a:tblGrid>
                <a:gridCol w="1333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66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0204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istance from carbonyl carbon of 17Leu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(Å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256958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①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e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②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Ty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6.8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4.9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3D1F6A5D-C57A-121D-A74F-65A14687F1A5}"/>
              </a:ext>
            </a:extLst>
          </p:cNvPr>
          <p:cNvCxnSpPr>
            <a:cxnSpLocks/>
          </p:cNvCxnSpPr>
          <p:nvPr/>
        </p:nvCxnSpPr>
        <p:spPr>
          <a:xfrm flipH="1">
            <a:off x="4503420" y="1828800"/>
            <a:ext cx="807720" cy="5105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74627146-590C-98BD-A14D-02FA7C3BBE39}"/>
              </a:ext>
            </a:extLst>
          </p:cNvPr>
          <p:cNvCxnSpPr>
            <a:cxnSpLocks/>
          </p:cNvCxnSpPr>
          <p:nvPr/>
        </p:nvCxnSpPr>
        <p:spPr>
          <a:xfrm flipH="1">
            <a:off x="4493260" y="1935480"/>
            <a:ext cx="515620" cy="3987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7F1D0D8-4408-E905-B075-71207EDBC486}"/>
              </a:ext>
            </a:extLst>
          </p:cNvPr>
          <p:cNvSpPr txBox="1"/>
          <p:nvPr/>
        </p:nvSpPr>
        <p:spPr>
          <a:xfrm>
            <a:off x="4609465" y="1884164"/>
            <a:ext cx="31813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①</a:t>
            </a:r>
            <a:endParaRPr lang="ja-JP" altLang="en-US" sz="105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47A3354-0BBA-FA98-809A-1D7C6DF275AB}"/>
              </a:ext>
            </a:extLst>
          </p:cNvPr>
          <p:cNvSpPr txBox="1"/>
          <p:nvPr/>
        </p:nvSpPr>
        <p:spPr>
          <a:xfrm>
            <a:off x="4855845" y="2006084"/>
            <a:ext cx="31813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②</a:t>
            </a:r>
            <a:endParaRPr lang="ja-JP" altLang="en-US" sz="1050" dirty="0"/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72712D14-2236-5D13-D4D1-75F797FF4FAF}"/>
              </a:ext>
            </a:extLst>
          </p:cNvPr>
          <p:cNvCxnSpPr>
            <a:cxnSpLocks/>
          </p:cNvCxnSpPr>
          <p:nvPr/>
        </p:nvCxnSpPr>
        <p:spPr>
          <a:xfrm>
            <a:off x="7048500" y="1903476"/>
            <a:ext cx="608076" cy="40690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21016A79-CA9A-9DFF-9BDA-0B2CC903A192}"/>
              </a:ext>
            </a:extLst>
          </p:cNvPr>
          <p:cNvCxnSpPr>
            <a:cxnSpLocks/>
          </p:cNvCxnSpPr>
          <p:nvPr/>
        </p:nvCxnSpPr>
        <p:spPr>
          <a:xfrm>
            <a:off x="7504176" y="2164080"/>
            <a:ext cx="169164" cy="1645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D932BF2-8D89-BB69-49BB-1557F2843A01}"/>
              </a:ext>
            </a:extLst>
          </p:cNvPr>
          <p:cNvSpPr txBox="1"/>
          <p:nvPr/>
        </p:nvSpPr>
        <p:spPr>
          <a:xfrm>
            <a:off x="7175373" y="1849112"/>
            <a:ext cx="31813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①</a:t>
            </a:r>
            <a:endParaRPr lang="ja-JP" altLang="en-US" sz="105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017EDB5-52E0-E6BC-01D8-EC699E99354C}"/>
              </a:ext>
            </a:extLst>
          </p:cNvPr>
          <p:cNvSpPr txBox="1"/>
          <p:nvPr/>
        </p:nvSpPr>
        <p:spPr>
          <a:xfrm>
            <a:off x="7506081" y="2030468"/>
            <a:ext cx="31813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②</a:t>
            </a:r>
            <a:endParaRPr lang="ja-JP" altLang="en-US" sz="1050" dirty="0"/>
          </a:p>
        </p:txBody>
      </p:sp>
      <p:graphicFrame>
        <p:nvGraphicFramePr>
          <p:cNvPr id="44" name="表 43">
            <a:extLst>
              <a:ext uri="{FF2B5EF4-FFF2-40B4-BE49-F238E27FC236}">
                <a16:creationId xmlns:a16="http://schemas.microsoft.com/office/drawing/2014/main" id="{1A96AF83-B887-3098-DBE6-31CB9D4773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4884021"/>
              </p:ext>
            </p:extLst>
          </p:nvPr>
        </p:nvGraphicFramePr>
        <p:xfrm>
          <a:off x="6142501" y="5819510"/>
          <a:ext cx="2690311" cy="517407"/>
        </p:xfrm>
        <a:graphic>
          <a:graphicData uri="http://schemas.openxmlformats.org/drawingml/2006/table">
            <a:tbl>
              <a:tblPr/>
              <a:tblGrid>
                <a:gridCol w="1333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66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0204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istance from carbonyl carbon of 17Leu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(Å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256958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①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e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②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Ty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4.2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6.5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45" name="表 44">
            <a:extLst>
              <a:ext uri="{FF2B5EF4-FFF2-40B4-BE49-F238E27FC236}">
                <a16:creationId xmlns:a16="http://schemas.microsoft.com/office/drawing/2014/main" id="{7DBECC2F-FD0B-3553-5E2B-92A637CA26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4951731"/>
              </p:ext>
            </p:extLst>
          </p:nvPr>
        </p:nvGraphicFramePr>
        <p:xfrm>
          <a:off x="3249940" y="5816267"/>
          <a:ext cx="2690311" cy="517407"/>
        </p:xfrm>
        <a:graphic>
          <a:graphicData uri="http://schemas.openxmlformats.org/drawingml/2006/table">
            <a:tbl>
              <a:tblPr/>
              <a:tblGrid>
                <a:gridCol w="1333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66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0204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istance from carbonyl carbon of 17Leu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(Å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256958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①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e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②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Ty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5.1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6.9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46" name="表 45">
            <a:extLst>
              <a:ext uri="{FF2B5EF4-FFF2-40B4-BE49-F238E27FC236}">
                <a16:creationId xmlns:a16="http://schemas.microsoft.com/office/drawing/2014/main" id="{90EDF1D2-4E92-26F8-4E32-4E9B17808D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7244669"/>
              </p:ext>
            </p:extLst>
          </p:nvPr>
        </p:nvGraphicFramePr>
        <p:xfrm>
          <a:off x="247981" y="5832480"/>
          <a:ext cx="2690311" cy="517407"/>
        </p:xfrm>
        <a:graphic>
          <a:graphicData uri="http://schemas.openxmlformats.org/drawingml/2006/table">
            <a:tbl>
              <a:tblPr/>
              <a:tblGrid>
                <a:gridCol w="1333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66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0204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istance from carbonyl carbon of 17Leu</a:t>
                      </a:r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(Å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256958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①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e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②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Tyr-</a:t>
                      </a:r>
                      <a:r>
                        <a:rPr lang="en-US" sz="1050" b="0" i="0" u="sng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</a:t>
                      </a: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20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8.5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9.9</a:t>
                      </a:r>
                    </a:p>
                  </a:txBody>
                  <a:tcPr marL="12449" marR="12449" marT="1244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44AE77E-9637-BA63-C7AE-5357CD82878B}"/>
              </a:ext>
            </a:extLst>
          </p:cNvPr>
          <p:cNvSpPr txBox="1"/>
          <p:nvPr/>
        </p:nvSpPr>
        <p:spPr>
          <a:xfrm>
            <a:off x="243354" y="6396335"/>
            <a:ext cx="861870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Representative images of ten docking simulations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Docking to the carbonyl carbon of 17Leu, and (b) docking to the carbonyl carbon of 22Glu.</a:t>
            </a: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E843F0E8-99DF-DB29-7A92-DCEEB56EBD51}"/>
              </a:ext>
            </a:extLst>
          </p:cNvPr>
          <p:cNvCxnSpPr>
            <a:cxnSpLocks/>
          </p:cNvCxnSpPr>
          <p:nvPr/>
        </p:nvCxnSpPr>
        <p:spPr>
          <a:xfrm>
            <a:off x="942773" y="3976497"/>
            <a:ext cx="419099" cy="9456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84F6F402-28D9-4735-9667-CC42A7218517}"/>
              </a:ext>
            </a:extLst>
          </p:cNvPr>
          <p:cNvCxnSpPr>
            <a:cxnSpLocks/>
          </p:cNvCxnSpPr>
          <p:nvPr/>
        </p:nvCxnSpPr>
        <p:spPr>
          <a:xfrm flipH="1" flipV="1">
            <a:off x="1382138" y="4920891"/>
            <a:ext cx="573122" cy="6433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4A346C1-FBBA-6F0F-86DC-92EB6B3A81A9}"/>
              </a:ext>
            </a:extLst>
          </p:cNvPr>
          <p:cNvSpPr txBox="1"/>
          <p:nvPr/>
        </p:nvSpPr>
        <p:spPr>
          <a:xfrm>
            <a:off x="976779" y="4541591"/>
            <a:ext cx="31813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①</a:t>
            </a:r>
            <a:endParaRPr lang="ja-JP" altLang="en-US" sz="1050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9DE479E-7E3F-FFF5-A4DC-8F62179FDF29}"/>
              </a:ext>
            </a:extLst>
          </p:cNvPr>
          <p:cNvSpPr txBox="1"/>
          <p:nvPr/>
        </p:nvSpPr>
        <p:spPr>
          <a:xfrm>
            <a:off x="1433168" y="5210217"/>
            <a:ext cx="31813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②</a:t>
            </a:r>
            <a:endParaRPr lang="ja-JP" altLang="en-US" sz="1050" dirty="0"/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90747EC5-24B1-744E-A6EE-BBA3A40C211C}"/>
              </a:ext>
            </a:extLst>
          </p:cNvPr>
          <p:cNvCxnSpPr>
            <a:cxnSpLocks/>
          </p:cNvCxnSpPr>
          <p:nvPr/>
        </p:nvCxnSpPr>
        <p:spPr>
          <a:xfrm>
            <a:off x="3452508" y="4643823"/>
            <a:ext cx="331552" cy="5410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19020D3A-2344-85E0-0F9F-9849949939CC}"/>
              </a:ext>
            </a:extLst>
          </p:cNvPr>
          <p:cNvCxnSpPr>
            <a:cxnSpLocks/>
          </p:cNvCxnSpPr>
          <p:nvPr/>
        </p:nvCxnSpPr>
        <p:spPr>
          <a:xfrm flipH="1" flipV="1">
            <a:off x="3794598" y="5189383"/>
            <a:ext cx="971955" cy="30674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1269581-B3FA-A6BE-CC3D-02C561C59E38}"/>
              </a:ext>
            </a:extLst>
          </p:cNvPr>
          <p:cNvSpPr txBox="1"/>
          <p:nvPr/>
        </p:nvSpPr>
        <p:spPr>
          <a:xfrm>
            <a:off x="3340600" y="4819810"/>
            <a:ext cx="31813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①</a:t>
            </a:r>
            <a:endParaRPr lang="ja-JP" altLang="en-US" sz="105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EDF5BBC-4371-6363-CA86-042439B1DDDE}"/>
              </a:ext>
            </a:extLst>
          </p:cNvPr>
          <p:cNvSpPr txBox="1"/>
          <p:nvPr/>
        </p:nvSpPr>
        <p:spPr>
          <a:xfrm>
            <a:off x="4109403" y="5337175"/>
            <a:ext cx="31813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②</a:t>
            </a:r>
            <a:endParaRPr lang="ja-JP" altLang="en-US" sz="1050" dirty="0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56AB8DCE-AD1A-B0B5-BE03-E00E3056EF1D}"/>
              </a:ext>
            </a:extLst>
          </p:cNvPr>
          <p:cNvCxnSpPr/>
          <p:nvPr/>
        </p:nvCxnSpPr>
        <p:spPr>
          <a:xfrm>
            <a:off x="7042015" y="5059566"/>
            <a:ext cx="342900" cy="4114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DC2C9496-CAEF-2738-EA92-4D8EDCA045C6}"/>
              </a:ext>
            </a:extLst>
          </p:cNvPr>
          <p:cNvCxnSpPr>
            <a:cxnSpLocks/>
          </p:cNvCxnSpPr>
          <p:nvPr/>
        </p:nvCxnSpPr>
        <p:spPr>
          <a:xfrm flipH="1">
            <a:off x="7423015" y="5019472"/>
            <a:ext cx="534211" cy="4591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EDC775C8-025A-EFC0-7F1F-338AEC372A91}"/>
              </a:ext>
            </a:extLst>
          </p:cNvPr>
          <p:cNvSpPr txBox="1"/>
          <p:nvPr/>
        </p:nvSpPr>
        <p:spPr>
          <a:xfrm>
            <a:off x="6998200" y="5206370"/>
            <a:ext cx="31813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①</a:t>
            </a:r>
            <a:endParaRPr lang="ja-JP" altLang="en-US" sz="105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9F62091-7D9F-4697-E4D1-C6F22DA53F38}"/>
              </a:ext>
            </a:extLst>
          </p:cNvPr>
          <p:cNvSpPr txBox="1"/>
          <p:nvPr/>
        </p:nvSpPr>
        <p:spPr>
          <a:xfrm>
            <a:off x="7726964" y="5083259"/>
            <a:ext cx="31813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050" b="0" i="0" u="none" strike="noStrike" dirty="0">
                <a:solidFill>
                  <a:schemeClr val="tx1"/>
                </a:solidFill>
                <a:effectLst/>
                <a:latin typeface="+mn-lt"/>
                <a:ea typeface="ＭＳ Ｐゴシック" panose="020B0600070205080204" pitchFamily="50" charset="-128"/>
              </a:rPr>
              <a:t>②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4178852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00</TotalTime>
  <Words>821</Words>
  <Application>Microsoft Office PowerPoint</Application>
  <PresentationFormat>画面に合わせる (4:3)</PresentationFormat>
  <Paragraphs>436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7" baseType="lpstr"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里菜 中村</dc:creator>
  <cp:lastModifiedBy>中村 里菜</cp:lastModifiedBy>
  <cp:revision>78</cp:revision>
  <cp:lastPrinted>2022-11-08T09:36:55Z</cp:lastPrinted>
  <dcterms:created xsi:type="dcterms:W3CDTF">2020-07-28T04:31:21Z</dcterms:created>
  <dcterms:modified xsi:type="dcterms:W3CDTF">2022-11-26T21:33:52Z</dcterms:modified>
</cp:coreProperties>
</file>